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0" r:id="rId3"/>
    <p:sldId id="261" r:id="rId4"/>
    <p:sldId id="262" r:id="rId5"/>
  </p:sldIdLst>
  <p:sldSz cx="7556500" cy="10693400"/>
  <p:notesSz cx="6858000" cy="9144000"/>
  <p:custDataLst>
    <p:tags r:id="rId9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gs" Target="tags/tag1.xml"/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1.xml"/><Relationship Id="rId8" Type="http://schemas.openxmlformats.org/officeDocument/2006/relationships/image" Target="../media/image8.png"/><Relationship Id="rId7" Type="http://schemas.openxmlformats.org/officeDocument/2006/relationships/image" Target="../media/image7.png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1.xml"/><Relationship Id="rId8" Type="http://schemas.openxmlformats.org/officeDocument/2006/relationships/image" Target="../media/image8.png"/><Relationship Id="rId7" Type="http://schemas.openxmlformats.org/officeDocument/2006/relationships/image" Target="../media/image7.png"/><Relationship Id="rId6" Type="http://schemas.openxmlformats.org/officeDocument/2006/relationships/image" Target="../media/image6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1.xml"/><Relationship Id="rId8" Type="http://schemas.openxmlformats.org/officeDocument/2006/relationships/image" Target="../media/image7.png"/><Relationship Id="rId7" Type="http://schemas.openxmlformats.org/officeDocument/2006/relationships/image" Target="../media/image6.png"/><Relationship Id="rId6" Type="http://schemas.openxmlformats.org/officeDocument/2006/relationships/image" Target="../media/image18.png"/><Relationship Id="rId5" Type="http://schemas.openxmlformats.org/officeDocument/2006/relationships/image" Target="../media/image17.png"/><Relationship Id="rId4" Type="http://schemas.openxmlformats.org/officeDocument/2006/relationships/image" Target="../media/image16.png"/><Relationship Id="rId3" Type="http://schemas.openxmlformats.org/officeDocument/2006/relationships/image" Target="../media/image8.png"/><Relationship Id="rId2" Type="http://schemas.openxmlformats.org/officeDocument/2006/relationships/image" Target="../media/image15.png"/><Relationship Id="rId1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2"/>
          <p:cNvGrpSpPr/>
          <p:nvPr/>
        </p:nvGrpSpPr>
        <p:grpSpPr>
          <a:xfrm rot="21600000">
            <a:off x="851274" y="3790917"/>
            <a:ext cx="2827440" cy="85576"/>
            <a:chOff x="0" y="0"/>
            <a:chExt cx="2827440" cy="85576"/>
          </a:xfrm>
        </p:grpSpPr>
        <p:sp>
          <p:nvSpPr>
            <p:cNvPr id="3" name="path 2"/>
            <p:cNvSpPr/>
            <p:nvPr/>
          </p:nvSpPr>
          <p:spPr>
            <a:xfrm>
              <a:off x="1174863" y="0"/>
              <a:ext cx="1652576" cy="85576"/>
            </a:xfrm>
            <a:custGeom>
              <a:avLst/>
              <a:gdLst/>
              <a:ahLst/>
              <a:cxnLst/>
              <a:rect l="0" t="0" r="0" b="0"/>
              <a:pathLst>
                <a:path w="2602" h="134">
                  <a:moveTo>
                    <a:pt x="7" y="127"/>
                  </a:moveTo>
                  <a:lnTo>
                    <a:pt x="35" y="92"/>
                  </a:lnTo>
                  <a:lnTo>
                    <a:pt x="64" y="12"/>
                  </a:lnTo>
                  <a:moveTo>
                    <a:pt x="632" y="7"/>
                  </a:moveTo>
                  <a:lnTo>
                    <a:pt x="661" y="35"/>
                  </a:lnTo>
                  <a:lnTo>
                    <a:pt x="689" y="77"/>
                  </a:lnTo>
                  <a:lnTo>
                    <a:pt x="718" y="109"/>
                  </a:lnTo>
                  <a:moveTo>
                    <a:pt x="2083" y="123"/>
                  </a:moveTo>
                  <a:lnTo>
                    <a:pt x="2111" y="105"/>
                  </a:lnTo>
                  <a:lnTo>
                    <a:pt x="2140" y="98"/>
                  </a:lnTo>
                  <a:lnTo>
                    <a:pt x="2168" y="102"/>
                  </a:lnTo>
                  <a:lnTo>
                    <a:pt x="2197" y="91"/>
                  </a:lnTo>
                  <a:lnTo>
                    <a:pt x="2225" y="100"/>
                  </a:lnTo>
                  <a:lnTo>
                    <a:pt x="2253" y="85"/>
                  </a:lnTo>
                  <a:lnTo>
                    <a:pt x="2282" y="77"/>
                  </a:lnTo>
                  <a:lnTo>
                    <a:pt x="2310" y="71"/>
                  </a:lnTo>
                  <a:lnTo>
                    <a:pt x="2339" y="61"/>
                  </a:lnTo>
                  <a:lnTo>
                    <a:pt x="2367" y="25"/>
                  </a:lnTo>
                  <a:lnTo>
                    <a:pt x="2396" y="12"/>
                  </a:lnTo>
                  <a:lnTo>
                    <a:pt x="2424" y="8"/>
                  </a:lnTo>
                  <a:lnTo>
                    <a:pt x="2452" y="22"/>
                  </a:lnTo>
                  <a:lnTo>
                    <a:pt x="2481" y="53"/>
                  </a:lnTo>
                  <a:lnTo>
                    <a:pt x="2509" y="43"/>
                  </a:lnTo>
                  <a:lnTo>
                    <a:pt x="2538" y="70"/>
                  </a:lnTo>
                  <a:lnTo>
                    <a:pt x="2566" y="85"/>
                  </a:lnTo>
                  <a:lnTo>
                    <a:pt x="2595" y="109"/>
                  </a:lnTo>
                </a:path>
              </a:pathLst>
            </a:custGeom>
            <a:noFill/>
            <a:ln w="9260" cap="rnd">
              <a:solidFill>
                <a:srgbClr val="000000"/>
              </a:solidFill>
              <a:prstDash val="solid"/>
              <a:round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  <p:sp>
          <p:nvSpPr>
            <p:cNvPr id="4" name="path 4"/>
            <p:cNvSpPr/>
            <p:nvPr/>
          </p:nvSpPr>
          <p:spPr>
            <a:xfrm>
              <a:off x="0" y="23790"/>
              <a:ext cx="71236" cy="7123"/>
            </a:xfrm>
            <a:custGeom>
              <a:avLst/>
              <a:gdLst/>
              <a:ahLst/>
              <a:cxnLst/>
              <a:rect l="0" t="0" r="0" b="0"/>
              <a:pathLst>
                <a:path w="112" h="11">
                  <a:moveTo>
                    <a:pt x="106" y="5"/>
                  </a:moveTo>
                  <a:lnTo>
                    <a:pt x="5" y="5"/>
                  </a:lnTo>
                </a:path>
              </a:pathLst>
            </a:custGeom>
            <a:noFill/>
            <a:ln w="7123" cap="sq">
              <a:solidFill>
                <a:srgbClr val="000000"/>
              </a:solidFill>
              <a:prstDash val="solid"/>
              <a:bevel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</p:grpSp>
      <p:pic>
        <p:nvPicPr>
          <p:cNvPr id="6" name="picture 6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 rot="21600000">
            <a:off x="915387" y="3899554"/>
            <a:ext cx="3625931" cy="135985"/>
          </a:xfrm>
          <a:prstGeom prst="rect">
            <a:avLst/>
          </a:prstGeom>
        </p:spPr>
      </p:pic>
      <p:grpSp>
        <p:nvGrpSpPr>
          <p:cNvPr id="5" name="group 4"/>
          <p:cNvGrpSpPr/>
          <p:nvPr/>
        </p:nvGrpSpPr>
        <p:grpSpPr>
          <a:xfrm rot="21600000">
            <a:off x="787161" y="3855697"/>
            <a:ext cx="3758357" cy="51617"/>
            <a:chOff x="0" y="0"/>
            <a:chExt cx="3758357" cy="51617"/>
          </a:xfrm>
        </p:grpSpPr>
        <p:sp>
          <p:nvSpPr>
            <p:cNvPr id="8" name="path 8"/>
            <p:cNvSpPr/>
            <p:nvPr/>
          </p:nvSpPr>
          <p:spPr>
            <a:xfrm>
              <a:off x="137412" y="0"/>
              <a:ext cx="3620944" cy="50081"/>
            </a:xfrm>
            <a:custGeom>
              <a:avLst/>
              <a:gdLst/>
              <a:ahLst/>
              <a:cxnLst/>
              <a:rect l="0" t="0" r="0" b="0"/>
              <a:pathLst>
                <a:path w="5702" h="78">
                  <a:moveTo>
                    <a:pt x="7" y="71"/>
                  </a:moveTo>
                  <a:lnTo>
                    <a:pt x="35" y="71"/>
                  </a:lnTo>
                  <a:lnTo>
                    <a:pt x="64" y="71"/>
                  </a:lnTo>
                  <a:lnTo>
                    <a:pt x="92" y="71"/>
                  </a:lnTo>
                  <a:lnTo>
                    <a:pt x="121" y="71"/>
                  </a:lnTo>
                  <a:lnTo>
                    <a:pt x="149" y="71"/>
                  </a:lnTo>
                  <a:lnTo>
                    <a:pt x="177" y="71"/>
                  </a:lnTo>
                  <a:lnTo>
                    <a:pt x="206" y="71"/>
                  </a:lnTo>
                  <a:lnTo>
                    <a:pt x="234" y="71"/>
                  </a:lnTo>
                  <a:lnTo>
                    <a:pt x="263" y="71"/>
                  </a:lnTo>
                  <a:lnTo>
                    <a:pt x="291" y="71"/>
                  </a:lnTo>
                  <a:lnTo>
                    <a:pt x="320" y="71"/>
                  </a:lnTo>
                  <a:lnTo>
                    <a:pt x="348" y="71"/>
                  </a:lnTo>
                  <a:lnTo>
                    <a:pt x="376" y="71"/>
                  </a:lnTo>
                  <a:lnTo>
                    <a:pt x="405" y="71"/>
                  </a:lnTo>
                  <a:lnTo>
                    <a:pt x="433" y="71"/>
                  </a:lnTo>
                  <a:lnTo>
                    <a:pt x="462" y="71"/>
                  </a:lnTo>
                  <a:lnTo>
                    <a:pt x="490" y="71"/>
                  </a:lnTo>
                  <a:lnTo>
                    <a:pt x="519" y="71"/>
                  </a:lnTo>
                  <a:lnTo>
                    <a:pt x="547" y="71"/>
                  </a:lnTo>
                  <a:lnTo>
                    <a:pt x="576" y="71"/>
                  </a:lnTo>
                  <a:lnTo>
                    <a:pt x="604" y="71"/>
                  </a:lnTo>
                  <a:lnTo>
                    <a:pt x="632" y="71"/>
                  </a:lnTo>
                  <a:lnTo>
                    <a:pt x="661" y="71"/>
                  </a:lnTo>
                  <a:lnTo>
                    <a:pt x="689" y="71"/>
                  </a:lnTo>
                  <a:lnTo>
                    <a:pt x="718" y="71"/>
                  </a:lnTo>
                  <a:lnTo>
                    <a:pt x="746" y="71"/>
                  </a:lnTo>
                  <a:lnTo>
                    <a:pt x="775" y="71"/>
                  </a:lnTo>
                  <a:lnTo>
                    <a:pt x="803" y="71"/>
                  </a:lnTo>
                  <a:lnTo>
                    <a:pt x="832" y="71"/>
                  </a:lnTo>
                  <a:lnTo>
                    <a:pt x="860" y="71"/>
                  </a:lnTo>
                  <a:lnTo>
                    <a:pt x="888" y="71"/>
                  </a:lnTo>
                  <a:lnTo>
                    <a:pt x="917" y="71"/>
                  </a:lnTo>
                  <a:lnTo>
                    <a:pt x="945" y="71"/>
                  </a:lnTo>
                  <a:lnTo>
                    <a:pt x="974" y="71"/>
                  </a:lnTo>
                  <a:lnTo>
                    <a:pt x="1002" y="71"/>
                  </a:lnTo>
                  <a:lnTo>
                    <a:pt x="1031" y="71"/>
                  </a:lnTo>
                  <a:lnTo>
                    <a:pt x="1059" y="71"/>
                  </a:lnTo>
                  <a:lnTo>
                    <a:pt x="1087" y="71"/>
                  </a:lnTo>
                  <a:lnTo>
                    <a:pt x="1116" y="71"/>
                  </a:lnTo>
                  <a:lnTo>
                    <a:pt x="1144" y="71"/>
                  </a:lnTo>
                  <a:lnTo>
                    <a:pt x="1173" y="71"/>
                  </a:lnTo>
                  <a:lnTo>
                    <a:pt x="1201" y="71"/>
                  </a:lnTo>
                  <a:lnTo>
                    <a:pt x="1230" y="71"/>
                  </a:lnTo>
                  <a:lnTo>
                    <a:pt x="1258" y="71"/>
                  </a:lnTo>
                  <a:lnTo>
                    <a:pt x="1287" y="71"/>
                  </a:lnTo>
                  <a:lnTo>
                    <a:pt x="1315" y="71"/>
                  </a:lnTo>
                  <a:lnTo>
                    <a:pt x="1343" y="71"/>
                  </a:lnTo>
                  <a:lnTo>
                    <a:pt x="1372" y="67"/>
                  </a:lnTo>
                  <a:lnTo>
                    <a:pt x="1400" y="70"/>
                  </a:lnTo>
                  <a:lnTo>
                    <a:pt x="1429" y="61"/>
                  </a:lnTo>
                  <a:lnTo>
                    <a:pt x="1457" y="60"/>
                  </a:lnTo>
                  <a:lnTo>
                    <a:pt x="1486" y="63"/>
                  </a:lnTo>
                  <a:lnTo>
                    <a:pt x="1514" y="53"/>
                  </a:lnTo>
                  <a:lnTo>
                    <a:pt x="1542" y="54"/>
                  </a:lnTo>
                  <a:lnTo>
                    <a:pt x="1571" y="63"/>
                  </a:lnTo>
                  <a:lnTo>
                    <a:pt x="1599" y="58"/>
                  </a:lnTo>
                  <a:lnTo>
                    <a:pt x="1628" y="47"/>
                  </a:lnTo>
                  <a:lnTo>
                    <a:pt x="1656" y="56"/>
                  </a:lnTo>
                  <a:lnTo>
                    <a:pt x="1685" y="52"/>
                  </a:lnTo>
                  <a:lnTo>
                    <a:pt x="1713" y="54"/>
                  </a:lnTo>
                  <a:lnTo>
                    <a:pt x="1742" y="25"/>
                  </a:lnTo>
                  <a:moveTo>
                    <a:pt x="2452" y="7"/>
                  </a:moveTo>
                  <a:lnTo>
                    <a:pt x="2481" y="28"/>
                  </a:lnTo>
                  <a:lnTo>
                    <a:pt x="2509" y="19"/>
                  </a:lnTo>
                  <a:lnTo>
                    <a:pt x="2538" y="47"/>
                  </a:lnTo>
                  <a:lnTo>
                    <a:pt x="2566" y="40"/>
                  </a:lnTo>
                  <a:lnTo>
                    <a:pt x="2595" y="43"/>
                  </a:lnTo>
                  <a:lnTo>
                    <a:pt x="2623" y="40"/>
                  </a:lnTo>
                  <a:lnTo>
                    <a:pt x="2652" y="40"/>
                  </a:lnTo>
                  <a:lnTo>
                    <a:pt x="2680" y="47"/>
                  </a:lnTo>
                  <a:lnTo>
                    <a:pt x="2708" y="40"/>
                  </a:lnTo>
                  <a:lnTo>
                    <a:pt x="2737" y="45"/>
                  </a:lnTo>
                  <a:lnTo>
                    <a:pt x="2765" y="46"/>
                  </a:lnTo>
                  <a:lnTo>
                    <a:pt x="2794" y="40"/>
                  </a:lnTo>
                  <a:lnTo>
                    <a:pt x="2822" y="35"/>
                  </a:lnTo>
                  <a:lnTo>
                    <a:pt x="2851" y="40"/>
                  </a:lnTo>
                  <a:lnTo>
                    <a:pt x="2879" y="47"/>
                  </a:lnTo>
                  <a:lnTo>
                    <a:pt x="2908" y="50"/>
                  </a:lnTo>
                  <a:lnTo>
                    <a:pt x="2936" y="56"/>
                  </a:lnTo>
                  <a:lnTo>
                    <a:pt x="2964" y="47"/>
                  </a:lnTo>
                  <a:lnTo>
                    <a:pt x="2993" y="45"/>
                  </a:lnTo>
                  <a:lnTo>
                    <a:pt x="3021" y="53"/>
                  </a:lnTo>
                  <a:lnTo>
                    <a:pt x="3050" y="63"/>
                  </a:lnTo>
                  <a:lnTo>
                    <a:pt x="3078" y="47"/>
                  </a:lnTo>
                  <a:lnTo>
                    <a:pt x="3107" y="54"/>
                  </a:lnTo>
                  <a:lnTo>
                    <a:pt x="3135" y="52"/>
                  </a:lnTo>
                  <a:lnTo>
                    <a:pt x="3163" y="53"/>
                  </a:lnTo>
                  <a:lnTo>
                    <a:pt x="3192" y="57"/>
                  </a:lnTo>
                  <a:lnTo>
                    <a:pt x="3220" y="54"/>
                  </a:lnTo>
                  <a:lnTo>
                    <a:pt x="3249" y="43"/>
                  </a:lnTo>
                  <a:lnTo>
                    <a:pt x="3277" y="52"/>
                  </a:lnTo>
                  <a:lnTo>
                    <a:pt x="3306" y="53"/>
                  </a:lnTo>
                  <a:lnTo>
                    <a:pt x="3334" y="50"/>
                  </a:lnTo>
                  <a:lnTo>
                    <a:pt x="3363" y="47"/>
                  </a:lnTo>
                  <a:lnTo>
                    <a:pt x="3391" y="47"/>
                  </a:lnTo>
                  <a:lnTo>
                    <a:pt x="3419" y="56"/>
                  </a:lnTo>
                  <a:lnTo>
                    <a:pt x="3448" y="50"/>
                  </a:lnTo>
                  <a:lnTo>
                    <a:pt x="3476" y="42"/>
                  </a:lnTo>
                  <a:lnTo>
                    <a:pt x="3505" y="46"/>
                  </a:lnTo>
                  <a:lnTo>
                    <a:pt x="3533" y="49"/>
                  </a:lnTo>
                  <a:lnTo>
                    <a:pt x="3562" y="50"/>
                  </a:lnTo>
                  <a:lnTo>
                    <a:pt x="3590" y="43"/>
                  </a:lnTo>
                  <a:lnTo>
                    <a:pt x="3618" y="35"/>
                  </a:lnTo>
                  <a:lnTo>
                    <a:pt x="3647" y="24"/>
                  </a:lnTo>
                  <a:lnTo>
                    <a:pt x="3675" y="31"/>
                  </a:lnTo>
                  <a:lnTo>
                    <a:pt x="3704" y="33"/>
                  </a:lnTo>
                  <a:lnTo>
                    <a:pt x="3732" y="26"/>
                  </a:lnTo>
                  <a:lnTo>
                    <a:pt x="3761" y="35"/>
                  </a:lnTo>
                  <a:lnTo>
                    <a:pt x="3789" y="11"/>
                  </a:lnTo>
                  <a:lnTo>
                    <a:pt x="3818" y="21"/>
                  </a:lnTo>
                  <a:moveTo>
                    <a:pt x="4329" y="7"/>
                  </a:moveTo>
                  <a:lnTo>
                    <a:pt x="4358" y="18"/>
                  </a:lnTo>
                  <a:lnTo>
                    <a:pt x="4386" y="43"/>
                  </a:lnTo>
                  <a:lnTo>
                    <a:pt x="4415" y="47"/>
                  </a:lnTo>
                  <a:lnTo>
                    <a:pt x="4443" y="58"/>
                  </a:lnTo>
                  <a:lnTo>
                    <a:pt x="4472" y="61"/>
                  </a:lnTo>
                  <a:lnTo>
                    <a:pt x="4500" y="57"/>
                  </a:lnTo>
                  <a:lnTo>
                    <a:pt x="4529" y="65"/>
                  </a:lnTo>
                  <a:lnTo>
                    <a:pt x="4557" y="68"/>
                  </a:lnTo>
                  <a:lnTo>
                    <a:pt x="4585" y="68"/>
                  </a:lnTo>
                  <a:lnTo>
                    <a:pt x="4614" y="68"/>
                  </a:lnTo>
                  <a:lnTo>
                    <a:pt x="4642" y="71"/>
                  </a:lnTo>
                  <a:lnTo>
                    <a:pt x="4671" y="70"/>
                  </a:lnTo>
                  <a:lnTo>
                    <a:pt x="4699" y="70"/>
                  </a:lnTo>
                  <a:lnTo>
                    <a:pt x="4728" y="71"/>
                  </a:lnTo>
                  <a:lnTo>
                    <a:pt x="4756" y="70"/>
                  </a:lnTo>
                  <a:lnTo>
                    <a:pt x="4784" y="71"/>
                  </a:lnTo>
                  <a:lnTo>
                    <a:pt x="4813" y="68"/>
                  </a:lnTo>
                  <a:lnTo>
                    <a:pt x="4841" y="71"/>
                  </a:lnTo>
                  <a:lnTo>
                    <a:pt x="4870" y="71"/>
                  </a:lnTo>
                  <a:lnTo>
                    <a:pt x="4898" y="68"/>
                  </a:lnTo>
                  <a:lnTo>
                    <a:pt x="4927" y="71"/>
                  </a:lnTo>
                  <a:lnTo>
                    <a:pt x="4955" y="71"/>
                  </a:lnTo>
                  <a:lnTo>
                    <a:pt x="4984" y="71"/>
                  </a:lnTo>
                  <a:lnTo>
                    <a:pt x="5012" y="71"/>
                  </a:lnTo>
                  <a:lnTo>
                    <a:pt x="5040" y="70"/>
                  </a:lnTo>
                  <a:lnTo>
                    <a:pt x="5069" y="71"/>
                  </a:lnTo>
                  <a:lnTo>
                    <a:pt x="5097" y="71"/>
                  </a:lnTo>
                  <a:lnTo>
                    <a:pt x="5126" y="71"/>
                  </a:lnTo>
                  <a:lnTo>
                    <a:pt x="5154" y="71"/>
                  </a:lnTo>
                  <a:lnTo>
                    <a:pt x="5183" y="70"/>
                  </a:lnTo>
                  <a:lnTo>
                    <a:pt x="5211" y="70"/>
                  </a:lnTo>
                  <a:lnTo>
                    <a:pt x="5239" y="71"/>
                  </a:lnTo>
                  <a:lnTo>
                    <a:pt x="5268" y="71"/>
                  </a:lnTo>
                  <a:lnTo>
                    <a:pt x="5296" y="71"/>
                  </a:lnTo>
                  <a:lnTo>
                    <a:pt x="5325" y="71"/>
                  </a:lnTo>
                  <a:lnTo>
                    <a:pt x="5353" y="70"/>
                  </a:lnTo>
                  <a:lnTo>
                    <a:pt x="5382" y="71"/>
                  </a:lnTo>
                  <a:lnTo>
                    <a:pt x="5410" y="70"/>
                  </a:lnTo>
                  <a:lnTo>
                    <a:pt x="5439" y="70"/>
                  </a:lnTo>
                  <a:lnTo>
                    <a:pt x="5467" y="70"/>
                  </a:lnTo>
                  <a:lnTo>
                    <a:pt x="5495" y="71"/>
                  </a:lnTo>
                  <a:lnTo>
                    <a:pt x="5524" y="71"/>
                  </a:lnTo>
                  <a:lnTo>
                    <a:pt x="5552" y="71"/>
                  </a:lnTo>
                  <a:lnTo>
                    <a:pt x="5581" y="71"/>
                  </a:lnTo>
                  <a:lnTo>
                    <a:pt x="5609" y="71"/>
                  </a:lnTo>
                  <a:lnTo>
                    <a:pt x="5638" y="71"/>
                  </a:lnTo>
                  <a:lnTo>
                    <a:pt x="5666" y="71"/>
                  </a:lnTo>
                  <a:lnTo>
                    <a:pt x="5694" y="71"/>
                  </a:lnTo>
                </a:path>
              </a:pathLst>
            </a:custGeom>
            <a:noFill/>
            <a:ln w="9260" cap="rnd">
              <a:solidFill>
                <a:srgbClr val="000000"/>
              </a:solidFill>
              <a:prstDash val="solid"/>
              <a:round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  <p:sp>
          <p:nvSpPr>
            <p:cNvPr id="10" name="path 10"/>
            <p:cNvSpPr/>
            <p:nvPr/>
          </p:nvSpPr>
          <p:spPr>
            <a:xfrm>
              <a:off x="0" y="44493"/>
              <a:ext cx="3754156" cy="7123"/>
            </a:xfrm>
            <a:custGeom>
              <a:avLst/>
              <a:gdLst/>
              <a:ahLst/>
              <a:cxnLst/>
              <a:rect l="0" t="0" r="0" b="0"/>
              <a:pathLst>
                <a:path w="5912" h="11">
                  <a:moveTo>
                    <a:pt x="207" y="5"/>
                  </a:moveTo>
                  <a:lnTo>
                    <a:pt x="5906" y="5"/>
                  </a:lnTo>
                  <a:moveTo>
                    <a:pt x="207" y="5"/>
                  </a:moveTo>
                  <a:lnTo>
                    <a:pt x="5" y="5"/>
                  </a:lnTo>
                </a:path>
              </a:pathLst>
            </a:custGeom>
            <a:noFill/>
            <a:ln w="7123" cap="sq">
              <a:solidFill>
                <a:srgbClr val="000000"/>
              </a:solidFill>
              <a:prstDash val="solid"/>
              <a:bevel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</p:grpSp>
      <p:sp>
        <p:nvSpPr>
          <p:cNvPr id="12" name="path 12"/>
          <p:cNvSpPr/>
          <p:nvPr/>
        </p:nvSpPr>
        <p:spPr>
          <a:xfrm>
            <a:off x="2062255" y="790612"/>
            <a:ext cx="370428" cy="3013115"/>
          </a:xfrm>
          <a:custGeom>
            <a:avLst/>
            <a:gdLst/>
            <a:ahLst/>
            <a:cxnLst/>
            <a:rect l="0" t="0" r="0" b="0"/>
            <a:pathLst>
              <a:path w="583" h="4745">
                <a:moveTo>
                  <a:pt x="7" y="4737"/>
                </a:moveTo>
                <a:lnTo>
                  <a:pt x="35" y="4635"/>
                </a:lnTo>
                <a:lnTo>
                  <a:pt x="64" y="4414"/>
                </a:lnTo>
                <a:lnTo>
                  <a:pt x="92" y="4196"/>
                </a:lnTo>
                <a:lnTo>
                  <a:pt x="121" y="3925"/>
                </a:lnTo>
                <a:lnTo>
                  <a:pt x="149" y="3679"/>
                </a:lnTo>
                <a:lnTo>
                  <a:pt x="177" y="3368"/>
                </a:lnTo>
                <a:lnTo>
                  <a:pt x="206" y="3027"/>
                </a:lnTo>
                <a:lnTo>
                  <a:pt x="234" y="2640"/>
                </a:lnTo>
                <a:lnTo>
                  <a:pt x="263" y="2035"/>
                </a:lnTo>
                <a:lnTo>
                  <a:pt x="291" y="893"/>
                </a:lnTo>
                <a:lnTo>
                  <a:pt x="320" y="195"/>
                </a:lnTo>
                <a:lnTo>
                  <a:pt x="348" y="7"/>
                </a:lnTo>
                <a:lnTo>
                  <a:pt x="376" y="500"/>
                </a:lnTo>
                <a:lnTo>
                  <a:pt x="405" y="1606"/>
                </a:lnTo>
                <a:lnTo>
                  <a:pt x="433" y="2588"/>
                </a:lnTo>
                <a:lnTo>
                  <a:pt x="462" y="3558"/>
                </a:lnTo>
                <a:lnTo>
                  <a:pt x="490" y="4065"/>
                </a:lnTo>
                <a:lnTo>
                  <a:pt x="519" y="4417"/>
                </a:lnTo>
                <a:lnTo>
                  <a:pt x="547" y="4623"/>
                </a:lnTo>
                <a:lnTo>
                  <a:pt x="576" y="4732"/>
                </a:lnTo>
              </a:path>
            </a:pathLst>
          </a:custGeom>
          <a:noFill/>
          <a:ln w="9260" cap="rnd">
            <a:solidFill>
              <a:srgbClr val="000000"/>
            </a:solidFill>
            <a:prstDash val="solid"/>
            <a:round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pic>
        <p:nvPicPr>
          <p:cNvPr id="14" name="picture 1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1600000">
            <a:off x="929204" y="1224514"/>
            <a:ext cx="3611684" cy="2676634"/>
          </a:xfrm>
          <a:prstGeom prst="rect">
            <a:avLst/>
          </a:prstGeom>
        </p:spPr>
      </p:pic>
      <p:sp>
        <p:nvSpPr>
          <p:cNvPr id="16" name="textbox 16"/>
          <p:cNvSpPr/>
          <p:nvPr/>
        </p:nvSpPr>
        <p:spPr>
          <a:xfrm>
            <a:off x="5148708" y="463314"/>
            <a:ext cx="2123439" cy="330962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74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ct val="97000"/>
              </a:lnSpc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ile analyzed:</a:t>
            </a:r>
            <a:r>
              <a:rPr sz="10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231222</a:t>
            </a:r>
            <a:r>
              <a:rPr sz="1000" u="sng" kern="0" spc="-40" dirty="0">
                <a:solidFill>
                  <a:srgbClr val="0000FF">
                    <a:alpha val="100000"/>
                  </a:srgbClr>
                </a:solidFill>
                <a:uFill>
                  <a:solidFill>
                    <a:srgbClr val="000000"/>
                  </a:solidFill>
                </a:u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1000" u="sng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</a:t>
            </a:r>
            <a:r>
              <a:rPr sz="1000" u="sng" kern="0" spc="-40" dirty="0">
                <a:solidFill>
                  <a:srgbClr val="0000FF">
                    <a:alpha val="100000"/>
                  </a:srgbClr>
                </a:solidFill>
                <a:uFill>
                  <a:solidFill>
                    <a:srgbClr val="000000"/>
                  </a:solidFill>
                </a:u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04.f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cs</a:t>
            </a:r>
            <a:r>
              <a:rPr sz="10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ate analyzed:</a:t>
            </a:r>
            <a:r>
              <a:rPr sz="10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7-Dec-20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3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el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nn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n_DSD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ts val="1230"/>
              </a:lnSpc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nalysis type:</a:t>
            </a:r>
            <a:r>
              <a:rPr sz="1000" kern="0" spc="8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anual analy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sis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87000"/>
              </a:lnSpc>
              <a:spcBef>
                <a:spcPts val="75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uto</a:t>
            </a:r>
            <a:r>
              <a:rPr sz="10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Linearity:</a:t>
            </a:r>
            <a:r>
              <a:rPr sz="10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N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o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ts val="1270"/>
              </a:lnSpc>
              <a:spcBef>
                <a:spcPts val="945"/>
              </a:spcBef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loidy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e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:</a:t>
            </a:r>
            <a:r>
              <a:rPr sz="900" kern="0" spc="12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irst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cycle</a:t>
            </a:r>
            <a:r>
              <a:rPr sz="900" kern="0" spc="8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is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loid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ts val="1195"/>
              </a:lnSpc>
              <a:spcBef>
                <a:spcPts val="975"/>
              </a:spcBef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loid:</a:t>
            </a:r>
            <a:r>
              <a:rPr sz="900" kern="0" spc="1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.00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827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G1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91.63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t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73.93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827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G2:</a:t>
            </a:r>
            <a:r>
              <a:rPr sz="9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3.97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t</a:t>
            </a:r>
            <a:r>
              <a:rPr sz="9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45.63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8270" algn="l" rtl="0" eaLnBrk="0">
              <a:lnSpc>
                <a:spcPts val="123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S:</a:t>
            </a:r>
            <a:r>
              <a:rPr sz="900" kern="0" spc="8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.39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r>
              <a:rPr sz="9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G2/G1:</a:t>
            </a:r>
            <a:r>
              <a:rPr sz="900" kern="0" spc="1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.97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6365" algn="l" rtl="0" eaLnBrk="0">
              <a:lnSpc>
                <a:spcPts val="1230"/>
              </a:lnSpc>
              <a:spcBef>
                <a:spcPts val="70"/>
              </a:spcBef>
            </a:pP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CV:</a:t>
            </a:r>
            <a:r>
              <a:rPr sz="10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.83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5240" algn="l" rtl="0" eaLnBrk="0">
              <a:lnSpc>
                <a:spcPts val="1195"/>
              </a:lnSpc>
              <a:spcBef>
                <a:spcPts val="760"/>
              </a:spcBef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Total S-Phase:</a:t>
            </a:r>
            <a:r>
              <a:rPr sz="900" kern="0" spc="8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.39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5240" algn="l" rtl="0" eaLnBrk="0">
              <a:lnSpc>
                <a:spcPts val="1195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Total B.A.D.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.00 %    no debris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no aggs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ct val="100000"/>
              </a:lnSpc>
              <a:spcBef>
                <a:spcPts val="970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ebris:</a:t>
            </a:r>
            <a:r>
              <a:rPr sz="10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3000"/>
              </a:lnSpc>
              <a:spcBef>
                <a:spcPts val="5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ggregates:</a:t>
            </a:r>
            <a:r>
              <a:rPr sz="10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eled event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s: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9330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3000"/>
              </a:lnSpc>
              <a:spcBef>
                <a:spcPts val="5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ll cycle events:</a:t>
            </a:r>
            <a:r>
              <a:rPr sz="10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9330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8415" algn="l" rtl="0" eaLnBrk="0">
              <a:lnSpc>
                <a:spcPts val="1225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Cycle</a:t>
            </a:r>
            <a:r>
              <a:rPr sz="900" kern="0" spc="2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events</a:t>
            </a:r>
            <a:r>
              <a:rPr sz="900" kern="0" spc="1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er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channel</a:t>
            </a:r>
            <a:r>
              <a:rPr sz="900" kern="0" spc="2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: 403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ct val="92000"/>
              </a:lnSpc>
              <a:spcBef>
                <a:spcPts val="5"/>
              </a:spcBef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CS:</a:t>
            </a:r>
            <a:r>
              <a:rPr sz="900" kern="0" spc="10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.941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pic>
        <p:nvPicPr>
          <p:cNvPr id="18" name="picture 1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21600000">
            <a:off x="3209198" y="7436918"/>
            <a:ext cx="1225214" cy="1301232"/>
          </a:xfrm>
          <a:prstGeom prst="rect">
            <a:avLst/>
          </a:prstGeom>
        </p:spPr>
      </p:pic>
      <p:grpSp>
        <p:nvGrpSpPr>
          <p:cNvPr id="7" name="group 6"/>
          <p:cNvGrpSpPr/>
          <p:nvPr/>
        </p:nvGrpSpPr>
        <p:grpSpPr>
          <a:xfrm rot="21600000">
            <a:off x="3095220" y="7426391"/>
            <a:ext cx="1353491" cy="1303625"/>
            <a:chOff x="0" y="0"/>
            <a:chExt cx="1353491" cy="1303625"/>
          </a:xfrm>
        </p:grpSpPr>
        <p:sp>
          <p:nvSpPr>
            <p:cNvPr id="20" name="path 20"/>
            <p:cNvSpPr/>
            <p:nvPr/>
          </p:nvSpPr>
          <p:spPr>
            <a:xfrm>
              <a:off x="0" y="0"/>
              <a:ext cx="1353491" cy="1303625"/>
            </a:xfrm>
            <a:custGeom>
              <a:avLst/>
              <a:gdLst/>
              <a:ahLst/>
              <a:cxnLst/>
              <a:rect l="0" t="0" r="0" b="0"/>
              <a:pathLst>
                <a:path w="2131" h="2052">
                  <a:moveTo>
                    <a:pt x="263" y="1867"/>
                  </a:moveTo>
                  <a:lnTo>
                    <a:pt x="263" y="1957"/>
                  </a:lnTo>
                  <a:moveTo>
                    <a:pt x="342" y="1867"/>
                  </a:moveTo>
                  <a:lnTo>
                    <a:pt x="342" y="1957"/>
                  </a:lnTo>
                  <a:moveTo>
                    <a:pt x="420" y="1867"/>
                  </a:moveTo>
                  <a:lnTo>
                    <a:pt x="420" y="1957"/>
                  </a:lnTo>
                  <a:moveTo>
                    <a:pt x="487" y="1867"/>
                  </a:moveTo>
                  <a:lnTo>
                    <a:pt x="487" y="2047"/>
                  </a:lnTo>
                  <a:moveTo>
                    <a:pt x="566" y="1867"/>
                  </a:moveTo>
                  <a:lnTo>
                    <a:pt x="566" y="1957"/>
                  </a:lnTo>
                  <a:moveTo>
                    <a:pt x="645" y="1867"/>
                  </a:moveTo>
                  <a:lnTo>
                    <a:pt x="645" y="1957"/>
                  </a:lnTo>
                  <a:moveTo>
                    <a:pt x="723" y="1867"/>
                  </a:moveTo>
                  <a:lnTo>
                    <a:pt x="723" y="1957"/>
                  </a:lnTo>
                  <a:moveTo>
                    <a:pt x="802" y="1867"/>
                  </a:moveTo>
                  <a:lnTo>
                    <a:pt x="802" y="2047"/>
                  </a:lnTo>
                  <a:moveTo>
                    <a:pt x="880" y="1867"/>
                  </a:moveTo>
                  <a:lnTo>
                    <a:pt x="880" y="1957"/>
                  </a:lnTo>
                  <a:moveTo>
                    <a:pt x="959" y="1867"/>
                  </a:moveTo>
                  <a:lnTo>
                    <a:pt x="959" y="1957"/>
                  </a:lnTo>
                  <a:moveTo>
                    <a:pt x="1037" y="1867"/>
                  </a:moveTo>
                  <a:lnTo>
                    <a:pt x="1037" y="1957"/>
                  </a:lnTo>
                  <a:moveTo>
                    <a:pt x="1105" y="1867"/>
                  </a:moveTo>
                  <a:lnTo>
                    <a:pt x="1105" y="2047"/>
                  </a:lnTo>
                  <a:moveTo>
                    <a:pt x="1183" y="1867"/>
                  </a:moveTo>
                  <a:lnTo>
                    <a:pt x="1183" y="1957"/>
                  </a:lnTo>
                  <a:moveTo>
                    <a:pt x="1262" y="1867"/>
                  </a:moveTo>
                  <a:lnTo>
                    <a:pt x="1262" y="1957"/>
                  </a:lnTo>
                  <a:moveTo>
                    <a:pt x="1340" y="1867"/>
                  </a:moveTo>
                  <a:lnTo>
                    <a:pt x="1340" y="1957"/>
                  </a:lnTo>
                  <a:moveTo>
                    <a:pt x="1419" y="1867"/>
                  </a:moveTo>
                  <a:lnTo>
                    <a:pt x="1419" y="2047"/>
                  </a:lnTo>
                  <a:moveTo>
                    <a:pt x="1497" y="1867"/>
                  </a:moveTo>
                  <a:lnTo>
                    <a:pt x="1497" y="1957"/>
                  </a:lnTo>
                  <a:moveTo>
                    <a:pt x="1576" y="1867"/>
                  </a:moveTo>
                  <a:lnTo>
                    <a:pt x="1576" y="1957"/>
                  </a:lnTo>
                  <a:moveTo>
                    <a:pt x="1643" y="1867"/>
                  </a:moveTo>
                  <a:lnTo>
                    <a:pt x="1643" y="1957"/>
                  </a:lnTo>
                  <a:moveTo>
                    <a:pt x="1722" y="1867"/>
                  </a:moveTo>
                  <a:lnTo>
                    <a:pt x="1722" y="2047"/>
                  </a:lnTo>
                  <a:moveTo>
                    <a:pt x="1800" y="1867"/>
                  </a:moveTo>
                  <a:lnTo>
                    <a:pt x="1800" y="1957"/>
                  </a:lnTo>
                  <a:moveTo>
                    <a:pt x="1879" y="1867"/>
                  </a:moveTo>
                  <a:lnTo>
                    <a:pt x="1879" y="1957"/>
                  </a:lnTo>
                  <a:moveTo>
                    <a:pt x="1957" y="1867"/>
                  </a:moveTo>
                  <a:lnTo>
                    <a:pt x="1957" y="1957"/>
                  </a:lnTo>
                  <a:moveTo>
                    <a:pt x="2036" y="1867"/>
                  </a:moveTo>
                  <a:lnTo>
                    <a:pt x="2036" y="2047"/>
                  </a:lnTo>
                  <a:moveTo>
                    <a:pt x="2114" y="1867"/>
                  </a:moveTo>
                  <a:lnTo>
                    <a:pt x="2114" y="1957"/>
                  </a:lnTo>
                  <a:moveTo>
                    <a:pt x="185" y="1867"/>
                  </a:moveTo>
                  <a:lnTo>
                    <a:pt x="2125" y="1867"/>
                  </a:lnTo>
                  <a:moveTo>
                    <a:pt x="185" y="1867"/>
                  </a:moveTo>
                  <a:lnTo>
                    <a:pt x="5" y="1867"/>
                  </a:lnTo>
                  <a:moveTo>
                    <a:pt x="185" y="1789"/>
                  </a:moveTo>
                  <a:lnTo>
                    <a:pt x="95" y="1789"/>
                  </a:lnTo>
                  <a:moveTo>
                    <a:pt x="185" y="1722"/>
                  </a:moveTo>
                  <a:lnTo>
                    <a:pt x="95" y="1722"/>
                  </a:lnTo>
                  <a:moveTo>
                    <a:pt x="185" y="1643"/>
                  </a:moveTo>
                  <a:lnTo>
                    <a:pt x="95" y="1643"/>
                  </a:lnTo>
                  <a:moveTo>
                    <a:pt x="185" y="1576"/>
                  </a:moveTo>
                  <a:lnTo>
                    <a:pt x="5" y="1576"/>
                  </a:lnTo>
                  <a:moveTo>
                    <a:pt x="185" y="1497"/>
                  </a:moveTo>
                  <a:lnTo>
                    <a:pt x="95" y="1497"/>
                  </a:lnTo>
                  <a:moveTo>
                    <a:pt x="185" y="1430"/>
                  </a:moveTo>
                  <a:lnTo>
                    <a:pt x="95" y="1430"/>
                  </a:lnTo>
                  <a:moveTo>
                    <a:pt x="185" y="1351"/>
                  </a:moveTo>
                  <a:lnTo>
                    <a:pt x="95" y="1351"/>
                  </a:lnTo>
                  <a:moveTo>
                    <a:pt x="185" y="1284"/>
                  </a:moveTo>
                  <a:lnTo>
                    <a:pt x="5" y="1284"/>
                  </a:lnTo>
                  <a:moveTo>
                    <a:pt x="185" y="1205"/>
                  </a:moveTo>
                  <a:lnTo>
                    <a:pt x="95" y="1205"/>
                  </a:lnTo>
                  <a:moveTo>
                    <a:pt x="185" y="1138"/>
                  </a:moveTo>
                  <a:lnTo>
                    <a:pt x="95" y="1138"/>
                  </a:lnTo>
                  <a:moveTo>
                    <a:pt x="185" y="1060"/>
                  </a:moveTo>
                  <a:lnTo>
                    <a:pt x="95" y="1060"/>
                  </a:lnTo>
                  <a:moveTo>
                    <a:pt x="185" y="992"/>
                  </a:moveTo>
                  <a:lnTo>
                    <a:pt x="5" y="992"/>
                  </a:lnTo>
                  <a:moveTo>
                    <a:pt x="185" y="914"/>
                  </a:moveTo>
                  <a:lnTo>
                    <a:pt x="95" y="914"/>
                  </a:lnTo>
                  <a:moveTo>
                    <a:pt x="185" y="846"/>
                  </a:moveTo>
                  <a:lnTo>
                    <a:pt x="95" y="846"/>
                  </a:lnTo>
                  <a:moveTo>
                    <a:pt x="185" y="768"/>
                  </a:moveTo>
                  <a:lnTo>
                    <a:pt x="95" y="768"/>
                  </a:lnTo>
                  <a:moveTo>
                    <a:pt x="185" y="689"/>
                  </a:moveTo>
                  <a:lnTo>
                    <a:pt x="5" y="689"/>
                  </a:lnTo>
                  <a:moveTo>
                    <a:pt x="185" y="622"/>
                  </a:moveTo>
                  <a:lnTo>
                    <a:pt x="95" y="622"/>
                  </a:lnTo>
                  <a:moveTo>
                    <a:pt x="185" y="544"/>
                  </a:moveTo>
                  <a:lnTo>
                    <a:pt x="95" y="544"/>
                  </a:lnTo>
                  <a:moveTo>
                    <a:pt x="185" y="476"/>
                  </a:moveTo>
                  <a:lnTo>
                    <a:pt x="95" y="476"/>
                  </a:lnTo>
                  <a:moveTo>
                    <a:pt x="185" y="398"/>
                  </a:moveTo>
                  <a:lnTo>
                    <a:pt x="5" y="398"/>
                  </a:lnTo>
                  <a:moveTo>
                    <a:pt x="185" y="330"/>
                  </a:moveTo>
                  <a:lnTo>
                    <a:pt x="95" y="330"/>
                  </a:lnTo>
                  <a:moveTo>
                    <a:pt x="185" y="252"/>
                  </a:moveTo>
                  <a:lnTo>
                    <a:pt x="95" y="252"/>
                  </a:lnTo>
                  <a:moveTo>
                    <a:pt x="185" y="185"/>
                  </a:moveTo>
                  <a:lnTo>
                    <a:pt x="95" y="185"/>
                  </a:lnTo>
                  <a:moveTo>
                    <a:pt x="185" y="106"/>
                  </a:moveTo>
                  <a:lnTo>
                    <a:pt x="5" y="106"/>
                  </a:lnTo>
                  <a:moveTo>
                    <a:pt x="185" y="39"/>
                  </a:moveTo>
                  <a:lnTo>
                    <a:pt x="95" y="39"/>
                  </a:lnTo>
                  <a:moveTo>
                    <a:pt x="185" y="1867"/>
                  </a:moveTo>
                  <a:lnTo>
                    <a:pt x="185" y="5"/>
                  </a:lnTo>
                </a:path>
              </a:pathLst>
            </a:custGeom>
            <a:noFill/>
            <a:ln w="7123" cap="sq">
              <a:solidFill>
                <a:srgbClr val="000000"/>
              </a:solidFill>
              <a:prstDash val="solid"/>
              <a:bevel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  <p:sp>
          <p:nvSpPr>
            <p:cNvPr id="22" name="path 22"/>
            <p:cNvSpPr/>
            <p:nvPr/>
          </p:nvSpPr>
          <p:spPr>
            <a:xfrm>
              <a:off x="376856" y="634992"/>
              <a:ext cx="720723" cy="554654"/>
            </a:xfrm>
            <a:custGeom>
              <a:avLst/>
              <a:gdLst/>
              <a:ahLst/>
              <a:cxnLst/>
              <a:rect l="0" t="0" r="0" b="0"/>
              <a:pathLst>
                <a:path w="1134" h="873">
                  <a:moveTo>
                    <a:pt x="1082" y="76"/>
                  </a:moveTo>
                  <a:lnTo>
                    <a:pt x="1104" y="153"/>
                  </a:lnTo>
                  <a:lnTo>
                    <a:pt x="1118" y="222"/>
                  </a:lnTo>
                  <a:lnTo>
                    <a:pt x="1118" y="267"/>
                  </a:lnTo>
                  <a:lnTo>
                    <a:pt x="1118" y="312"/>
                  </a:lnTo>
                  <a:lnTo>
                    <a:pt x="1113" y="389"/>
                  </a:lnTo>
                  <a:lnTo>
                    <a:pt x="1087" y="483"/>
                  </a:lnTo>
                  <a:lnTo>
                    <a:pt x="1052" y="560"/>
                  </a:lnTo>
                  <a:lnTo>
                    <a:pt x="1012" y="625"/>
                  </a:lnTo>
                  <a:lnTo>
                    <a:pt x="959" y="676"/>
                  </a:lnTo>
                  <a:lnTo>
                    <a:pt x="906" y="723"/>
                  </a:lnTo>
                  <a:lnTo>
                    <a:pt x="840" y="766"/>
                  </a:lnTo>
                  <a:lnTo>
                    <a:pt x="778" y="800"/>
                  </a:lnTo>
                  <a:lnTo>
                    <a:pt x="699" y="830"/>
                  </a:lnTo>
                  <a:lnTo>
                    <a:pt x="615" y="843"/>
                  </a:lnTo>
                  <a:lnTo>
                    <a:pt x="545" y="852"/>
                  </a:lnTo>
                  <a:lnTo>
                    <a:pt x="474" y="852"/>
                  </a:lnTo>
                  <a:lnTo>
                    <a:pt x="400" y="856"/>
                  </a:lnTo>
                  <a:lnTo>
                    <a:pt x="325" y="856"/>
                  </a:lnTo>
                  <a:lnTo>
                    <a:pt x="254" y="856"/>
                  </a:lnTo>
                  <a:lnTo>
                    <a:pt x="175" y="830"/>
                  </a:lnTo>
                  <a:lnTo>
                    <a:pt x="104" y="800"/>
                  </a:lnTo>
                  <a:lnTo>
                    <a:pt x="47" y="749"/>
                  </a:lnTo>
                  <a:lnTo>
                    <a:pt x="21" y="668"/>
                  </a:lnTo>
                  <a:lnTo>
                    <a:pt x="16" y="595"/>
                  </a:lnTo>
                  <a:lnTo>
                    <a:pt x="16" y="558"/>
                  </a:lnTo>
                  <a:lnTo>
                    <a:pt x="16" y="522"/>
                  </a:lnTo>
                  <a:lnTo>
                    <a:pt x="38" y="453"/>
                  </a:lnTo>
                  <a:lnTo>
                    <a:pt x="82" y="381"/>
                  </a:lnTo>
                  <a:lnTo>
                    <a:pt x="126" y="312"/>
                  </a:lnTo>
                  <a:lnTo>
                    <a:pt x="171" y="256"/>
                  </a:lnTo>
                  <a:lnTo>
                    <a:pt x="223" y="205"/>
                  </a:lnTo>
                  <a:lnTo>
                    <a:pt x="294" y="145"/>
                  </a:lnTo>
                  <a:lnTo>
                    <a:pt x="360" y="102"/>
                  </a:lnTo>
                  <a:lnTo>
                    <a:pt x="426" y="68"/>
                  </a:lnTo>
                  <a:lnTo>
                    <a:pt x="492" y="38"/>
                  </a:lnTo>
                  <a:lnTo>
                    <a:pt x="580" y="21"/>
                  </a:lnTo>
                  <a:lnTo>
                    <a:pt x="660" y="16"/>
                  </a:lnTo>
                  <a:lnTo>
                    <a:pt x="730" y="16"/>
                  </a:lnTo>
                  <a:lnTo>
                    <a:pt x="805" y="21"/>
                  </a:lnTo>
                  <a:lnTo>
                    <a:pt x="831" y="25"/>
                  </a:lnTo>
                  <a:lnTo>
                    <a:pt x="894" y="38"/>
                  </a:lnTo>
                  <a:lnTo>
                    <a:pt x="957" y="51"/>
                  </a:lnTo>
                  <a:lnTo>
                    <a:pt x="1020" y="63"/>
                  </a:lnTo>
                  <a:lnTo>
                    <a:pt x="1082" y="76"/>
                  </a:lnTo>
                </a:path>
              </a:pathLst>
            </a:custGeom>
            <a:noFill/>
            <a:ln w="21370" cap="sq">
              <a:solidFill>
                <a:srgbClr val="000000"/>
              </a:solidFill>
              <a:prstDash val="solid"/>
              <a:miter lim="1000000"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</p:grpSp>
      <p:pic>
        <p:nvPicPr>
          <p:cNvPr id="24" name="picture 2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21600000">
            <a:off x="5545751" y="7436918"/>
            <a:ext cx="1223862" cy="1301232"/>
          </a:xfrm>
          <a:prstGeom prst="rect">
            <a:avLst/>
          </a:prstGeom>
        </p:spPr>
      </p:pic>
      <p:grpSp>
        <p:nvGrpSpPr>
          <p:cNvPr id="9" name="group 8"/>
          <p:cNvGrpSpPr/>
          <p:nvPr/>
        </p:nvGrpSpPr>
        <p:grpSpPr>
          <a:xfrm rot="21600000">
            <a:off x="5431773" y="7426391"/>
            <a:ext cx="1353491" cy="1303625"/>
            <a:chOff x="0" y="0"/>
            <a:chExt cx="1353491" cy="1303625"/>
          </a:xfrm>
        </p:grpSpPr>
        <p:sp>
          <p:nvSpPr>
            <p:cNvPr id="26" name="path 26"/>
            <p:cNvSpPr/>
            <p:nvPr/>
          </p:nvSpPr>
          <p:spPr>
            <a:xfrm>
              <a:off x="0" y="0"/>
              <a:ext cx="1353491" cy="1303625"/>
            </a:xfrm>
            <a:custGeom>
              <a:avLst/>
              <a:gdLst/>
              <a:ahLst/>
              <a:cxnLst/>
              <a:rect l="0" t="0" r="0" b="0"/>
              <a:pathLst>
                <a:path w="2131" h="2052">
                  <a:moveTo>
                    <a:pt x="263" y="1867"/>
                  </a:moveTo>
                  <a:lnTo>
                    <a:pt x="263" y="1957"/>
                  </a:lnTo>
                  <a:moveTo>
                    <a:pt x="342" y="1867"/>
                  </a:moveTo>
                  <a:lnTo>
                    <a:pt x="342" y="1957"/>
                  </a:lnTo>
                  <a:moveTo>
                    <a:pt x="420" y="1867"/>
                  </a:moveTo>
                  <a:lnTo>
                    <a:pt x="420" y="1957"/>
                  </a:lnTo>
                  <a:moveTo>
                    <a:pt x="487" y="1867"/>
                  </a:moveTo>
                  <a:lnTo>
                    <a:pt x="487" y="2047"/>
                  </a:lnTo>
                  <a:moveTo>
                    <a:pt x="566" y="1867"/>
                  </a:moveTo>
                  <a:lnTo>
                    <a:pt x="566" y="1957"/>
                  </a:lnTo>
                  <a:moveTo>
                    <a:pt x="645" y="1867"/>
                  </a:moveTo>
                  <a:lnTo>
                    <a:pt x="645" y="1957"/>
                  </a:lnTo>
                  <a:moveTo>
                    <a:pt x="723" y="1867"/>
                  </a:moveTo>
                  <a:lnTo>
                    <a:pt x="723" y="1957"/>
                  </a:lnTo>
                  <a:moveTo>
                    <a:pt x="802" y="1867"/>
                  </a:moveTo>
                  <a:lnTo>
                    <a:pt x="802" y="2047"/>
                  </a:lnTo>
                  <a:moveTo>
                    <a:pt x="880" y="1867"/>
                  </a:moveTo>
                  <a:lnTo>
                    <a:pt x="880" y="1957"/>
                  </a:lnTo>
                  <a:moveTo>
                    <a:pt x="959" y="1867"/>
                  </a:moveTo>
                  <a:lnTo>
                    <a:pt x="959" y="1957"/>
                  </a:lnTo>
                  <a:moveTo>
                    <a:pt x="1037" y="1867"/>
                  </a:moveTo>
                  <a:lnTo>
                    <a:pt x="1037" y="1957"/>
                  </a:lnTo>
                  <a:moveTo>
                    <a:pt x="1105" y="1867"/>
                  </a:moveTo>
                  <a:lnTo>
                    <a:pt x="1105" y="2047"/>
                  </a:lnTo>
                  <a:moveTo>
                    <a:pt x="1183" y="1867"/>
                  </a:moveTo>
                  <a:lnTo>
                    <a:pt x="1183" y="1957"/>
                  </a:lnTo>
                  <a:moveTo>
                    <a:pt x="1262" y="1867"/>
                  </a:moveTo>
                  <a:lnTo>
                    <a:pt x="1262" y="1957"/>
                  </a:lnTo>
                  <a:moveTo>
                    <a:pt x="1340" y="1867"/>
                  </a:moveTo>
                  <a:lnTo>
                    <a:pt x="1340" y="1957"/>
                  </a:lnTo>
                  <a:moveTo>
                    <a:pt x="1419" y="1867"/>
                  </a:moveTo>
                  <a:lnTo>
                    <a:pt x="1419" y="2047"/>
                  </a:lnTo>
                  <a:moveTo>
                    <a:pt x="1497" y="1867"/>
                  </a:moveTo>
                  <a:lnTo>
                    <a:pt x="1497" y="1957"/>
                  </a:lnTo>
                  <a:moveTo>
                    <a:pt x="1576" y="1867"/>
                  </a:moveTo>
                  <a:lnTo>
                    <a:pt x="1576" y="1957"/>
                  </a:lnTo>
                  <a:moveTo>
                    <a:pt x="1643" y="1867"/>
                  </a:moveTo>
                  <a:lnTo>
                    <a:pt x="1643" y="1957"/>
                  </a:lnTo>
                  <a:moveTo>
                    <a:pt x="1722" y="1867"/>
                  </a:moveTo>
                  <a:lnTo>
                    <a:pt x="1722" y="2047"/>
                  </a:lnTo>
                  <a:moveTo>
                    <a:pt x="1800" y="1867"/>
                  </a:moveTo>
                  <a:lnTo>
                    <a:pt x="1800" y="1957"/>
                  </a:lnTo>
                  <a:moveTo>
                    <a:pt x="1879" y="1867"/>
                  </a:moveTo>
                  <a:lnTo>
                    <a:pt x="1879" y="1957"/>
                  </a:lnTo>
                  <a:moveTo>
                    <a:pt x="1957" y="1867"/>
                  </a:moveTo>
                  <a:lnTo>
                    <a:pt x="1957" y="1957"/>
                  </a:lnTo>
                  <a:moveTo>
                    <a:pt x="2036" y="1867"/>
                  </a:moveTo>
                  <a:lnTo>
                    <a:pt x="2036" y="2047"/>
                  </a:lnTo>
                  <a:moveTo>
                    <a:pt x="2114" y="1867"/>
                  </a:moveTo>
                  <a:lnTo>
                    <a:pt x="2114" y="1957"/>
                  </a:lnTo>
                  <a:moveTo>
                    <a:pt x="185" y="1867"/>
                  </a:moveTo>
                  <a:lnTo>
                    <a:pt x="2125" y="1867"/>
                  </a:lnTo>
                  <a:moveTo>
                    <a:pt x="185" y="1867"/>
                  </a:moveTo>
                  <a:lnTo>
                    <a:pt x="5" y="1867"/>
                  </a:lnTo>
                  <a:moveTo>
                    <a:pt x="185" y="1789"/>
                  </a:moveTo>
                  <a:lnTo>
                    <a:pt x="95" y="1789"/>
                  </a:lnTo>
                  <a:moveTo>
                    <a:pt x="185" y="1722"/>
                  </a:moveTo>
                  <a:lnTo>
                    <a:pt x="95" y="1722"/>
                  </a:lnTo>
                  <a:moveTo>
                    <a:pt x="185" y="1643"/>
                  </a:moveTo>
                  <a:lnTo>
                    <a:pt x="95" y="1643"/>
                  </a:lnTo>
                  <a:moveTo>
                    <a:pt x="185" y="1576"/>
                  </a:moveTo>
                  <a:lnTo>
                    <a:pt x="5" y="1576"/>
                  </a:lnTo>
                  <a:moveTo>
                    <a:pt x="185" y="1497"/>
                  </a:moveTo>
                  <a:lnTo>
                    <a:pt x="95" y="1497"/>
                  </a:lnTo>
                  <a:moveTo>
                    <a:pt x="185" y="1430"/>
                  </a:moveTo>
                  <a:lnTo>
                    <a:pt x="95" y="1430"/>
                  </a:lnTo>
                  <a:moveTo>
                    <a:pt x="185" y="1351"/>
                  </a:moveTo>
                  <a:lnTo>
                    <a:pt x="95" y="1351"/>
                  </a:lnTo>
                  <a:moveTo>
                    <a:pt x="185" y="1284"/>
                  </a:moveTo>
                  <a:lnTo>
                    <a:pt x="5" y="1284"/>
                  </a:lnTo>
                  <a:moveTo>
                    <a:pt x="185" y="1205"/>
                  </a:moveTo>
                  <a:lnTo>
                    <a:pt x="95" y="1205"/>
                  </a:lnTo>
                  <a:moveTo>
                    <a:pt x="185" y="1138"/>
                  </a:moveTo>
                  <a:lnTo>
                    <a:pt x="95" y="1138"/>
                  </a:lnTo>
                  <a:moveTo>
                    <a:pt x="185" y="1060"/>
                  </a:moveTo>
                  <a:lnTo>
                    <a:pt x="95" y="1060"/>
                  </a:lnTo>
                  <a:moveTo>
                    <a:pt x="185" y="992"/>
                  </a:moveTo>
                  <a:lnTo>
                    <a:pt x="5" y="992"/>
                  </a:lnTo>
                  <a:moveTo>
                    <a:pt x="185" y="914"/>
                  </a:moveTo>
                  <a:lnTo>
                    <a:pt x="95" y="914"/>
                  </a:lnTo>
                  <a:moveTo>
                    <a:pt x="185" y="846"/>
                  </a:moveTo>
                  <a:lnTo>
                    <a:pt x="95" y="846"/>
                  </a:lnTo>
                  <a:moveTo>
                    <a:pt x="185" y="768"/>
                  </a:moveTo>
                  <a:lnTo>
                    <a:pt x="95" y="768"/>
                  </a:lnTo>
                  <a:moveTo>
                    <a:pt x="185" y="689"/>
                  </a:moveTo>
                  <a:lnTo>
                    <a:pt x="5" y="689"/>
                  </a:lnTo>
                  <a:moveTo>
                    <a:pt x="185" y="622"/>
                  </a:moveTo>
                  <a:lnTo>
                    <a:pt x="95" y="622"/>
                  </a:lnTo>
                  <a:moveTo>
                    <a:pt x="185" y="544"/>
                  </a:moveTo>
                  <a:lnTo>
                    <a:pt x="95" y="544"/>
                  </a:lnTo>
                  <a:moveTo>
                    <a:pt x="185" y="476"/>
                  </a:moveTo>
                  <a:lnTo>
                    <a:pt x="95" y="476"/>
                  </a:lnTo>
                  <a:moveTo>
                    <a:pt x="185" y="398"/>
                  </a:moveTo>
                  <a:lnTo>
                    <a:pt x="5" y="398"/>
                  </a:lnTo>
                  <a:moveTo>
                    <a:pt x="185" y="330"/>
                  </a:moveTo>
                  <a:lnTo>
                    <a:pt x="95" y="330"/>
                  </a:lnTo>
                  <a:moveTo>
                    <a:pt x="185" y="252"/>
                  </a:moveTo>
                  <a:lnTo>
                    <a:pt x="95" y="252"/>
                  </a:lnTo>
                  <a:moveTo>
                    <a:pt x="185" y="185"/>
                  </a:moveTo>
                  <a:lnTo>
                    <a:pt x="95" y="185"/>
                  </a:lnTo>
                  <a:moveTo>
                    <a:pt x="185" y="106"/>
                  </a:moveTo>
                  <a:lnTo>
                    <a:pt x="5" y="106"/>
                  </a:lnTo>
                  <a:moveTo>
                    <a:pt x="185" y="39"/>
                  </a:moveTo>
                  <a:lnTo>
                    <a:pt x="95" y="39"/>
                  </a:lnTo>
                  <a:moveTo>
                    <a:pt x="185" y="1867"/>
                  </a:moveTo>
                  <a:lnTo>
                    <a:pt x="185" y="5"/>
                  </a:lnTo>
                </a:path>
              </a:pathLst>
            </a:custGeom>
            <a:noFill/>
            <a:ln w="7123" cap="sq">
              <a:solidFill>
                <a:srgbClr val="000000"/>
              </a:solidFill>
              <a:prstDash val="solid"/>
              <a:bevel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  <p:sp>
          <p:nvSpPr>
            <p:cNvPr id="28" name="path 28"/>
            <p:cNvSpPr/>
            <p:nvPr/>
          </p:nvSpPr>
          <p:spPr>
            <a:xfrm>
              <a:off x="334972" y="537042"/>
              <a:ext cx="729115" cy="598187"/>
            </a:xfrm>
            <a:custGeom>
              <a:avLst/>
              <a:gdLst/>
              <a:ahLst/>
              <a:cxnLst/>
              <a:rect l="0" t="0" r="0" b="0"/>
              <a:pathLst>
                <a:path w="1148" h="942">
                  <a:moveTo>
                    <a:pt x="928" y="21"/>
                  </a:moveTo>
                  <a:lnTo>
                    <a:pt x="986" y="72"/>
                  </a:lnTo>
                  <a:lnTo>
                    <a:pt x="1047" y="132"/>
                  </a:lnTo>
                  <a:lnTo>
                    <a:pt x="1091" y="213"/>
                  </a:lnTo>
                  <a:lnTo>
                    <a:pt x="1122" y="299"/>
                  </a:lnTo>
                  <a:lnTo>
                    <a:pt x="1131" y="372"/>
                  </a:lnTo>
                  <a:lnTo>
                    <a:pt x="1131" y="411"/>
                  </a:lnTo>
                  <a:lnTo>
                    <a:pt x="1131" y="449"/>
                  </a:lnTo>
                  <a:lnTo>
                    <a:pt x="1096" y="531"/>
                  </a:lnTo>
                  <a:lnTo>
                    <a:pt x="1052" y="590"/>
                  </a:lnTo>
                  <a:lnTo>
                    <a:pt x="999" y="642"/>
                  </a:lnTo>
                  <a:lnTo>
                    <a:pt x="941" y="702"/>
                  </a:lnTo>
                  <a:lnTo>
                    <a:pt x="880" y="758"/>
                  </a:lnTo>
                  <a:lnTo>
                    <a:pt x="823" y="805"/>
                  </a:lnTo>
                  <a:lnTo>
                    <a:pt x="765" y="848"/>
                  </a:lnTo>
                  <a:lnTo>
                    <a:pt x="704" y="886"/>
                  </a:lnTo>
                  <a:lnTo>
                    <a:pt x="629" y="908"/>
                  </a:lnTo>
                  <a:lnTo>
                    <a:pt x="554" y="920"/>
                  </a:lnTo>
                  <a:lnTo>
                    <a:pt x="474" y="925"/>
                  </a:lnTo>
                  <a:lnTo>
                    <a:pt x="400" y="925"/>
                  </a:lnTo>
                  <a:lnTo>
                    <a:pt x="329" y="916"/>
                  </a:lnTo>
                  <a:lnTo>
                    <a:pt x="259" y="895"/>
                  </a:lnTo>
                  <a:lnTo>
                    <a:pt x="193" y="860"/>
                  </a:lnTo>
                  <a:lnTo>
                    <a:pt x="140" y="813"/>
                  </a:lnTo>
                  <a:lnTo>
                    <a:pt x="78" y="766"/>
                  </a:lnTo>
                  <a:lnTo>
                    <a:pt x="30" y="706"/>
                  </a:lnTo>
                  <a:lnTo>
                    <a:pt x="16" y="638"/>
                  </a:lnTo>
                  <a:lnTo>
                    <a:pt x="21" y="569"/>
                  </a:lnTo>
                  <a:lnTo>
                    <a:pt x="43" y="501"/>
                  </a:lnTo>
                  <a:lnTo>
                    <a:pt x="69" y="436"/>
                  </a:lnTo>
                  <a:lnTo>
                    <a:pt x="100" y="372"/>
                  </a:lnTo>
                  <a:lnTo>
                    <a:pt x="144" y="312"/>
                  </a:lnTo>
                  <a:lnTo>
                    <a:pt x="201" y="248"/>
                  </a:lnTo>
                  <a:lnTo>
                    <a:pt x="259" y="205"/>
                  </a:lnTo>
                  <a:lnTo>
                    <a:pt x="316" y="162"/>
                  </a:lnTo>
                  <a:lnTo>
                    <a:pt x="382" y="132"/>
                  </a:lnTo>
                  <a:lnTo>
                    <a:pt x="452" y="98"/>
                  </a:lnTo>
                  <a:lnTo>
                    <a:pt x="519" y="68"/>
                  </a:lnTo>
                  <a:lnTo>
                    <a:pt x="589" y="42"/>
                  </a:lnTo>
                  <a:lnTo>
                    <a:pt x="660" y="21"/>
                  </a:lnTo>
                  <a:lnTo>
                    <a:pt x="673" y="16"/>
                  </a:lnTo>
                  <a:lnTo>
                    <a:pt x="737" y="17"/>
                  </a:lnTo>
                  <a:lnTo>
                    <a:pt x="800" y="18"/>
                  </a:lnTo>
                  <a:lnTo>
                    <a:pt x="864" y="20"/>
                  </a:lnTo>
                  <a:lnTo>
                    <a:pt x="928" y="21"/>
                  </a:lnTo>
                </a:path>
              </a:pathLst>
            </a:custGeom>
            <a:noFill/>
            <a:ln w="21370" cap="sq">
              <a:solidFill>
                <a:srgbClr val="000000"/>
              </a:solidFill>
              <a:prstDash val="solid"/>
              <a:miter lim="1000000"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</p:grpSp>
      <p:pic>
        <p:nvPicPr>
          <p:cNvPr id="30" name="picture 3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21600000">
            <a:off x="872645" y="7436918"/>
            <a:ext cx="1239083" cy="1301232"/>
          </a:xfrm>
          <a:prstGeom prst="rect">
            <a:avLst/>
          </a:prstGeom>
        </p:spPr>
      </p:pic>
      <p:sp>
        <p:nvSpPr>
          <p:cNvPr id="32" name="textbox 32"/>
          <p:cNvSpPr/>
          <p:nvPr/>
        </p:nvSpPr>
        <p:spPr>
          <a:xfrm>
            <a:off x="882499" y="4078020"/>
            <a:ext cx="3767454" cy="31242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81000"/>
              </a:lnSpc>
            </a:pP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  </a:t>
            </a:r>
            <a:r>
              <a:rPr sz="9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5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50                       200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741170" algn="l" rtl="0" eaLnBrk="0">
              <a:lnSpc>
                <a:spcPts val="1270"/>
              </a:lnSpc>
              <a:spcBef>
                <a:spcPts val="115"/>
              </a:spcBef>
            </a:pPr>
            <a:r>
              <a:rPr sz="1000" kern="0" spc="-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I-A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34" name="textbox 34"/>
          <p:cNvSpPr/>
          <p:nvPr/>
        </p:nvSpPr>
        <p:spPr>
          <a:xfrm>
            <a:off x="5519459" y="8760429"/>
            <a:ext cx="1303019" cy="32639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6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537210" indent="-525145" algn="l" rtl="0" eaLnBrk="0">
              <a:lnSpc>
                <a:spcPct val="116000"/>
              </a:lnSpc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    2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60   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80</a:t>
            </a:r>
            <a:r>
              <a:rPr sz="700" kern="0" spc="10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  120  </a:t>
            </a:r>
            <a:r>
              <a:rPr sz="1000" kern="0" spc="-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I-A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36" name="textbox 36"/>
          <p:cNvSpPr/>
          <p:nvPr/>
        </p:nvSpPr>
        <p:spPr>
          <a:xfrm>
            <a:off x="846353" y="8760429"/>
            <a:ext cx="1303019" cy="28702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2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0000"/>
              </a:lnSpc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    2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60</a:t>
            </a:r>
            <a:r>
              <a:rPr sz="700" kern="0" spc="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   100  1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l" rtl="0" eaLnBrk="0">
              <a:lnSpc>
                <a:spcPct val="148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47371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SC-A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38" name="textbox 38"/>
          <p:cNvSpPr/>
          <p:nvPr/>
        </p:nvSpPr>
        <p:spPr>
          <a:xfrm>
            <a:off x="3182906" y="8760429"/>
            <a:ext cx="1303019" cy="28702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2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0000"/>
              </a:lnSpc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    2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60</a:t>
            </a:r>
            <a:r>
              <a:rPr sz="700" kern="0" spc="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   100  1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l" rtl="0" eaLnBrk="0">
              <a:lnSpc>
                <a:spcPct val="148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47371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SC-A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40" name="textbox 40"/>
          <p:cNvSpPr/>
          <p:nvPr/>
        </p:nvSpPr>
        <p:spPr>
          <a:xfrm rot="16200000">
            <a:off x="-952306" y="2214200"/>
            <a:ext cx="3289934" cy="16256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26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81000"/>
              </a:lnSpc>
              <a:spcBef>
                <a:spcPts val="0"/>
              </a:spcBef>
            </a:pPr>
            <a:r>
              <a:rPr sz="9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          50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</a:t>
            </a:r>
            <a:r>
              <a:rPr sz="9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0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150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00      2500       3000      3500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42" name="path 42"/>
          <p:cNvSpPr/>
          <p:nvPr/>
        </p:nvSpPr>
        <p:spPr>
          <a:xfrm>
            <a:off x="1166600" y="8053654"/>
            <a:ext cx="651294" cy="325403"/>
          </a:xfrm>
          <a:custGeom>
            <a:avLst/>
            <a:gdLst/>
            <a:ahLst/>
            <a:cxnLst/>
            <a:rect l="0" t="0" r="0" b="0"/>
            <a:pathLst>
              <a:path w="1025" h="512">
                <a:moveTo>
                  <a:pt x="663" y="35"/>
                </a:moveTo>
                <a:lnTo>
                  <a:pt x="732" y="25"/>
                </a:lnTo>
                <a:lnTo>
                  <a:pt x="822" y="16"/>
                </a:lnTo>
                <a:lnTo>
                  <a:pt x="902" y="20"/>
                </a:lnTo>
                <a:lnTo>
                  <a:pt x="964" y="42"/>
                </a:lnTo>
                <a:lnTo>
                  <a:pt x="995" y="96"/>
                </a:lnTo>
                <a:lnTo>
                  <a:pt x="1008" y="159"/>
                </a:lnTo>
                <a:lnTo>
                  <a:pt x="1006" y="225"/>
                </a:lnTo>
                <a:lnTo>
                  <a:pt x="962" y="281"/>
                </a:lnTo>
                <a:lnTo>
                  <a:pt x="904" y="320"/>
                </a:lnTo>
                <a:lnTo>
                  <a:pt x="849" y="350"/>
                </a:lnTo>
                <a:lnTo>
                  <a:pt x="782" y="375"/>
                </a:lnTo>
                <a:lnTo>
                  <a:pt x="709" y="397"/>
                </a:lnTo>
                <a:lnTo>
                  <a:pt x="626" y="420"/>
                </a:lnTo>
                <a:lnTo>
                  <a:pt x="557" y="441"/>
                </a:lnTo>
                <a:lnTo>
                  <a:pt x="493" y="458"/>
                </a:lnTo>
                <a:lnTo>
                  <a:pt x="432" y="474"/>
                </a:lnTo>
                <a:lnTo>
                  <a:pt x="366" y="484"/>
                </a:lnTo>
                <a:lnTo>
                  <a:pt x="296" y="493"/>
                </a:lnTo>
                <a:lnTo>
                  <a:pt x="229" y="495"/>
                </a:lnTo>
                <a:lnTo>
                  <a:pt x="160" y="486"/>
                </a:lnTo>
                <a:lnTo>
                  <a:pt x="99" y="471"/>
                </a:lnTo>
                <a:lnTo>
                  <a:pt x="49" y="424"/>
                </a:lnTo>
                <a:lnTo>
                  <a:pt x="21" y="367"/>
                </a:lnTo>
                <a:lnTo>
                  <a:pt x="16" y="306"/>
                </a:lnTo>
                <a:lnTo>
                  <a:pt x="47" y="241"/>
                </a:lnTo>
                <a:lnTo>
                  <a:pt x="100" y="195"/>
                </a:lnTo>
                <a:lnTo>
                  <a:pt x="154" y="160"/>
                </a:lnTo>
                <a:lnTo>
                  <a:pt x="222" y="135"/>
                </a:lnTo>
                <a:lnTo>
                  <a:pt x="286" y="111"/>
                </a:lnTo>
                <a:lnTo>
                  <a:pt x="347" y="98"/>
                </a:lnTo>
                <a:lnTo>
                  <a:pt x="410" y="86"/>
                </a:lnTo>
                <a:lnTo>
                  <a:pt x="473" y="73"/>
                </a:lnTo>
                <a:lnTo>
                  <a:pt x="536" y="60"/>
                </a:lnTo>
                <a:lnTo>
                  <a:pt x="599" y="48"/>
                </a:lnTo>
                <a:lnTo>
                  <a:pt x="663" y="35"/>
                </a:lnTo>
              </a:path>
            </a:pathLst>
          </a:custGeom>
          <a:noFill/>
          <a:ln w="21370" cap="sq">
            <a:solidFill>
              <a:srgbClr val="000000"/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44" name="path 44"/>
          <p:cNvSpPr/>
          <p:nvPr/>
        </p:nvSpPr>
        <p:spPr>
          <a:xfrm>
            <a:off x="758667" y="7447762"/>
            <a:ext cx="121101" cy="1075669"/>
          </a:xfrm>
          <a:custGeom>
            <a:avLst/>
            <a:gdLst/>
            <a:ahLst/>
            <a:cxnLst/>
            <a:rect l="0" t="0" r="0" b="0"/>
            <a:pathLst>
              <a:path w="190" h="1693">
                <a:moveTo>
                  <a:pt x="185" y="1688"/>
                </a:moveTo>
                <a:lnTo>
                  <a:pt x="95" y="1688"/>
                </a:lnTo>
                <a:moveTo>
                  <a:pt x="185" y="1609"/>
                </a:moveTo>
                <a:lnTo>
                  <a:pt x="95" y="1609"/>
                </a:lnTo>
                <a:moveTo>
                  <a:pt x="185" y="1542"/>
                </a:moveTo>
                <a:lnTo>
                  <a:pt x="5" y="1542"/>
                </a:lnTo>
                <a:moveTo>
                  <a:pt x="185" y="1463"/>
                </a:moveTo>
                <a:lnTo>
                  <a:pt x="95" y="1463"/>
                </a:lnTo>
                <a:moveTo>
                  <a:pt x="185" y="1396"/>
                </a:moveTo>
                <a:lnTo>
                  <a:pt x="95" y="1396"/>
                </a:lnTo>
                <a:moveTo>
                  <a:pt x="185" y="1318"/>
                </a:moveTo>
                <a:lnTo>
                  <a:pt x="95" y="1318"/>
                </a:lnTo>
                <a:moveTo>
                  <a:pt x="185" y="1250"/>
                </a:moveTo>
                <a:lnTo>
                  <a:pt x="5" y="1250"/>
                </a:lnTo>
                <a:moveTo>
                  <a:pt x="185" y="1172"/>
                </a:moveTo>
                <a:lnTo>
                  <a:pt x="95" y="1172"/>
                </a:lnTo>
                <a:moveTo>
                  <a:pt x="185" y="1105"/>
                </a:moveTo>
                <a:lnTo>
                  <a:pt x="95" y="1105"/>
                </a:lnTo>
                <a:moveTo>
                  <a:pt x="185" y="1026"/>
                </a:moveTo>
                <a:lnTo>
                  <a:pt x="95" y="1026"/>
                </a:lnTo>
                <a:moveTo>
                  <a:pt x="185" y="959"/>
                </a:moveTo>
                <a:lnTo>
                  <a:pt x="5" y="959"/>
                </a:lnTo>
                <a:moveTo>
                  <a:pt x="185" y="880"/>
                </a:moveTo>
                <a:lnTo>
                  <a:pt x="95" y="880"/>
                </a:lnTo>
                <a:moveTo>
                  <a:pt x="185" y="813"/>
                </a:moveTo>
                <a:lnTo>
                  <a:pt x="95" y="813"/>
                </a:lnTo>
                <a:moveTo>
                  <a:pt x="185" y="734"/>
                </a:moveTo>
                <a:lnTo>
                  <a:pt x="95" y="734"/>
                </a:lnTo>
                <a:moveTo>
                  <a:pt x="185" y="656"/>
                </a:moveTo>
                <a:lnTo>
                  <a:pt x="5" y="656"/>
                </a:lnTo>
                <a:moveTo>
                  <a:pt x="185" y="588"/>
                </a:moveTo>
                <a:lnTo>
                  <a:pt x="95" y="588"/>
                </a:lnTo>
                <a:moveTo>
                  <a:pt x="185" y="510"/>
                </a:moveTo>
                <a:lnTo>
                  <a:pt x="95" y="510"/>
                </a:lnTo>
                <a:moveTo>
                  <a:pt x="185" y="443"/>
                </a:moveTo>
                <a:lnTo>
                  <a:pt x="95" y="443"/>
                </a:lnTo>
                <a:moveTo>
                  <a:pt x="185" y="364"/>
                </a:moveTo>
                <a:lnTo>
                  <a:pt x="5" y="364"/>
                </a:lnTo>
                <a:moveTo>
                  <a:pt x="185" y="297"/>
                </a:moveTo>
                <a:lnTo>
                  <a:pt x="95" y="297"/>
                </a:lnTo>
                <a:moveTo>
                  <a:pt x="185" y="218"/>
                </a:moveTo>
                <a:lnTo>
                  <a:pt x="95" y="218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72"/>
                </a:moveTo>
                <a:lnTo>
                  <a:pt x="5" y="72"/>
                </a:lnTo>
                <a:moveTo>
                  <a:pt x="185" y="5"/>
                </a:moveTo>
                <a:lnTo>
                  <a:pt x="9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46" name="textbox 46"/>
          <p:cNvSpPr/>
          <p:nvPr/>
        </p:nvSpPr>
        <p:spPr>
          <a:xfrm>
            <a:off x="468099" y="9566299"/>
            <a:ext cx="949325" cy="16128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ts val="1065"/>
              </a:lnSpc>
            </a:pPr>
            <a:r>
              <a:rPr sz="800" kern="0" spc="-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Fit</a:t>
            </a:r>
            <a:r>
              <a:rPr sz="8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800" kern="0" spc="-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LTV4.1.</a:t>
            </a:r>
            <a:r>
              <a:rPr sz="8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7(Win)</a:t>
            </a:r>
            <a:endParaRPr sz="8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48" name="textbox 48"/>
          <p:cNvSpPr/>
          <p:nvPr/>
        </p:nvSpPr>
        <p:spPr>
          <a:xfrm>
            <a:off x="3805569" y="454610"/>
            <a:ext cx="495300" cy="28638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4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33350" algn="l" rtl="0" eaLnBrk="0">
              <a:lnSpc>
                <a:spcPct val="122000"/>
              </a:lnSpc>
              <a:tabLst>
                <a:tab pos="198120" algn="l"/>
              </a:tabLst>
            </a:pP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	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G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	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G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pic>
        <p:nvPicPr>
          <p:cNvPr id="50" name="picture 5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rot="21600000">
            <a:off x="3818269" y="598385"/>
            <a:ext cx="121101" cy="99731"/>
          </a:xfrm>
          <a:prstGeom prst="rect">
            <a:avLst/>
          </a:prstGeom>
        </p:spPr>
      </p:pic>
      <p:pic>
        <p:nvPicPr>
          <p:cNvPr id="52" name="picture 5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rot="21600000">
            <a:off x="3818269" y="477284"/>
            <a:ext cx="121101" cy="99730"/>
          </a:xfrm>
          <a:prstGeom prst="rect">
            <a:avLst/>
          </a:prstGeom>
        </p:spPr>
      </p:pic>
      <p:sp>
        <p:nvSpPr>
          <p:cNvPr id="54" name="textbox 54"/>
          <p:cNvSpPr/>
          <p:nvPr/>
        </p:nvSpPr>
        <p:spPr>
          <a:xfrm rot="16200000">
            <a:off x="2389390" y="7948715"/>
            <a:ext cx="1245869" cy="14160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07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0000"/>
              </a:lnSpc>
              <a:spcBef>
                <a:spcPts val="0"/>
              </a:spcBef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   40   6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</a:t>
            </a:r>
            <a:r>
              <a:rPr sz="700" kern="0" spc="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700" kern="0" spc="1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20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56" name="textbox 56"/>
          <p:cNvSpPr/>
          <p:nvPr/>
        </p:nvSpPr>
        <p:spPr>
          <a:xfrm rot="16200000">
            <a:off x="52837" y="7948715"/>
            <a:ext cx="1245869" cy="14160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07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0000"/>
              </a:lnSpc>
              <a:spcBef>
                <a:spcPts val="0"/>
              </a:spcBef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   40   6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</a:t>
            </a:r>
            <a:r>
              <a:rPr sz="700" kern="0" spc="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700" kern="0" spc="1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20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58" name="textbox 58"/>
          <p:cNvSpPr/>
          <p:nvPr/>
        </p:nvSpPr>
        <p:spPr>
          <a:xfrm rot="16200000">
            <a:off x="4725942" y="7948715"/>
            <a:ext cx="1245869" cy="14160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07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0000"/>
              </a:lnSpc>
              <a:spcBef>
                <a:spcPts val="0"/>
              </a:spcBef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   40   6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</a:t>
            </a:r>
            <a:r>
              <a:rPr sz="700" kern="0" spc="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700" kern="0" spc="1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20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60" name="path 60"/>
          <p:cNvSpPr/>
          <p:nvPr/>
        </p:nvSpPr>
        <p:spPr>
          <a:xfrm>
            <a:off x="1898449" y="8608915"/>
            <a:ext cx="156720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2" name="path 62"/>
          <p:cNvSpPr/>
          <p:nvPr/>
        </p:nvSpPr>
        <p:spPr>
          <a:xfrm>
            <a:off x="1114849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4" name="path 64"/>
          <p:cNvSpPr/>
          <p:nvPr/>
        </p:nvSpPr>
        <p:spPr>
          <a:xfrm>
            <a:off x="1706111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51" y="5"/>
                </a:moveTo>
                <a:lnTo>
                  <a:pt x="151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6" name="path 66"/>
          <p:cNvSpPr/>
          <p:nvPr/>
        </p:nvSpPr>
        <p:spPr>
          <a:xfrm>
            <a:off x="1506649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8" name="path 68"/>
          <p:cNvSpPr/>
          <p:nvPr/>
        </p:nvSpPr>
        <p:spPr>
          <a:xfrm>
            <a:off x="922511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0" name="path 70"/>
          <p:cNvSpPr/>
          <p:nvPr/>
        </p:nvSpPr>
        <p:spPr>
          <a:xfrm>
            <a:off x="1314311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2" name="path 72"/>
          <p:cNvSpPr/>
          <p:nvPr/>
        </p:nvSpPr>
        <p:spPr>
          <a:xfrm>
            <a:off x="872645" y="8608915"/>
            <a:ext cx="1239512" cy="64112"/>
          </a:xfrm>
          <a:custGeom>
            <a:avLst/>
            <a:gdLst/>
            <a:ahLst/>
            <a:cxnLst/>
            <a:rect l="0" t="0" r="0" b="0"/>
            <a:pathLst>
              <a:path w="1951" h="100">
                <a:moveTo>
                  <a:pt x="1935" y="5"/>
                </a:moveTo>
                <a:lnTo>
                  <a:pt x="1935" y="95"/>
                </a:lnTo>
                <a:moveTo>
                  <a:pt x="5" y="5"/>
                </a:moveTo>
                <a:lnTo>
                  <a:pt x="1946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4" name="textbox 74"/>
          <p:cNvSpPr/>
          <p:nvPr/>
        </p:nvSpPr>
        <p:spPr>
          <a:xfrm rot="16200000">
            <a:off x="310755" y="2249794"/>
            <a:ext cx="421640" cy="18668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ts val="1270"/>
              </a:lnSpc>
            </a:pPr>
            <a:r>
              <a:rPr sz="900" kern="0" spc="-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Number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76" name="textbox 76"/>
          <p:cNvSpPr/>
          <p:nvPr/>
        </p:nvSpPr>
        <p:spPr>
          <a:xfrm>
            <a:off x="3805569" y="696814"/>
            <a:ext cx="434975" cy="16128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33350" algn="l" rtl="0" eaLnBrk="0">
              <a:lnSpc>
                <a:spcPts val="1065"/>
              </a:lnSpc>
              <a:tabLst>
                <a:tab pos="198120" algn="l"/>
              </a:tabLst>
            </a:pPr>
            <a:r>
              <a:rPr sz="8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	</a:t>
            </a:r>
            <a:r>
              <a:rPr sz="8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S</a:t>
            </a:r>
            <a:endParaRPr sz="8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pic>
        <p:nvPicPr>
          <p:cNvPr id="78" name="picture 7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rot="21600000">
            <a:off x="3818269" y="719487"/>
            <a:ext cx="121101" cy="99731"/>
          </a:xfrm>
          <a:prstGeom prst="rect">
            <a:avLst/>
          </a:prstGeom>
        </p:spPr>
      </p:pic>
      <p:sp>
        <p:nvSpPr>
          <p:cNvPr id="80" name="path 80"/>
          <p:cNvSpPr/>
          <p:nvPr/>
        </p:nvSpPr>
        <p:spPr>
          <a:xfrm>
            <a:off x="787161" y="3009736"/>
            <a:ext cx="135349" cy="363305"/>
          </a:xfrm>
          <a:custGeom>
            <a:avLst/>
            <a:gdLst/>
            <a:ahLst/>
            <a:cxnLst/>
            <a:rect l="0" t="0" r="0" b="0"/>
            <a:pathLst>
              <a:path w="213" h="572">
                <a:moveTo>
                  <a:pt x="207" y="566"/>
                </a:moveTo>
                <a:lnTo>
                  <a:pt x="106" y="566"/>
                </a:lnTo>
                <a:moveTo>
                  <a:pt x="207" y="431"/>
                </a:moveTo>
                <a:lnTo>
                  <a:pt x="106" y="431"/>
                </a:lnTo>
                <a:moveTo>
                  <a:pt x="207" y="286"/>
                </a:moveTo>
                <a:lnTo>
                  <a:pt x="106" y="286"/>
                </a:lnTo>
                <a:moveTo>
                  <a:pt x="207" y="151"/>
                </a:moveTo>
                <a:lnTo>
                  <a:pt x="106" y="151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82" name="path 82"/>
          <p:cNvSpPr/>
          <p:nvPr/>
        </p:nvSpPr>
        <p:spPr>
          <a:xfrm>
            <a:off x="787161" y="2568071"/>
            <a:ext cx="135349" cy="363305"/>
          </a:xfrm>
          <a:custGeom>
            <a:avLst/>
            <a:gdLst/>
            <a:ahLst/>
            <a:cxnLst/>
            <a:rect l="0" t="0" r="0" b="0"/>
            <a:pathLst>
              <a:path w="213" h="572">
                <a:moveTo>
                  <a:pt x="207" y="566"/>
                </a:moveTo>
                <a:lnTo>
                  <a:pt x="106" y="566"/>
                </a:lnTo>
                <a:moveTo>
                  <a:pt x="207" y="420"/>
                </a:moveTo>
                <a:lnTo>
                  <a:pt x="106" y="420"/>
                </a:lnTo>
                <a:moveTo>
                  <a:pt x="207" y="286"/>
                </a:moveTo>
                <a:lnTo>
                  <a:pt x="106" y="286"/>
                </a:lnTo>
                <a:moveTo>
                  <a:pt x="207" y="140"/>
                </a:moveTo>
                <a:lnTo>
                  <a:pt x="106" y="140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84" name="path 84"/>
          <p:cNvSpPr/>
          <p:nvPr/>
        </p:nvSpPr>
        <p:spPr>
          <a:xfrm>
            <a:off x="787161" y="1677616"/>
            <a:ext cx="135349" cy="363305"/>
          </a:xfrm>
          <a:custGeom>
            <a:avLst/>
            <a:gdLst/>
            <a:ahLst/>
            <a:cxnLst/>
            <a:rect l="0" t="0" r="0" b="0"/>
            <a:pathLst>
              <a:path w="213" h="572">
                <a:moveTo>
                  <a:pt x="207" y="566"/>
                </a:moveTo>
                <a:lnTo>
                  <a:pt x="106" y="566"/>
                </a:lnTo>
                <a:moveTo>
                  <a:pt x="207" y="420"/>
                </a:moveTo>
                <a:lnTo>
                  <a:pt x="106" y="420"/>
                </a:lnTo>
                <a:moveTo>
                  <a:pt x="207" y="286"/>
                </a:moveTo>
                <a:lnTo>
                  <a:pt x="106" y="286"/>
                </a:lnTo>
                <a:moveTo>
                  <a:pt x="207" y="140"/>
                </a:moveTo>
                <a:lnTo>
                  <a:pt x="106" y="140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86" name="path 86"/>
          <p:cNvSpPr/>
          <p:nvPr/>
        </p:nvSpPr>
        <p:spPr>
          <a:xfrm>
            <a:off x="787161" y="1228827"/>
            <a:ext cx="135349" cy="363305"/>
          </a:xfrm>
          <a:custGeom>
            <a:avLst/>
            <a:gdLst/>
            <a:ahLst/>
            <a:cxnLst/>
            <a:rect l="0" t="0" r="0" b="0"/>
            <a:pathLst>
              <a:path w="213" h="572">
                <a:moveTo>
                  <a:pt x="207" y="566"/>
                </a:moveTo>
                <a:lnTo>
                  <a:pt x="106" y="566"/>
                </a:lnTo>
                <a:moveTo>
                  <a:pt x="207" y="431"/>
                </a:moveTo>
                <a:lnTo>
                  <a:pt x="106" y="431"/>
                </a:lnTo>
                <a:moveTo>
                  <a:pt x="207" y="286"/>
                </a:moveTo>
                <a:lnTo>
                  <a:pt x="106" y="286"/>
                </a:lnTo>
                <a:moveTo>
                  <a:pt x="207" y="151"/>
                </a:moveTo>
                <a:lnTo>
                  <a:pt x="106" y="151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88" name="path 88"/>
          <p:cNvSpPr/>
          <p:nvPr/>
        </p:nvSpPr>
        <p:spPr>
          <a:xfrm>
            <a:off x="787161" y="787162"/>
            <a:ext cx="135349" cy="363305"/>
          </a:xfrm>
          <a:custGeom>
            <a:avLst/>
            <a:gdLst/>
            <a:ahLst/>
            <a:cxnLst/>
            <a:rect l="0" t="0" r="0" b="0"/>
            <a:pathLst>
              <a:path w="213" h="572">
                <a:moveTo>
                  <a:pt x="207" y="566"/>
                </a:moveTo>
                <a:lnTo>
                  <a:pt x="106" y="566"/>
                </a:lnTo>
                <a:moveTo>
                  <a:pt x="207" y="420"/>
                </a:moveTo>
                <a:lnTo>
                  <a:pt x="106" y="420"/>
                </a:lnTo>
                <a:moveTo>
                  <a:pt x="207" y="286"/>
                </a:moveTo>
                <a:lnTo>
                  <a:pt x="106" y="286"/>
                </a:lnTo>
                <a:moveTo>
                  <a:pt x="207" y="140"/>
                </a:moveTo>
                <a:lnTo>
                  <a:pt x="106" y="140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0" name="path 90"/>
          <p:cNvSpPr/>
          <p:nvPr/>
        </p:nvSpPr>
        <p:spPr>
          <a:xfrm>
            <a:off x="787161" y="2119282"/>
            <a:ext cx="135349" cy="363304"/>
          </a:xfrm>
          <a:custGeom>
            <a:avLst/>
            <a:gdLst/>
            <a:ahLst/>
            <a:cxnLst/>
            <a:rect l="0" t="0" r="0" b="0"/>
            <a:pathLst>
              <a:path w="213" h="572">
                <a:moveTo>
                  <a:pt x="207" y="566"/>
                </a:moveTo>
                <a:lnTo>
                  <a:pt x="106" y="566"/>
                </a:lnTo>
                <a:moveTo>
                  <a:pt x="207" y="431"/>
                </a:moveTo>
                <a:lnTo>
                  <a:pt x="106" y="431"/>
                </a:lnTo>
                <a:moveTo>
                  <a:pt x="207" y="286"/>
                </a:moveTo>
                <a:lnTo>
                  <a:pt x="106" y="286"/>
                </a:lnTo>
                <a:moveTo>
                  <a:pt x="207" y="151"/>
                </a:moveTo>
                <a:lnTo>
                  <a:pt x="106" y="151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2" name="textbox 92"/>
          <p:cNvSpPr/>
          <p:nvPr/>
        </p:nvSpPr>
        <p:spPr>
          <a:xfrm rot="16200000">
            <a:off x="5064821" y="7915550"/>
            <a:ext cx="259715" cy="18668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ts val="1270"/>
              </a:lnSpc>
            </a:pP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</a:t>
            </a:r>
            <a:r>
              <a:rPr sz="900" kern="0" spc="-1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I-H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94" name="path 94"/>
          <p:cNvSpPr/>
          <p:nvPr/>
        </p:nvSpPr>
        <p:spPr>
          <a:xfrm>
            <a:off x="787161" y="3458526"/>
            <a:ext cx="135349" cy="270698"/>
          </a:xfrm>
          <a:custGeom>
            <a:avLst/>
            <a:gdLst/>
            <a:ahLst/>
            <a:cxnLst/>
            <a:rect l="0" t="0" r="0" b="0"/>
            <a:pathLst>
              <a:path w="213" h="426">
                <a:moveTo>
                  <a:pt x="207" y="420"/>
                </a:moveTo>
                <a:lnTo>
                  <a:pt x="106" y="420"/>
                </a:lnTo>
                <a:moveTo>
                  <a:pt x="207" y="286"/>
                </a:moveTo>
                <a:lnTo>
                  <a:pt x="106" y="286"/>
                </a:lnTo>
                <a:moveTo>
                  <a:pt x="207" y="140"/>
                </a:moveTo>
                <a:lnTo>
                  <a:pt x="106" y="140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6" name="textbox 96"/>
          <p:cNvSpPr/>
          <p:nvPr/>
        </p:nvSpPr>
        <p:spPr>
          <a:xfrm rot="16200000">
            <a:off x="315261" y="7933009"/>
            <a:ext cx="407034" cy="174625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34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SC-W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98" name="textbox 98"/>
          <p:cNvSpPr/>
          <p:nvPr/>
        </p:nvSpPr>
        <p:spPr>
          <a:xfrm rot="16200000">
            <a:off x="2662193" y="7926484"/>
            <a:ext cx="386079" cy="174625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34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5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SSC-A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100" name="path 100"/>
          <p:cNvSpPr/>
          <p:nvPr/>
        </p:nvSpPr>
        <p:spPr>
          <a:xfrm>
            <a:off x="915387" y="787162"/>
            <a:ext cx="7123" cy="3120152"/>
          </a:xfrm>
          <a:custGeom>
            <a:avLst/>
            <a:gdLst/>
            <a:ahLst/>
            <a:cxnLst/>
            <a:rect l="0" t="0" r="0" b="0"/>
            <a:pathLst>
              <a:path w="11" h="4913">
                <a:moveTo>
                  <a:pt x="5" y="4908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02" name="rect 102"/>
          <p:cNvSpPr/>
          <p:nvPr/>
        </p:nvSpPr>
        <p:spPr>
          <a:xfrm>
            <a:off x="3381900" y="7613574"/>
            <a:ext cx="142473" cy="135349"/>
          </a:xfrm>
          <a:prstGeom prst="rect">
            <a:avLst/>
          </a:prstGeom>
          <a:solidFill>
            <a:srgbClr val="FFFFFF">
              <a:alpha val="49803"/>
            </a:srgbClr>
          </a:solidFill>
          <a:ln w="0" cap="flat">
            <a:noFill/>
            <a:prstDash val="solid"/>
            <a:miter lim="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04" name="rect 104"/>
          <p:cNvSpPr/>
          <p:nvPr/>
        </p:nvSpPr>
        <p:spPr>
          <a:xfrm>
            <a:off x="1098199" y="7602667"/>
            <a:ext cx="142472" cy="135349"/>
          </a:xfrm>
          <a:prstGeom prst="rect">
            <a:avLst/>
          </a:prstGeom>
          <a:solidFill>
            <a:srgbClr val="FFFFFF">
              <a:alpha val="49803"/>
            </a:srgbClr>
          </a:solidFill>
          <a:ln w="0" cap="flat">
            <a:noFill/>
            <a:prstDash val="solid"/>
            <a:miter lim="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06" name="rect 106"/>
          <p:cNvSpPr/>
          <p:nvPr/>
        </p:nvSpPr>
        <p:spPr>
          <a:xfrm>
            <a:off x="5716958" y="7534850"/>
            <a:ext cx="142472" cy="135349"/>
          </a:xfrm>
          <a:prstGeom prst="rect">
            <a:avLst/>
          </a:prstGeom>
          <a:solidFill>
            <a:srgbClr val="FFFFFF">
              <a:alpha val="49803"/>
            </a:srgbClr>
          </a:solidFill>
          <a:ln w="0" cap="flat">
            <a:noFill/>
            <a:prstDash val="solid"/>
            <a:miter lim="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08" name="textbox 108"/>
          <p:cNvSpPr/>
          <p:nvPr/>
        </p:nvSpPr>
        <p:spPr>
          <a:xfrm>
            <a:off x="5713715" y="7540575"/>
            <a:ext cx="161289" cy="144145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2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r" rtl="0" eaLnBrk="0">
              <a:lnSpc>
                <a:spcPct val="78000"/>
              </a:lnSpc>
            </a:pPr>
            <a:r>
              <a:rPr sz="1000" kern="0" spc="-9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</a:t>
            </a:r>
            <a:r>
              <a:rPr sz="1000" kern="0" spc="-5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3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110" name="textbox 110"/>
          <p:cNvSpPr/>
          <p:nvPr/>
        </p:nvSpPr>
        <p:spPr>
          <a:xfrm>
            <a:off x="1094927" y="7608361"/>
            <a:ext cx="161289" cy="14477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r" rtl="0" eaLnBrk="0">
              <a:lnSpc>
                <a:spcPct val="78000"/>
              </a:lnSpc>
            </a:pPr>
            <a:r>
              <a:rPr sz="1000" kern="0" spc="-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1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112" name="textbox 112"/>
          <p:cNvSpPr/>
          <p:nvPr/>
        </p:nvSpPr>
        <p:spPr>
          <a:xfrm>
            <a:off x="3378609" y="7619269"/>
            <a:ext cx="161289" cy="14477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r" rtl="0" eaLnBrk="0">
              <a:lnSpc>
                <a:spcPct val="78000"/>
              </a:lnSpc>
            </a:pPr>
            <a:r>
              <a:rPr sz="1000" kern="0" spc="-8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</a:t>
            </a: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114" name="path 114"/>
          <p:cNvSpPr/>
          <p:nvPr/>
        </p:nvSpPr>
        <p:spPr>
          <a:xfrm>
            <a:off x="815656" y="8559049"/>
            <a:ext cx="64112" cy="7123"/>
          </a:xfrm>
          <a:custGeom>
            <a:avLst/>
            <a:gdLst/>
            <a:ahLst/>
            <a:cxnLst/>
            <a:rect l="0" t="0" r="0" b="0"/>
            <a:pathLst>
              <a:path w="100" h="11">
                <a:moveTo>
                  <a:pt x="9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16" name="path 116"/>
          <p:cNvSpPr/>
          <p:nvPr/>
        </p:nvSpPr>
        <p:spPr>
          <a:xfrm>
            <a:off x="758667" y="8608915"/>
            <a:ext cx="121101" cy="7123"/>
          </a:xfrm>
          <a:custGeom>
            <a:avLst/>
            <a:gdLst/>
            <a:ahLst/>
            <a:cxnLst/>
            <a:rect l="0" t="0" r="0" b="0"/>
            <a:pathLst>
              <a:path w="190" h="11"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18" name="path 118"/>
          <p:cNvSpPr/>
          <p:nvPr/>
        </p:nvSpPr>
        <p:spPr>
          <a:xfrm>
            <a:off x="872645" y="7426391"/>
            <a:ext cx="7123" cy="1189647"/>
          </a:xfrm>
          <a:custGeom>
            <a:avLst/>
            <a:gdLst/>
            <a:ahLst/>
            <a:cxnLst/>
            <a:rect l="0" t="0" r="0" b="0"/>
            <a:pathLst>
              <a:path w="11" h="1873">
                <a:moveTo>
                  <a:pt x="5" y="1867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 rot="21600000">
            <a:off x="787161" y="3642869"/>
            <a:ext cx="3758357" cy="392671"/>
          </a:xfrm>
          <a:prstGeom prst="rect">
            <a:avLst/>
          </a:prstGeom>
        </p:spPr>
      </p:pic>
      <p:sp>
        <p:nvSpPr>
          <p:cNvPr id="4" name="path 4"/>
          <p:cNvSpPr/>
          <p:nvPr/>
        </p:nvSpPr>
        <p:spPr>
          <a:xfrm>
            <a:off x="2062255" y="1088779"/>
            <a:ext cx="334312" cy="2602692"/>
          </a:xfrm>
          <a:custGeom>
            <a:avLst/>
            <a:gdLst/>
            <a:ahLst/>
            <a:cxnLst/>
            <a:rect l="0" t="0" r="0" b="0"/>
            <a:pathLst>
              <a:path w="526" h="4098">
                <a:moveTo>
                  <a:pt x="7" y="4091"/>
                </a:moveTo>
                <a:lnTo>
                  <a:pt x="35" y="4018"/>
                </a:lnTo>
                <a:lnTo>
                  <a:pt x="64" y="3791"/>
                </a:lnTo>
                <a:lnTo>
                  <a:pt x="92" y="3577"/>
                </a:lnTo>
                <a:lnTo>
                  <a:pt x="121" y="3269"/>
                </a:lnTo>
                <a:lnTo>
                  <a:pt x="149" y="2992"/>
                </a:lnTo>
                <a:lnTo>
                  <a:pt x="177" y="2606"/>
                </a:lnTo>
                <a:lnTo>
                  <a:pt x="206" y="2247"/>
                </a:lnTo>
                <a:lnTo>
                  <a:pt x="234" y="1753"/>
                </a:lnTo>
                <a:lnTo>
                  <a:pt x="263" y="858"/>
                </a:lnTo>
                <a:lnTo>
                  <a:pt x="291" y="173"/>
                </a:lnTo>
                <a:lnTo>
                  <a:pt x="320" y="7"/>
                </a:lnTo>
                <a:lnTo>
                  <a:pt x="348" y="132"/>
                </a:lnTo>
                <a:lnTo>
                  <a:pt x="376" y="1158"/>
                </a:lnTo>
                <a:lnTo>
                  <a:pt x="405" y="1942"/>
                </a:lnTo>
                <a:lnTo>
                  <a:pt x="433" y="2839"/>
                </a:lnTo>
                <a:lnTo>
                  <a:pt x="462" y="3421"/>
                </a:lnTo>
                <a:lnTo>
                  <a:pt x="490" y="3827"/>
                </a:lnTo>
                <a:lnTo>
                  <a:pt x="519" y="4029"/>
                </a:lnTo>
              </a:path>
            </a:pathLst>
          </a:custGeom>
          <a:noFill/>
          <a:ln w="9260" cap="rnd">
            <a:solidFill>
              <a:srgbClr val="000000"/>
            </a:solidFill>
            <a:prstDash val="solid"/>
            <a:round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pic>
        <p:nvPicPr>
          <p:cNvPr id="6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1600000">
            <a:off x="929204" y="1388647"/>
            <a:ext cx="3611684" cy="2512500"/>
          </a:xfrm>
          <a:prstGeom prst="rect">
            <a:avLst/>
          </a:prstGeom>
        </p:spPr>
      </p:pic>
      <p:sp>
        <p:nvSpPr>
          <p:cNvPr id="8" name="textbox 8"/>
          <p:cNvSpPr/>
          <p:nvPr/>
        </p:nvSpPr>
        <p:spPr>
          <a:xfrm>
            <a:off x="5148708" y="463314"/>
            <a:ext cx="2123439" cy="330962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76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ct val="10200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ile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nalyzed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: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231222</a:t>
            </a:r>
            <a:r>
              <a:rPr sz="900" u="sng" kern="0" spc="10" dirty="0">
                <a:solidFill>
                  <a:srgbClr val="0000FF">
                    <a:alpha val="100000"/>
                  </a:srgbClr>
                </a:solidFill>
                <a:uFill>
                  <a:solidFill>
                    <a:srgbClr val="000000"/>
                  </a:solidFill>
                </a:u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900" u="sng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6</a:t>
            </a:r>
            <a:r>
              <a:rPr sz="900" u="sng" kern="0" spc="10" dirty="0">
                <a:solidFill>
                  <a:srgbClr val="0000FF">
                    <a:alpha val="100000"/>
                  </a:srgbClr>
                </a:solidFill>
                <a:uFill>
                  <a:solidFill>
                    <a:srgbClr val="000000"/>
                  </a:solidFill>
                </a:u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06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.fcs        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ate analyzed:</a:t>
            </a:r>
            <a:r>
              <a:rPr sz="10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7-Dec-20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3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el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nn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n_DSD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ts val="1230"/>
              </a:lnSpc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nalysis type:</a:t>
            </a:r>
            <a:r>
              <a:rPr sz="1000" kern="0" spc="8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anual analy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sis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87000"/>
              </a:lnSpc>
              <a:spcBef>
                <a:spcPts val="75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uto</a:t>
            </a:r>
            <a:r>
              <a:rPr sz="10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Linearity:</a:t>
            </a:r>
            <a:r>
              <a:rPr sz="10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N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o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ts val="1270"/>
              </a:lnSpc>
              <a:spcBef>
                <a:spcPts val="945"/>
              </a:spcBef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loidy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e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:</a:t>
            </a:r>
            <a:r>
              <a:rPr sz="900" kern="0" spc="12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irst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cycle</a:t>
            </a:r>
            <a:r>
              <a:rPr sz="900" kern="0" spc="8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is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loid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ts val="1195"/>
              </a:lnSpc>
              <a:spcBef>
                <a:spcPts val="975"/>
              </a:spcBef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loid:</a:t>
            </a:r>
            <a:r>
              <a:rPr sz="900" kern="0" spc="1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.00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827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G1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76.78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t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73.06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827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G2:</a:t>
            </a:r>
            <a:r>
              <a:rPr sz="9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9.46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t</a:t>
            </a:r>
            <a:r>
              <a:rPr sz="9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42.48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8270" algn="l" rtl="0" eaLnBrk="0">
              <a:lnSpc>
                <a:spcPts val="123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S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3.76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r>
              <a:rPr sz="9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G2/G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:</a:t>
            </a:r>
            <a:r>
              <a:rPr sz="900" kern="0" spc="18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.95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6365" algn="l" rtl="0" eaLnBrk="0">
              <a:lnSpc>
                <a:spcPts val="1230"/>
              </a:lnSpc>
              <a:spcBef>
                <a:spcPts val="70"/>
              </a:spcBef>
            </a:pPr>
            <a:r>
              <a:rPr sz="1000" kern="0" spc="-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CV:</a:t>
            </a:r>
            <a:r>
              <a:rPr sz="1000" kern="0" spc="12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5.04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5240" algn="l" rtl="0" eaLnBrk="0">
              <a:lnSpc>
                <a:spcPts val="1195"/>
              </a:lnSpc>
              <a:spcBef>
                <a:spcPts val="760"/>
              </a:spcBef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Total S-Phase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3.76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5240" algn="l" rtl="0" eaLnBrk="0">
              <a:lnSpc>
                <a:spcPts val="1195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Total B.A.D.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.00 %    no debris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no aggs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ct val="100000"/>
              </a:lnSpc>
              <a:spcBef>
                <a:spcPts val="970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ebris:</a:t>
            </a:r>
            <a:r>
              <a:rPr sz="10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3000"/>
              </a:lnSpc>
              <a:spcBef>
                <a:spcPts val="5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ggregates:</a:t>
            </a:r>
            <a:r>
              <a:rPr sz="10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eled event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s: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8812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3000"/>
              </a:lnSpc>
              <a:spcBef>
                <a:spcPts val="5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ll cycle events:</a:t>
            </a:r>
            <a:r>
              <a:rPr sz="10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8812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8415" algn="l" rtl="0" eaLnBrk="0">
              <a:lnSpc>
                <a:spcPts val="1225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Cycle</a:t>
            </a:r>
            <a:r>
              <a:rPr sz="900" kern="0" spc="2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events</a:t>
            </a:r>
            <a:r>
              <a:rPr sz="900" kern="0" spc="1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er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channel</a:t>
            </a:r>
            <a:r>
              <a:rPr sz="900" kern="0" spc="2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: 409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ct val="92000"/>
              </a:lnSpc>
              <a:spcBef>
                <a:spcPts val="5"/>
              </a:spcBef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CS:</a:t>
            </a:r>
            <a:r>
              <a:rPr sz="900" kern="0" spc="10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6.412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pic>
        <p:nvPicPr>
          <p:cNvPr id="10" name="picture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21600000">
            <a:off x="5545751" y="7436918"/>
            <a:ext cx="1223862" cy="1301232"/>
          </a:xfrm>
          <a:prstGeom prst="rect">
            <a:avLst/>
          </a:prstGeom>
        </p:spPr>
      </p:pic>
      <p:grpSp>
        <p:nvGrpSpPr>
          <p:cNvPr id="3" name="group 2"/>
          <p:cNvGrpSpPr/>
          <p:nvPr/>
        </p:nvGrpSpPr>
        <p:grpSpPr>
          <a:xfrm rot="21600000">
            <a:off x="5431773" y="7426391"/>
            <a:ext cx="1353491" cy="1303625"/>
            <a:chOff x="0" y="0"/>
            <a:chExt cx="1353491" cy="1303625"/>
          </a:xfrm>
        </p:grpSpPr>
        <p:sp>
          <p:nvSpPr>
            <p:cNvPr id="12" name="path 12"/>
            <p:cNvSpPr/>
            <p:nvPr/>
          </p:nvSpPr>
          <p:spPr>
            <a:xfrm>
              <a:off x="0" y="0"/>
              <a:ext cx="1353491" cy="1303625"/>
            </a:xfrm>
            <a:custGeom>
              <a:avLst/>
              <a:gdLst/>
              <a:ahLst/>
              <a:cxnLst/>
              <a:rect l="0" t="0" r="0" b="0"/>
              <a:pathLst>
                <a:path w="2131" h="2052">
                  <a:moveTo>
                    <a:pt x="263" y="1867"/>
                  </a:moveTo>
                  <a:lnTo>
                    <a:pt x="263" y="1957"/>
                  </a:lnTo>
                  <a:moveTo>
                    <a:pt x="342" y="1867"/>
                  </a:moveTo>
                  <a:lnTo>
                    <a:pt x="342" y="1957"/>
                  </a:lnTo>
                  <a:moveTo>
                    <a:pt x="420" y="1867"/>
                  </a:moveTo>
                  <a:lnTo>
                    <a:pt x="420" y="1957"/>
                  </a:lnTo>
                  <a:moveTo>
                    <a:pt x="487" y="1867"/>
                  </a:moveTo>
                  <a:lnTo>
                    <a:pt x="487" y="2047"/>
                  </a:lnTo>
                  <a:moveTo>
                    <a:pt x="566" y="1867"/>
                  </a:moveTo>
                  <a:lnTo>
                    <a:pt x="566" y="1957"/>
                  </a:lnTo>
                  <a:moveTo>
                    <a:pt x="645" y="1867"/>
                  </a:moveTo>
                  <a:lnTo>
                    <a:pt x="645" y="1957"/>
                  </a:lnTo>
                  <a:moveTo>
                    <a:pt x="723" y="1867"/>
                  </a:moveTo>
                  <a:lnTo>
                    <a:pt x="723" y="1957"/>
                  </a:lnTo>
                  <a:moveTo>
                    <a:pt x="802" y="1867"/>
                  </a:moveTo>
                  <a:lnTo>
                    <a:pt x="802" y="2047"/>
                  </a:lnTo>
                  <a:moveTo>
                    <a:pt x="880" y="1867"/>
                  </a:moveTo>
                  <a:lnTo>
                    <a:pt x="880" y="1957"/>
                  </a:lnTo>
                  <a:moveTo>
                    <a:pt x="959" y="1867"/>
                  </a:moveTo>
                  <a:lnTo>
                    <a:pt x="959" y="1957"/>
                  </a:lnTo>
                  <a:moveTo>
                    <a:pt x="1037" y="1867"/>
                  </a:moveTo>
                  <a:lnTo>
                    <a:pt x="1037" y="1957"/>
                  </a:lnTo>
                  <a:moveTo>
                    <a:pt x="1105" y="1867"/>
                  </a:moveTo>
                  <a:lnTo>
                    <a:pt x="1105" y="2047"/>
                  </a:lnTo>
                  <a:moveTo>
                    <a:pt x="1183" y="1867"/>
                  </a:moveTo>
                  <a:lnTo>
                    <a:pt x="1183" y="1957"/>
                  </a:lnTo>
                  <a:moveTo>
                    <a:pt x="1262" y="1867"/>
                  </a:moveTo>
                  <a:lnTo>
                    <a:pt x="1262" y="1957"/>
                  </a:lnTo>
                  <a:moveTo>
                    <a:pt x="1340" y="1867"/>
                  </a:moveTo>
                  <a:lnTo>
                    <a:pt x="1340" y="1957"/>
                  </a:lnTo>
                  <a:moveTo>
                    <a:pt x="1419" y="1867"/>
                  </a:moveTo>
                  <a:lnTo>
                    <a:pt x="1419" y="2047"/>
                  </a:lnTo>
                  <a:moveTo>
                    <a:pt x="1497" y="1867"/>
                  </a:moveTo>
                  <a:lnTo>
                    <a:pt x="1497" y="1957"/>
                  </a:lnTo>
                  <a:moveTo>
                    <a:pt x="1576" y="1867"/>
                  </a:moveTo>
                  <a:lnTo>
                    <a:pt x="1576" y="1957"/>
                  </a:lnTo>
                  <a:moveTo>
                    <a:pt x="1643" y="1867"/>
                  </a:moveTo>
                  <a:lnTo>
                    <a:pt x="1643" y="1957"/>
                  </a:lnTo>
                  <a:moveTo>
                    <a:pt x="1722" y="1867"/>
                  </a:moveTo>
                  <a:lnTo>
                    <a:pt x="1722" y="2047"/>
                  </a:lnTo>
                  <a:moveTo>
                    <a:pt x="1800" y="1867"/>
                  </a:moveTo>
                  <a:lnTo>
                    <a:pt x="1800" y="1957"/>
                  </a:lnTo>
                  <a:moveTo>
                    <a:pt x="1879" y="1867"/>
                  </a:moveTo>
                  <a:lnTo>
                    <a:pt x="1879" y="1957"/>
                  </a:lnTo>
                  <a:moveTo>
                    <a:pt x="1957" y="1867"/>
                  </a:moveTo>
                  <a:lnTo>
                    <a:pt x="1957" y="1957"/>
                  </a:lnTo>
                  <a:moveTo>
                    <a:pt x="2036" y="1867"/>
                  </a:moveTo>
                  <a:lnTo>
                    <a:pt x="2036" y="2047"/>
                  </a:lnTo>
                  <a:moveTo>
                    <a:pt x="2114" y="1867"/>
                  </a:moveTo>
                  <a:lnTo>
                    <a:pt x="2114" y="1957"/>
                  </a:lnTo>
                  <a:moveTo>
                    <a:pt x="185" y="1867"/>
                  </a:moveTo>
                  <a:lnTo>
                    <a:pt x="2125" y="1867"/>
                  </a:lnTo>
                  <a:moveTo>
                    <a:pt x="185" y="1867"/>
                  </a:moveTo>
                  <a:lnTo>
                    <a:pt x="5" y="1867"/>
                  </a:lnTo>
                  <a:moveTo>
                    <a:pt x="185" y="1789"/>
                  </a:moveTo>
                  <a:lnTo>
                    <a:pt x="95" y="1789"/>
                  </a:lnTo>
                  <a:moveTo>
                    <a:pt x="185" y="1722"/>
                  </a:moveTo>
                  <a:lnTo>
                    <a:pt x="95" y="1722"/>
                  </a:lnTo>
                  <a:moveTo>
                    <a:pt x="185" y="1643"/>
                  </a:moveTo>
                  <a:lnTo>
                    <a:pt x="95" y="1643"/>
                  </a:lnTo>
                  <a:moveTo>
                    <a:pt x="185" y="1576"/>
                  </a:moveTo>
                  <a:lnTo>
                    <a:pt x="5" y="1576"/>
                  </a:lnTo>
                  <a:moveTo>
                    <a:pt x="185" y="1497"/>
                  </a:moveTo>
                  <a:lnTo>
                    <a:pt x="95" y="1497"/>
                  </a:lnTo>
                  <a:moveTo>
                    <a:pt x="185" y="1430"/>
                  </a:moveTo>
                  <a:lnTo>
                    <a:pt x="95" y="1430"/>
                  </a:lnTo>
                  <a:moveTo>
                    <a:pt x="185" y="1351"/>
                  </a:moveTo>
                  <a:lnTo>
                    <a:pt x="95" y="1351"/>
                  </a:lnTo>
                  <a:moveTo>
                    <a:pt x="185" y="1284"/>
                  </a:moveTo>
                  <a:lnTo>
                    <a:pt x="5" y="1284"/>
                  </a:lnTo>
                  <a:moveTo>
                    <a:pt x="185" y="1205"/>
                  </a:moveTo>
                  <a:lnTo>
                    <a:pt x="95" y="1205"/>
                  </a:lnTo>
                  <a:moveTo>
                    <a:pt x="185" y="1138"/>
                  </a:moveTo>
                  <a:lnTo>
                    <a:pt x="95" y="1138"/>
                  </a:lnTo>
                  <a:moveTo>
                    <a:pt x="185" y="1060"/>
                  </a:moveTo>
                  <a:lnTo>
                    <a:pt x="95" y="1060"/>
                  </a:lnTo>
                  <a:moveTo>
                    <a:pt x="185" y="992"/>
                  </a:moveTo>
                  <a:lnTo>
                    <a:pt x="5" y="992"/>
                  </a:lnTo>
                  <a:moveTo>
                    <a:pt x="185" y="914"/>
                  </a:moveTo>
                  <a:lnTo>
                    <a:pt x="95" y="914"/>
                  </a:lnTo>
                  <a:moveTo>
                    <a:pt x="185" y="846"/>
                  </a:moveTo>
                  <a:lnTo>
                    <a:pt x="95" y="846"/>
                  </a:lnTo>
                  <a:moveTo>
                    <a:pt x="185" y="768"/>
                  </a:moveTo>
                  <a:lnTo>
                    <a:pt x="95" y="768"/>
                  </a:lnTo>
                  <a:moveTo>
                    <a:pt x="185" y="689"/>
                  </a:moveTo>
                  <a:lnTo>
                    <a:pt x="5" y="689"/>
                  </a:lnTo>
                  <a:moveTo>
                    <a:pt x="185" y="622"/>
                  </a:moveTo>
                  <a:lnTo>
                    <a:pt x="95" y="622"/>
                  </a:lnTo>
                  <a:moveTo>
                    <a:pt x="185" y="544"/>
                  </a:moveTo>
                  <a:lnTo>
                    <a:pt x="95" y="544"/>
                  </a:lnTo>
                  <a:moveTo>
                    <a:pt x="185" y="476"/>
                  </a:moveTo>
                  <a:lnTo>
                    <a:pt x="95" y="476"/>
                  </a:lnTo>
                  <a:moveTo>
                    <a:pt x="185" y="398"/>
                  </a:moveTo>
                  <a:lnTo>
                    <a:pt x="5" y="398"/>
                  </a:lnTo>
                  <a:moveTo>
                    <a:pt x="185" y="330"/>
                  </a:moveTo>
                  <a:lnTo>
                    <a:pt x="95" y="330"/>
                  </a:lnTo>
                  <a:moveTo>
                    <a:pt x="185" y="252"/>
                  </a:moveTo>
                  <a:lnTo>
                    <a:pt x="95" y="252"/>
                  </a:lnTo>
                  <a:moveTo>
                    <a:pt x="185" y="185"/>
                  </a:moveTo>
                  <a:lnTo>
                    <a:pt x="95" y="185"/>
                  </a:lnTo>
                  <a:moveTo>
                    <a:pt x="185" y="106"/>
                  </a:moveTo>
                  <a:lnTo>
                    <a:pt x="5" y="106"/>
                  </a:lnTo>
                  <a:moveTo>
                    <a:pt x="185" y="39"/>
                  </a:moveTo>
                  <a:lnTo>
                    <a:pt x="95" y="39"/>
                  </a:lnTo>
                  <a:moveTo>
                    <a:pt x="185" y="1867"/>
                  </a:moveTo>
                  <a:lnTo>
                    <a:pt x="185" y="5"/>
                  </a:lnTo>
                </a:path>
              </a:pathLst>
            </a:custGeom>
            <a:noFill/>
            <a:ln w="7123" cap="sq">
              <a:solidFill>
                <a:srgbClr val="000000"/>
              </a:solidFill>
              <a:prstDash val="solid"/>
              <a:bevel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  <p:sp>
          <p:nvSpPr>
            <p:cNvPr id="14" name="path 14"/>
            <p:cNvSpPr/>
            <p:nvPr/>
          </p:nvSpPr>
          <p:spPr>
            <a:xfrm>
              <a:off x="334972" y="537042"/>
              <a:ext cx="729115" cy="598187"/>
            </a:xfrm>
            <a:custGeom>
              <a:avLst/>
              <a:gdLst/>
              <a:ahLst/>
              <a:cxnLst/>
              <a:rect l="0" t="0" r="0" b="0"/>
              <a:pathLst>
                <a:path w="1148" h="942">
                  <a:moveTo>
                    <a:pt x="928" y="21"/>
                  </a:moveTo>
                  <a:lnTo>
                    <a:pt x="986" y="72"/>
                  </a:lnTo>
                  <a:lnTo>
                    <a:pt x="1047" y="132"/>
                  </a:lnTo>
                  <a:lnTo>
                    <a:pt x="1091" y="213"/>
                  </a:lnTo>
                  <a:lnTo>
                    <a:pt x="1122" y="299"/>
                  </a:lnTo>
                  <a:lnTo>
                    <a:pt x="1131" y="372"/>
                  </a:lnTo>
                  <a:lnTo>
                    <a:pt x="1131" y="411"/>
                  </a:lnTo>
                  <a:lnTo>
                    <a:pt x="1131" y="449"/>
                  </a:lnTo>
                  <a:lnTo>
                    <a:pt x="1096" y="531"/>
                  </a:lnTo>
                  <a:lnTo>
                    <a:pt x="1052" y="590"/>
                  </a:lnTo>
                  <a:lnTo>
                    <a:pt x="999" y="642"/>
                  </a:lnTo>
                  <a:lnTo>
                    <a:pt x="941" y="702"/>
                  </a:lnTo>
                  <a:lnTo>
                    <a:pt x="880" y="758"/>
                  </a:lnTo>
                  <a:lnTo>
                    <a:pt x="823" y="805"/>
                  </a:lnTo>
                  <a:lnTo>
                    <a:pt x="765" y="848"/>
                  </a:lnTo>
                  <a:lnTo>
                    <a:pt x="704" y="886"/>
                  </a:lnTo>
                  <a:lnTo>
                    <a:pt x="629" y="908"/>
                  </a:lnTo>
                  <a:lnTo>
                    <a:pt x="554" y="920"/>
                  </a:lnTo>
                  <a:lnTo>
                    <a:pt x="474" y="925"/>
                  </a:lnTo>
                  <a:lnTo>
                    <a:pt x="400" y="925"/>
                  </a:lnTo>
                  <a:lnTo>
                    <a:pt x="329" y="916"/>
                  </a:lnTo>
                  <a:lnTo>
                    <a:pt x="259" y="895"/>
                  </a:lnTo>
                  <a:lnTo>
                    <a:pt x="193" y="860"/>
                  </a:lnTo>
                  <a:lnTo>
                    <a:pt x="140" y="813"/>
                  </a:lnTo>
                  <a:lnTo>
                    <a:pt x="78" y="766"/>
                  </a:lnTo>
                  <a:lnTo>
                    <a:pt x="30" y="706"/>
                  </a:lnTo>
                  <a:lnTo>
                    <a:pt x="16" y="638"/>
                  </a:lnTo>
                  <a:lnTo>
                    <a:pt x="21" y="569"/>
                  </a:lnTo>
                  <a:lnTo>
                    <a:pt x="43" y="501"/>
                  </a:lnTo>
                  <a:lnTo>
                    <a:pt x="69" y="436"/>
                  </a:lnTo>
                  <a:lnTo>
                    <a:pt x="100" y="372"/>
                  </a:lnTo>
                  <a:lnTo>
                    <a:pt x="144" y="312"/>
                  </a:lnTo>
                  <a:lnTo>
                    <a:pt x="201" y="248"/>
                  </a:lnTo>
                  <a:lnTo>
                    <a:pt x="259" y="205"/>
                  </a:lnTo>
                  <a:lnTo>
                    <a:pt x="316" y="162"/>
                  </a:lnTo>
                  <a:lnTo>
                    <a:pt x="382" y="132"/>
                  </a:lnTo>
                  <a:lnTo>
                    <a:pt x="452" y="98"/>
                  </a:lnTo>
                  <a:lnTo>
                    <a:pt x="519" y="68"/>
                  </a:lnTo>
                  <a:lnTo>
                    <a:pt x="589" y="42"/>
                  </a:lnTo>
                  <a:lnTo>
                    <a:pt x="660" y="21"/>
                  </a:lnTo>
                  <a:lnTo>
                    <a:pt x="673" y="16"/>
                  </a:lnTo>
                  <a:lnTo>
                    <a:pt x="737" y="17"/>
                  </a:lnTo>
                  <a:lnTo>
                    <a:pt x="800" y="18"/>
                  </a:lnTo>
                  <a:lnTo>
                    <a:pt x="864" y="20"/>
                  </a:lnTo>
                  <a:lnTo>
                    <a:pt x="928" y="21"/>
                  </a:lnTo>
                </a:path>
              </a:pathLst>
            </a:custGeom>
            <a:noFill/>
            <a:ln w="21370" cap="sq">
              <a:solidFill>
                <a:srgbClr val="000000"/>
              </a:solidFill>
              <a:prstDash val="solid"/>
              <a:miter lim="1000000"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</p:grpSp>
      <p:pic>
        <p:nvPicPr>
          <p:cNvPr id="16" name="picture 1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21600000">
            <a:off x="3209198" y="7436918"/>
            <a:ext cx="1225214" cy="1301232"/>
          </a:xfrm>
          <a:prstGeom prst="rect">
            <a:avLst/>
          </a:prstGeom>
        </p:spPr>
      </p:pic>
      <p:grpSp>
        <p:nvGrpSpPr>
          <p:cNvPr id="5" name="group 4"/>
          <p:cNvGrpSpPr/>
          <p:nvPr/>
        </p:nvGrpSpPr>
        <p:grpSpPr>
          <a:xfrm rot="21600000">
            <a:off x="3095220" y="7426391"/>
            <a:ext cx="1353491" cy="1303625"/>
            <a:chOff x="0" y="0"/>
            <a:chExt cx="1353491" cy="1303625"/>
          </a:xfrm>
        </p:grpSpPr>
        <p:sp>
          <p:nvSpPr>
            <p:cNvPr id="18" name="path 18"/>
            <p:cNvSpPr/>
            <p:nvPr/>
          </p:nvSpPr>
          <p:spPr>
            <a:xfrm>
              <a:off x="0" y="0"/>
              <a:ext cx="1353491" cy="1303625"/>
            </a:xfrm>
            <a:custGeom>
              <a:avLst/>
              <a:gdLst/>
              <a:ahLst/>
              <a:cxnLst/>
              <a:rect l="0" t="0" r="0" b="0"/>
              <a:pathLst>
                <a:path w="2131" h="2052">
                  <a:moveTo>
                    <a:pt x="263" y="1867"/>
                  </a:moveTo>
                  <a:lnTo>
                    <a:pt x="263" y="1957"/>
                  </a:lnTo>
                  <a:moveTo>
                    <a:pt x="342" y="1867"/>
                  </a:moveTo>
                  <a:lnTo>
                    <a:pt x="342" y="1957"/>
                  </a:lnTo>
                  <a:moveTo>
                    <a:pt x="420" y="1867"/>
                  </a:moveTo>
                  <a:lnTo>
                    <a:pt x="420" y="1957"/>
                  </a:lnTo>
                  <a:moveTo>
                    <a:pt x="487" y="1867"/>
                  </a:moveTo>
                  <a:lnTo>
                    <a:pt x="487" y="2047"/>
                  </a:lnTo>
                  <a:moveTo>
                    <a:pt x="566" y="1867"/>
                  </a:moveTo>
                  <a:lnTo>
                    <a:pt x="566" y="1957"/>
                  </a:lnTo>
                  <a:moveTo>
                    <a:pt x="645" y="1867"/>
                  </a:moveTo>
                  <a:lnTo>
                    <a:pt x="645" y="1957"/>
                  </a:lnTo>
                  <a:moveTo>
                    <a:pt x="723" y="1867"/>
                  </a:moveTo>
                  <a:lnTo>
                    <a:pt x="723" y="1957"/>
                  </a:lnTo>
                  <a:moveTo>
                    <a:pt x="802" y="1867"/>
                  </a:moveTo>
                  <a:lnTo>
                    <a:pt x="802" y="2047"/>
                  </a:lnTo>
                  <a:moveTo>
                    <a:pt x="880" y="1867"/>
                  </a:moveTo>
                  <a:lnTo>
                    <a:pt x="880" y="1957"/>
                  </a:lnTo>
                  <a:moveTo>
                    <a:pt x="959" y="1867"/>
                  </a:moveTo>
                  <a:lnTo>
                    <a:pt x="959" y="1957"/>
                  </a:lnTo>
                  <a:moveTo>
                    <a:pt x="1037" y="1867"/>
                  </a:moveTo>
                  <a:lnTo>
                    <a:pt x="1037" y="1957"/>
                  </a:lnTo>
                  <a:moveTo>
                    <a:pt x="1105" y="1867"/>
                  </a:moveTo>
                  <a:lnTo>
                    <a:pt x="1105" y="2047"/>
                  </a:lnTo>
                  <a:moveTo>
                    <a:pt x="1183" y="1867"/>
                  </a:moveTo>
                  <a:lnTo>
                    <a:pt x="1183" y="1957"/>
                  </a:lnTo>
                  <a:moveTo>
                    <a:pt x="1262" y="1867"/>
                  </a:moveTo>
                  <a:lnTo>
                    <a:pt x="1262" y="1957"/>
                  </a:lnTo>
                  <a:moveTo>
                    <a:pt x="1340" y="1867"/>
                  </a:moveTo>
                  <a:lnTo>
                    <a:pt x="1340" y="1957"/>
                  </a:lnTo>
                  <a:moveTo>
                    <a:pt x="1419" y="1867"/>
                  </a:moveTo>
                  <a:lnTo>
                    <a:pt x="1419" y="2047"/>
                  </a:lnTo>
                  <a:moveTo>
                    <a:pt x="1497" y="1867"/>
                  </a:moveTo>
                  <a:lnTo>
                    <a:pt x="1497" y="1957"/>
                  </a:lnTo>
                  <a:moveTo>
                    <a:pt x="1576" y="1867"/>
                  </a:moveTo>
                  <a:lnTo>
                    <a:pt x="1576" y="1957"/>
                  </a:lnTo>
                  <a:moveTo>
                    <a:pt x="1643" y="1867"/>
                  </a:moveTo>
                  <a:lnTo>
                    <a:pt x="1643" y="1957"/>
                  </a:lnTo>
                  <a:moveTo>
                    <a:pt x="1722" y="1867"/>
                  </a:moveTo>
                  <a:lnTo>
                    <a:pt x="1722" y="2047"/>
                  </a:lnTo>
                  <a:moveTo>
                    <a:pt x="1800" y="1867"/>
                  </a:moveTo>
                  <a:lnTo>
                    <a:pt x="1800" y="1957"/>
                  </a:lnTo>
                  <a:moveTo>
                    <a:pt x="1879" y="1867"/>
                  </a:moveTo>
                  <a:lnTo>
                    <a:pt x="1879" y="1957"/>
                  </a:lnTo>
                  <a:moveTo>
                    <a:pt x="1957" y="1867"/>
                  </a:moveTo>
                  <a:lnTo>
                    <a:pt x="1957" y="1957"/>
                  </a:lnTo>
                  <a:moveTo>
                    <a:pt x="2036" y="1867"/>
                  </a:moveTo>
                  <a:lnTo>
                    <a:pt x="2036" y="2047"/>
                  </a:lnTo>
                  <a:moveTo>
                    <a:pt x="2114" y="1867"/>
                  </a:moveTo>
                  <a:lnTo>
                    <a:pt x="2114" y="1957"/>
                  </a:lnTo>
                  <a:moveTo>
                    <a:pt x="185" y="1867"/>
                  </a:moveTo>
                  <a:lnTo>
                    <a:pt x="2125" y="1867"/>
                  </a:lnTo>
                  <a:moveTo>
                    <a:pt x="185" y="1867"/>
                  </a:moveTo>
                  <a:lnTo>
                    <a:pt x="5" y="1867"/>
                  </a:lnTo>
                  <a:moveTo>
                    <a:pt x="185" y="1789"/>
                  </a:moveTo>
                  <a:lnTo>
                    <a:pt x="95" y="1789"/>
                  </a:lnTo>
                  <a:moveTo>
                    <a:pt x="185" y="1722"/>
                  </a:moveTo>
                  <a:lnTo>
                    <a:pt x="95" y="1722"/>
                  </a:lnTo>
                  <a:moveTo>
                    <a:pt x="185" y="1643"/>
                  </a:moveTo>
                  <a:lnTo>
                    <a:pt x="95" y="1643"/>
                  </a:lnTo>
                  <a:moveTo>
                    <a:pt x="185" y="1576"/>
                  </a:moveTo>
                  <a:lnTo>
                    <a:pt x="5" y="1576"/>
                  </a:lnTo>
                  <a:moveTo>
                    <a:pt x="185" y="1497"/>
                  </a:moveTo>
                  <a:lnTo>
                    <a:pt x="95" y="1497"/>
                  </a:lnTo>
                  <a:moveTo>
                    <a:pt x="185" y="1430"/>
                  </a:moveTo>
                  <a:lnTo>
                    <a:pt x="95" y="1430"/>
                  </a:lnTo>
                  <a:moveTo>
                    <a:pt x="185" y="1351"/>
                  </a:moveTo>
                  <a:lnTo>
                    <a:pt x="95" y="1351"/>
                  </a:lnTo>
                  <a:moveTo>
                    <a:pt x="185" y="1284"/>
                  </a:moveTo>
                  <a:lnTo>
                    <a:pt x="5" y="1284"/>
                  </a:lnTo>
                  <a:moveTo>
                    <a:pt x="185" y="1205"/>
                  </a:moveTo>
                  <a:lnTo>
                    <a:pt x="95" y="1205"/>
                  </a:lnTo>
                  <a:moveTo>
                    <a:pt x="185" y="1138"/>
                  </a:moveTo>
                  <a:lnTo>
                    <a:pt x="95" y="1138"/>
                  </a:lnTo>
                  <a:moveTo>
                    <a:pt x="185" y="1060"/>
                  </a:moveTo>
                  <a:lnTo>
                    <a:pt x="95" y="1060"/>
                  </a:lnTo>
                  <a:moveTo>
                    <a:pt x="185" y="992"/>
                  </a:moveTo>
                  <a:lnTo>
                    <a:pt x="5" y="992"/>
                  </a:lnTo>
                  <a:moveTo>
                    <a:pt x="185" y="914"/>
                  </a:moveTo>
                  <a:lnTo>
                    <a:pt x="95" y="914"/>
                  </a:lnTo>
                  <a:moveTo>
                    <a:pt x="185" y="846"/>
                  </a:moveTo>
                  <a:lnTo>
                    <a:pt x="95" y="846"/>
                  </a:lnTo>
                  <a:moveTo>
                    <a:pt x="185" y="768"/>
                  </a:moveTo>
                  <a:lnTo>
                    <a:pt x="95" y="768"/>
                  </a:lnTo>
                  <a:moveTo>
                    <a:pt x="185" y="689"/>
                  </a:moveTo>
                  <a:lnTo>
                    <a:pt x="5" y="689"/>
                  </a:lnTo>
                  <a:moveTo>
                    <a:pt x="185" y="622"/>
                  </a:moveTo>
                  <a:lnTo>
                    <a:pt x="95" y="622"/>
                  </a:lnTo>
                  <a:moveTo>
                    <a:pt x="185" y="544"/>
                  </a:moveTo>
                  <a:lnTo>
                    <a:pt x="95" y="544"/>
                  </a:lnTo>
                  <a:moveTo>
                    <a:pt x="185" y="476"/>
                  </a:moveTo>
                  <a:lnTo>
                    <a:pt x="95" y="476"/>
                  </a:lnTo>
                  <a:moveTo>
                    <a:pt x="185" y="398"/>
                  </a:moveTo>
                  <a:lnTo>
                    <a:pt x="5" y="398"/>
                  </a:lnTo>
                  <a:moveTo>
                    <a:pt x="185" y="330"/>
                  </a:moveTo>
                  <a:lnTo>
                    <a:pt x="95" y="330"/>
                  </a:lnTo>
                  <a:moveTo>
                    <a:pt x="185" y="252"/>
                  </a:moveTo>
                  <a:lnTo>
                    <a:pt x="95" y="252"/>
                  </a:lnTo>
                  <a:moveTo>
                    <a:pt x="185" y="185"/>
                  </a:moveTo>
                  <a:lnTo>
                    <a:pt x="95" y="185"/>
                  </a:lnTo>
                  <a:moveTo>
                    <a:pt x="185" y="106"/>
                  </a:moveTo>
                  <a:lnTo>
                    <a:pt x="5" y="106"/>
                  </a:lnTo>
                  <a:moveTo>
                    <a:pt x="185" y="39"/>
                  </a:moveTo>
                  <a:lnTo>
                    <a:pt x="95" y="39"/>
                  </a:lnTo>
                  <a:moveTo>
                    <a:pt x="185" y="1867"/>
                  </a:moveTo>
                  <a:lnTo>
                    <a:pt x="185" y="5"/>
                  </a:lnTo>
                </a:path>
              </a:pathLst>
            </a:custGeom>
            <a:noFill/>
            <a:ln w="7123" cap="sq">
              <a:solidFill>
                <a:srgbClr val="000000"/>
              </a:solidFill>
              <a:prstDash val="solid"/>
              <a:bevel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  <p:sp>
          <p:nvSpPr>
            <p:cNvPr id="20" name="path 20"/>
            <p:cNvSpPr/>
            <p:nvPr/>
          </p:nvSpPr>
          <p:spPr>
            <a:xfrm>
              <a:off x="376856" y="634992"/>
              <a:ext cx="720723" cy="554654"/>
            </a:xfrm>
            <a:custGeom>
              <a:avLst/>
              <a:gdLst/>
              <a:ahLst/>
              <a:cxnLst/>
              <a:rect l="0" t="0" r="0" b="0"/>
              <a:pathLst>
                <a:path w="1134" h="873">
                  <a:moveTo>
                    <a:pt x="1082" y="76"/>
                  </a:moveTo>
                  <a:lnTo>
                    <a:pt x="1104" y="153"/>
                  </a:lnTo>
                  <a:lnTo>
                    <a:pt x="1118" y="222"/>
                  </a:lnTo>
                  <a:lnTo>
                    <a:pt x="1118" y="267"/>
                  </a:lnTo>
                  <a:lnTo>
                    <a:pt x="1118" y="312"/>
                  </a:lnTo>
                  <a:lnTo>
                    <a:pt x="1113" y="389"/>
                  </a:lnTo>
                  <a:lnTo>
                    <a:pt x="1087" y="483"/>
                  </a:lnTo>
                  <a:lnTo>
                    <a:pt x="1052" y="560"/>
                  </a:lnTo>
                  <a:lnTo>
                    <a:pt x="1012" y="625"/>
                  </a:lnTo>
                  <a:lnTo>
                    <a:pt x="959" y="676"/>
                  </a:lnTo>
                  <a:lnTo>
                    <a:pt x="906" y="723"/>
                  </a:lnTo>
                  <a:lnTo>
                    <a:pt x="840" y="766"/>
                  </a:lnTo>
                  <a:lnTo>
                    <a:pt x="778" y="800"/>
                  </a:lnTo>
                  <a:lnTo>
                    <a:pt x="699" y="830"/>
                  </a:lnTo>
                  <a:lnTo>
                    <a:pt x="615" y="843"/>
                  </a:lnTo>
                  <a:lnTo>
                    <a:pt x="545" y="852"/>
                  </a:lnTo>
                  <a:lnTo>
                    <a:pt x="474" y="852"/>
                  </a:lnTo>
                  <a:lnTo>
                    <a:pt x="400" y="856"/>
                  </a:lnTo>
                  <a:lnTo>
                    <a:pt x="325" y="856"/>
                  </a:lnTo>
                  <a:lnTo>
                    <a:pt x="254" y="856"/>
                  </a:lnTo>
                  <a:lnTo>
                    <a:pt x="175" y="830"/>
                  </a:lnTo>
                  <a:lnTo>
                    <a:pt x="104" y="800"/>
                  </a:lnTo>
                  <a:lnTo>
                    <a:pt x="47" y="749"/>
                  </a:lnTo>
                  <a:lnTo>
                    <a:pt x="21" y="668"/>
                  </a:lnTo>
                  <a:lnTo>
                    <a:pt x="16" y="595"/>
                  </a:lnTo>
                  <a:lnTo>
                    <a:pt x="16" y="558"/>
                  </a:lnTo>
                  <a:lnTo>
                    <a:pt x="16" y="522"/>
                  </a:lnTo>
                  <a:lnTo>
                    <a:pt x="38" y="453"/>
                  </a:lnTo>
                  <a:lnTo>
                    <a:pt x="82" y="381"/>
                  </a:lnTo>
                  <a:lnTo>
                    <a:pt x="126" y="312"/>
                  </a:lnTo>
                  <a:lnTo>
                    <a:pt x="171" y="256"/>
                  </a:lnTo>
                  <a:lnTo>
                    <a:pt x="223" y="205"/>
                  </a:lnTo>
                  <a:lnTo>
                    <a:pt x="294" y="145"/>
                  </a:lnTo>
                  <a:lnTo>
                    <a:pt x="360" y="102"/>
                  </a:lnTo>
                  <a:lnTo>
                    <a:pt x="426" y="68"/>
                  </a:lnTo>
                  <a:lnTo>
                    <a:pt x="492" y="38"/>
                  </a:lnTo>
                  <a:lnTo>
                    <a:pt x="580" y="21"/>
                  </a:lnTo>
                  <a:lnTo>
                    <a:pt x="660" y="16"/>
                  </a:lnTo>
                  <a:lnTo>
                    <a:pt x="730" y="16"/>
                  </a:lnTo>
                  <a:lnTo>
                    <a:pt x="805" y="21"/>
                  </a:lnTo>
                  <a:lnTo>
                    <a:pt x="831" y="25"/>
                  </a:lnTo>
                  <a:lnTo>
                    <a:pt x="894" y="38"/>
                  </a:lnTo>
                  <a:lnTo>
                    <a:pt x="957" y="51"/>
                  </a:lnTo>
                  <a:lnTo>
                    <a:pt x="1020" y="63"/>
                  </a:lnTo>
                  <a:lnTo>
                    <a:pt x="1082" y="76"/>
                  </a:lnTo>
                </a:path>
              </a:pathLst>
            </a:custGeom>
            <a:noFill/>
            <a:ln w="21370" cap="sq">
              <a:solidFill>
                <a:srgbClr val="000000"/>
              </a:solidFill>
              <a:prstDash val="solid"/>
              <a:miter lim="1000000"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</p:grpSp>
      <p:pic>
        <p:nvPicPr>
          <p:cNvPr id="22" name="picture 2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21600000">
            <a:off x="872645" y="7436918"/>
            <a:ext cx="1239083" cy="1301232"/>
          </a:xfrm>
          <a:prstGeom prst="rect">
            <a:avLst/>
          </a:prstGeom>
        </p:spPr>
      </p:pic>
      <p:sp>
        <p:nvSpPr>
          <p:cNvPr id="24" name="textbox 24"/>
          <p:cNvSpPr/>
          <p:nvPr/>
        </p:nvSpPr>
        <p:spPr>
          <a:xfrm>
            <a:off x="882499" y="4078020"/>
            <a:ext cx="3767454" cy="31242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81000"/>
              </a:lnSpc>
            </a:pP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  </a:t>
            </a:r>
            <a:r>
              <a:rPr sz="9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5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50                       200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741170" algn="l" rtl="0" eaLnBrk="0">
              <a:lnSpc>
                <a:spcPts val="1270"/>
              </a:lnSpc>
              <a:spcBef>
                <a:spcPts val="115"/>
              </a:spcBef>
            </a:pPr>
            <a:r>
              <a:rPr sz="1000" kern="0" spc="-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I-A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26" name="textbox 26"/>
          <p:cNvSpPr/>
          <p:nvPr/>
        </p:nvSpPr>
        <p:spPr>
          <a:xfrm>
            <a:off x="5519459" y="8760429"/>
            <a:ext cx="1303019" cy="32639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6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537210" indent="-525145" algn="l" rtl="0" eaLnBrk="0">
              <a:lnSpc>
                <a:spcPct val="116000"/>
              </a:lnSpc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    2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60   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80</a:t>
            </a:r>
            <a:r>
              <a:rPr sz="700" kern="0" spc="10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  120  </a:t>
            </a:r>
            <a:r>
              <a:rPr sz="1000" kern="0" spc="-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I-A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28" name="textbox 28"/>
          <p:cNvSpPr/>
          <p:nvPr/>
        </p:nvSpPr>
        <p:spPr>
          <a:xfrm>
            <a:off x="846353" y="8760429"/>
            <a:ext cx="1303019" cy="28702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2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0000"/>
              </a:lnSpc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    2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60</a:t>
            </a:r>
            <a:r>
              <a:rPr sz="700" kern="0" spc="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   100  1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l" rtl="0" eaLnBrk="0">
              <a:lnSpc>
                <a:spcPct val="148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47371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SC-A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30" name="textbox 30"/>
          <p:cNvSpPr/>
          <p:nvPr/>
        </p:nvSpPr>
        <p:spPr>
          <a:xfrm>
            <a:off x="3182906" y="8760429"/>
            <a:ext cx="1303019" cy="28702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2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0000"/>
              </a:lnSpc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    2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60</a:t>
            </a:r>
            <a:r>
              <a:rPr sz="700" kern="0" spc="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   100  1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l" rtl="0" eaLnBrk="0">
              <a:lnSpc>
                <a:spcPct val="148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47371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SC-A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32" name="textbox 32"/>
          <p:cNvSpPr/>
          <p:nvPr/>
        </p:nvSpPr>
        <p:spPr>
          <a:xfrm rot="16200000">
            <a:off x="-952306" y="2214200"/>
            <a:ext cx="3289934" cy="16256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26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81000"/>
              </a:lnSpc>
              <a:spcBef>
                <a:spcPts val="0"/>
              </a:spcBef>
            </a:pP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50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0</a:t>
            </a:r>
            <a:r>
              <a:rPr sz="900" kern="0" spc="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50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00</a:t>
            </a:r>
            <a:r>
              <a:rPr sz="900" kern="0" spc="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50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300</a:t>
            </a:r>
            <a:r>
              <a:rPr sz="900" kern="0" spc="-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34" name="path 34"/>
          <p:cNvSpPr/>
          <p:nvPr/>
        </p:nvSpPr>
        <p:spPr>
          <a:xfrm>
            <a:off x="1166600" y="8053654"/>
            <a:ext cx="651294" cy="325403"/>
          </a:xfrm>
          <a:custGeom>
            <a:avLst/>
            <a:gdLst/>
            <a:ahLst/>
            <a:cxnLst/>
            <a:rect l="0" t="0" r="0" b="0"/>
            <a:pathLst>
              <a:path w="1025" h="512">
                <a:moveTo>
                  <a:pt x="663" y="35"/>
                </a:moveTo>
                <a:lnTo>
                  <a:pt x="732" y="25"/>
                </a:lnTo>
                <a:lnTo>
                  <a:pt x="822" y="16"/>
                </a:lnTo>
                <a:lnTo>
                  <a:pt x="902" y="20"/>
                </a:lnTo>
                <a:lnTo>
                  <a:pt x="964" y="42"/>
                </a:lnTo>
                <a:lnTo>
                  <a:pt x="995" y="96"/>
                </a:lnTo>
                <a:lnTo>
                  <a:pt x="1008" y="159"/>
                </a:lnTo>
                <a:lnTo>
                  <a:pt x="1006" y="225"/>
                </a:lnTo>
                <a:lnTo>
                  <a:pt x="962" y="281"/>
                </a:lnTo>
                <a:lnTo>
                  <a:pt x="904" y="320"/>
                </a:lnTo>
                <a:lnTo>
                  <a:pt x="849" y="350"/>
                </a:lnTo>
                <a:lnTo>
                  <a:pt x="782" y="375"/>
                </a:lnTo>
                <a:lnTo>
                  <a:pt x="709" y="397"/>
                </a:lnTo>
                <a:lnTo>
                  <a:pt x="626" y="420"/>
                </a:lnTo>
                <a:lnTo>
                  <a:pt x="557" y="441"/>
                </a:lnTo>
                <a:lnTo>
                  <a:pt x="493" y="458"/>
                </a:lnTo>
                <a:lnTo>
                  <a:pt x="432" y="474"/>
                </a:lnTo>
                <a:lnTo>
                  <a:pt x="366" y="484"/>
                </a:lnTo>
                <a:lnTo>
                  <a:pt x="296" y="493"/>
                </a:lnTo>
                <a:lnTo>
                  <a:pt x="229" y="495"/>
                </a:lnTo>
                <a:lnTo>
                  <a:pt x="160" y="486"/>
                </a:lnTo>
                <a:lnTo>
                  <a:pt x="99" y="471"/>
                </a:lnTo>
                <a:lnTo>
                  <a:pt x="49" y="424"/>
                </a:lnTo>
                <a:lnTo>
                  <a:pt x="21" y="367"/>
                </a:lnTo>
                <a:lnTo>
                  <a:pt x="16" y="306"/>
                </a:lnTo>
                <a:lnTo>
                  <a:pt x="47" y="241"/>
                </a:lnTo>
                <a:lnTo>
                  <a:pt x="100" y="195"/>
                </a:lnTo>
                <a:lnTo>
                  <a:pt x="154" y="160"/>
                </a:lnTo>
                <a:lnTo>
                  <a:pt x="222" y="135"/>
                </a:lnTo>
                <a:lnTo>
                  <a:pt x="286" y="111"/>
                </a:lnTo>
                <a:lnTo>
                  <a:pt x="347" y="98"/>
                </a:lnTo>
                <a:lnTo>
                  <a:pt x="410" y="86"/>
                </a:lnTo>
                <a:lnTo>
                  <a:pt x="473" y="73"/>
                </a:lnTo>
                <a:lnTo>
                  <a:pt x="536" y="60"/>
                </a:lnTo>
                <a:lnTo>
                  <a:pt x="599" y="48"/>
                </a:lnTo>
                <a:lnTo>
                  <a:pt x="663" y="35"/>
                </a:lnTo>
              </a:path>
            </a:pathLst>
          </a:custGeom>
          <a:noFill/>
          <a:ln w="21370" cap="sq">
            <a:solidFill>
              <a:srgbClr val="000000"/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36" name="path 36"/>
          <p:cNvSpPr/>
          <p:nvPr/>
        </p:nvSpPr>
        <p:spPr>
          <a:xfrm>
            <a:off x="758667" y="7447762"/>
            <a:ext cx="121101" cy="1075669"/>
          </a:xfrm>
          <a:custGeom>
            <a:avLst/>
            <a:gdLst/>
            <a:ahLst/>
            <a:cxnLst/>
            <a:rect l="0" t="0" r="0" b="0"/>
            <a:pathLst>
              <a:path w="190" h="1693">
                <a:moveTo>
                  <a:pt x="185" y="1688"/>
                </a:moveTo>
                <a:lnTo>
                  <a:pt x="95" y="1688"/>
                </a:lnTo>
                <a:moveTo>
                  <a:pt x="185" y="1609"/>
                </a:moveTo>
                <a:lnTo>
                  <a:pt x="95" y="1609"/>
                </a:lnTo>
                <a:moveTo>
                  <a:pt x="185" y="1542"/>
                </a:moveTo>
                <a:lnTo>
                  <a:pt x="5" y="1542"/>
                </a:lnTo>
                <a:moveTo>
                  <a:pt x="185" y="1463"/>
                </a:moveTo>
                <a:lnTo>
                  <a:pt x="95" y="1463"/>
                </a:lnTo>
                <a:moveTo>
                  <a:pt x="185" y="1396"/>
                </a:moveTo>
                <a:lnTo>
                  <a:pt x="95" y="1396"/>
                </a:lnTo>
                <a:moveTo>
                  <a:pt x="185" y="1318"/>
                </a:moveTo>
                <a:lnTo>
                  <a:pt x="95" y="1318"/>
                </a:lnTo>
                <a:moveTo>
                  <a:pt x="185" y="1250"/>
                </a:moveTo>
                <a:lnTo>
                  <a:pt x="5" y="1250"/>
                </a:lnTo>
                <a:moveTo>
                  <a:pt x="185" y="1172"/>
                </a:moveTo>
                <a:lnTo>
                  <a:pt x="95" y="1172"/>
                </a:lnTo>
                <a:moveTo>
                  <a:pt x="185" y="1105"/>
                </a:moveTo>
                <a:lnTo>
                  <a:pt x="95" y="1105"/>
                </a:lnTo>
                <a:moveTo>
                  <a:pt x="185" y="1026"/>
                </a:moveTo>
                <a:lnTo>
                  <a:pt x="95" y="1026"/>
                </a:lnTo>
                <a:moveTo>
                  <a:pt x="185" y="959"/>
                </a:moveTo>
                <a:lnTo>
                  <a:pt x="5" y="959"/>
                </a:lnTo>
                <a:moveTo>
                  <a:pt x="185" y="880"/>
                </a:moveTo>
                <a:lnTo>
                  <a:pt x="95" y="880"/>
                </a:lnTo>
                <a:moveTo>
                  <a:pt x="185" y="813"/>
                </a:moveTo>
                <a:lnTo>
                  <a:pt x="95" y="813"/>
                </a:lnTo>
                <a:moveTo>
                  <a:pt x="185" y="734"/>
                </a:moveTo>
                <a:lnTo>
                  <a:pt x="95" y="734"/>
                </a:lnTo>
                <a:moveTo>
                  <a:pt x="185" y="656"/>
                </a:moveTo>
                <a:lnTo>
                  <a:pt x="5" y="656"/>
                </a:lnTo>
                <a:moveTo>
                  <a:pt x="185" y="588"/>
                </a:moveTo>
                <a:lnTo>
                  <a:pt x="95" y="588"/>
                </a:lnTo>
                <a:moveTo>
                  <a:pt x="185" y="510"/>
                </a:moveTo>
                <a:lnTo>
                  <a:pt x="95" y="510"/>
                </a:lnTo>
                <a:moveTo>
                  <a:pt x="185" y="443"/>
                </a:moveTo>
                <a:lnTo>
                  <a:pt x="95" y="443"/>
                </a:lnTo>
                <a:moveTo>
                  <a:pt x="185" y="364"/>
                </a:moveTo>
                <a:lnTo>
                  <a:pt x="5" y="364"/>
                </a:lnTo>
                <a:moveTo>
                  <a:pt x="185" y="297"/>
                </a:moveTo>
                <a:lnTo>
                  <a:pt x="95" y="297"/>
                </a:lnTo>
                <a:moveTo>
                  <a:pt x="185" y="218"/>
                </a:moveTo>
                <a:lnTo>
                  <a:pt x="95" y="218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72"/>
                </a:moveTo>
                <a:lnTo>
                  <a:pt x="5" y="72"/>
                </a:lnTo>
                <a:moveTo>
                  <a:pt x="185" y="5"/>
                </a:moveTo>
                <a:lnTo>
                  <a:pt x="9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38" name="textbox 38"/>
          <p:cNvSpPr/>
          <p:nvPr/>
        </p:nvSpPr>
        <p:spPr>
          <a:xfrm>
            <a:off x="468099" y="9566299"/>
            <a:ext cx="949325" cy="16128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ts val="1065"/>
              </a:lnSpc>
            </a:pPr>
            <a:r>
              <a:rPr sz="800" kern="0" spc="-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Fit</a:t>
            </a:r>
            <a:r>
              <a:rPr sz="8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800" kern="0" spc="-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LTV4.1.</a:t>
            </a:r>
            <a:r>
              <a:rPr sz="8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7(Win)</a:t>
            </a:r>
            <a:endParaRPr sz="8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40" name="textbox 40"/>
          <p:cNvSpPr/>
          <p:nvPr/>
        </p:nvSpPr>
        <p:spPr>
          <a:xfrm>
            <a:off x="3805569" y="454610"/>
            <a:ext cx="495300" cy="28638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4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33350" algn="l" rtl="0" eaLnBrk="0">
              <a:lnSpc>
                <a:spcPct val="122000"/>
              </a:lnSpc>
              <a:tabLst>
                <a:tab pos="198120" algn="l"/>
              </a:tabLst>
            </a:pP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	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G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	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G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pic>
        <p:nvPicPr>
          <p:cNvPr id="42" name="picture 4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rot="21600000">
            <a:off x="3818269" y="598385"/>
            <a:ext cx="121101" cy="99731"/>
          </a:xfrm>
          <a:prstGeom prst="rect">
            <a:avLst/>
          </a:prstGeom>
        </p:spPr>
      </p:pic>
      <p:pic>
        <p:nvPicPr>
          <p:cNvPr id="44" name="picture 4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rot="21600000">
            <a:off x="3818269" y="477284"/>
            <a:ext cx="121101" cy="99730"/>
          </a:xfrm>
          <a:prstGeom prst="rect">
            <a:avLst/>
          </a:prstGeom>
        </p:spPr>
      </p:pic>
      <p:sp>
        <p:nvSpPr>
          <p:cNvPr id="46" name="textbox 46"/>
          <p:cNvSpPr/>
          <p:nvPr/>
        </p:nvSpPr>
        <p:spPr>
          <a:xfrm rot="16200000">
            <a:off x="2389390" y="7948715"/>
            <a:ext cx="1245869" cy="14160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07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0000"/>
              </a:lnSpc>
              <a:spcBef>
                <a:spcPts val="0"/>
              </a:spcBef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   40   6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</a:t>
            </a:r>
            <a:r>
              <a:rPr sz="700" kern="0" spc="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700" kern="0" spc="1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20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48" name="textbox 48"/>
          <p:cNvSpPr/>
          <p:nvPr/>
        </p:nvSpPr>
        <p:spPr>
          <a:xfrm rot="16200000">
            <a:off x="52837" y="7948715"/>
            <a:ext cx="1245869" cy="14160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07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0000"/>
              </a:lnSpc>
              <a:spcBef>
                <a:spcPts val="0"/>
              </a:spcBef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   40   6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</a:t>
            </a:r>
            <a:r>
              <a:rPr sz="700" kern="0" spc="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700" kern="0" spc="1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20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50" name="textbox 50"/>
          <p:cNvSpPr/>
          <p:nvPr/>
        </p:nvSpPr>
        <p:spPr>
          <a:xfrm rot="16200000">
            <a:off x="4725942" y="7948715"/>
            <a:ext cx="1245869" cy="14160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07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0000"/>
              </a:lnSpc>
              <a:spcBef>
                <a:spcPts val="0"/>
              </a:spcBef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   40   6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</a:t>
            </a:r>
            <a:r>
              <a:rPr sz="700" kern="0" spc="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700" kern="0" spc="1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20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52" name="path 52"/>
          <p:cNvSpPr/>
          <p:nvPr/>
        </p:nvSpPr>
        <p:spPr>
          <a:xfrm>
            <a:off x="922511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54" name="path 54"/>
          <p:cNvSpPr/>
          <p:nvPr/>
        </p:nvSpPr>
        <p:spPr>
          <a:xfrm>
            <a:off x="1114849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56" name="path 56"/>
          <p:cNvSpPr/>
          <p:nvPr/>
        </p:nvSpPr>
        <p:spPr>
          <a:xfrm>
            <a:off x="1314311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58" name="path 58"/>
          <p:cNvSpPr/>
          <p:nvPr/>
        </p:nvSpPr>
        <p:spPr>
          <a:xfrm>
            <a:off x="1506649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0" name="path 60"/>
          <p:cNvSpPr/>
          <p:nvPr/>
        </p:nvSpPr>
        <p:spPr>
          <a:xfrm>
            <a:off x="1898449" y="8608915"/>
            <a:ext cx="156720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2" name="path 62"/>
          <p:cNvSpPr/>
          <p:nvPr/>
        </p:nvSpPr>
        <p:spPr>
          <a:xfrm>
            <a:off x="1706111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51" y="5"/>
                </a:moveTo>
                <a:lnTo>
                  <a:pt x="151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4" name="path 64"/>
          <p:cNvSpPr/>
          <p:nvPr/>
        </p:nvSpPr>
        <p:spPr>
          <a:xfrm>
            <a:off x="872645" y="8608915"/>
            <a:ext cx="1239512" cy="64112"/>
          </a:xfrm>
          <a:custGeom>
            <a:avLst/>
            <a:gdLst/>
            <a:ahLst/>
            <a:cxnLst/>
            <a:rect l="0" t="0" r="0" b="0"/>
            <a:pathLst>
              <a:path w="1951" h="100">
                <a:moveTo>
                  <a:pt x="1935" y="5"/>
                </a:moveTo>
                <a:lnTo>
                  <a:pt x="1935" y="95"/>
                </a:lnTo>
                <a:moveTo>
                  <a:pt x="5" y="5"/>
                </a:moveTo>
                <a:lnTo>
                  <a:pt x="1946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6" name="textbox 66"/>
          <p:cNvSpPr/>
          <p:nvPr/>
        </p:nvSpPr>
        <p:spPr>
          <a:xfrm rot="16200000">
            <a:off x="310755" y="2249794"/>
            <a:ext cx="421640" cy="18668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ts val="1270"/>
              </a:lnSpc>
            </a:pPr>
            <a:r>
              <a:rPr sz="900" kern="0" spc="-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Number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68" name="path 68"/>
          <p:cNvSpPr/>
          <p:nvPr/>
        </p:nvSpPr>
        <p:spPr>
          <a:xfrm>
            <a:off x="787161" y="2860140"/>
            <a:ext cx="135349" cy="427418"/>
          </a:xfrm>
          <a:custGeom>
            <a:avLst/>
            <a:gdLst/>
            <a:ahLst/>
            <a:cxnLst/>
            <a:rect l="0" t="0" r="0" b="0"/>
            <a:pathLst>
              <a:path w="213" h="673">
                <a:moveTo>
                  <a:pt x="207" y="667"/>
                </a:moveTo>
                <a:lnTo>
                  <a:pt x="106" y="667"/>
                </a:lnTo>
                <a:moveTo>
                  <a:pt x="207" y="499"/>
                </a:moveTo>
                <a:lnTo>
                  <a:pt x="106" y="499"/>
                </a:lnTo>
                <a:moveTo>
                  <a:pt x="207" y="330"/>
                </a:moveTo>
                <a:lnTo>
                  <a:pt x="106" y="330"/>
                </a:lnTo>
                <a:moveTo>
                  <a:pt x="207" y="173"/>
                </a:moveTo>
                <a:lnTo>
                  <a:pt x="106" y="173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0" name="path 70"/>
          <p:cNvSpPr/>
          <p:nvPr/>
        </p:nvSpPr>
        <p:spPr>
          <a:xfrm>
            <a:off x="787161" y="2347238"/>
            <a:ext cx="135349" cy="420294"/>
          </a:xfrm>
          <a:custGeom>
            <a:avLst/>
            <a:gdLst/>
            <a:ahLst/>
            <a:cxnLst/>
            <a:rect l="0" t="0" r="0" b="0"/>
            <a:pathLst>
              <a:path w="213" h="661">
                <a:moveTo>
                  <a:pt x="207" y="656"/>
                </a:moveTo>
                <a:lnTo>
                  <a:pt x="106" y="656"/>
                </a:lnTo>
                <a:moveTo>
                  <a:pt x="207" y="487"/>
                </a:moveTo>
                <a:lnTo>
                  <a:pt x="106" y="487"/>
                </a:lnTo>
                <a:moveTo>
                  <a:pt x="207" y="330"/>
                </a:moveTo>
                <a:lnTo>
                  <a:pt x="106" y="330"/>
                </a:lnTo>
                <a:moveTo>
                  <a:pt x="207" y="162"/>
                </a:moveTo>
                <a:lnTo>
                  <a:pt x="106" y="162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2" name="path 72"/>
          <p:cNvSpPr/>
          <p:nvPr/>
        </p:nvSpPr>
        <p:spPr>
          <a:xfrm>
            <a:off x="787161" y="1307187"/>
            <a:ext cx="135349" cy="420294"/>
          </a:xfrm>
          <a:custGeom>
            <a:avLst/>
            <a:gdLst/>
            <a:ahLst/>
            <a:cxnLst/>
            <a:rect l="0" t="0" r="0" b="0"/>
            <a:pathLst>
              <a:path w="213" h="661">
                <a:moveTo>
                  <a:pt x="207" y="656"/>
                </a:moveTo>
                <a:lnTo>
                  <a:pt x="106" y="656"/>
                </a:lnTo>
                <a:moveTo>
                  <a:pt x="207" y="499"/>
                </a:moveTo>
                <a:lnTo>
                  <a:pt x="106" y="499"/>
                </a:lnTo>
                <a:moveTo>
                  <a:pt x="207" y="330"/>
                </a:moveTo>
                <a:lnTo>
                  <a:pt x="106" y="330"/>
                </a:lnTo>
                <a:moveTo>
                  <a:pt x="207" y="162"/>
                </a:moveTo>
                <a:lnTo>
                  <a:pt x="106" y="162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4" name="path 74"/>
          <p:cNvSpPr/>
          <p:nvPr/>
        </p:nvSpPr>
        <p:spPr>
          <a:xfrm>
            <a:off x="787161" y="787162"/>
            <a:ext cx="135349" cy="420294"/>
          </a:xfrm>
          <a:custGeom>
            <a:avLst/>
            <a:gdLst/>
            <a:ahLst/>
            <a:cxnLst/>
            <a:rect l="0" t="0" r="0" b="0"/>
            <a:pathLst>
              <a:path w="213" h="661">
                <a:moveTo>
                  <a:pt x="207" y="656"/>
                </a:moveTo>
                <a:lnTo>
                  <a:pt x="106" y="656"/>
                </a:lnTo>
                <a:moveTo>
                  <a:pt x="207" y="499"/>
                </a:moveTo>
                <a:lnTo>
                  <a:pt x="106" y="499"/>
                </a:lnTo>
                <a:moveTo>
                  <a:pt x="207" y="330"/>
                </a:moveTo>
                <a:lnTo>
                  <a:pt x="106" y="330"/>
                </a:lnTo>
                <a:moveTo>
                  <a:pt x="207" y="173"/>
                </a:moveTo>
                <a:lnTo>
                  <a:pt x="106" y="173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6" name="path 76"/>
          <p:cNvSpPr/>
          <p:nvPr/>
        </p:nvSpPr>
        <p:spPr>
          <a:xfrm>
            <a:off x="787161" y="1827213"/>
            <a:ext cx="135349" cy="420294"/>
          </a:xfrm>
          <a:custGeom>
            <a:avLst/>
            <a:gdLst/>
            <a:ahLst/>
            <a:cxnLst/>
            <a:rect l="0" t="0" r="0" b="0"/>
            <a:pathLst>
              <a:path w="213" h="661">
                <a:moveTo>
                  <a:pt x="207" y="656"/>
                </a:moveTo>
                <a:lnTo>
                  <a:pt x="106" y="656"/>
                </a:lnTo>
                <a:moveTo>
                  <a:pt x="207" y="487"/>
                </a:moveTo>
                <a:lnTo>
                  <a:pt x="106" y="487"/>
                </a:lnTo>
                <a:moveTo>
                  <a:pt x="207" y="330"/>
                </a:moveTo>
                <a:lnTo>
                  <a:pt x="106" y="330"/>
                </a:lnTo>
                <a:moveTo>
                  <a:pt x="207" y="162"/>
                </a:moveTo>
                <a:lnTo>
                  <a:pt x="106" y="162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8" name="textbox 78"/>
          <p:cNvSpPr/>
          <p:nvPr/>
        </p:nvSpPr>
        <p:spPr>
          <a:xfrm>
            <a:off x="3805569" y="696814"/>
            <a:ext cx="434975" cy="16128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33350" algn="l" rtl="0" eaLnBrk="0">
              <a:lnSpc>
                <a:spcPts val="1065"/>
              </a:lnSpc>
              <a:tabLst>
                <a:tab pos="198120" algn="l"/>
              </a:tabLst>
            </a:pPr>
            <a:r>
              <a:rPr sz="8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	</a:t>
            </a:r>
            <a:r>
              <a:rPr sz="8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S</a:t>
            </a:r>
            <a:endParaRPr sz="8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pic>
        <p:nvPicPr>
          <p:cNvPr id="80" name="picture 80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rot="21600000">
            <a:off x="3818269" y="719487"/>
            <a:ext cx="121101" cy="99731"/>
          </a:xfrm>
          <a:prstGeom prst="rect">
            <a:avLst/>
          </a:prstGeom>
        </p:spPr>
      </p:pic>
      <p:sp>
        <p:nvSpPr>
          <p:cNvPr id="82" name="textbox 82"/>
          <p:cNvSpPr/>
          <p:nvPr/>
        </p:nvSpPr>
        <p:spPr>
          <a:xfrm rot="16200000">
            <a:off x="5064821" y="7915550"/>
            <a:ext cx="259715" cy="18668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ts val="1270"/>
              </a:lnSpc>
            </a:pP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</a:t>
            </a:r>
            <a:r>
              <a:rPr sz="900" kern="0" spc="-1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I-H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84" name="textbox 84"/>
          <p:cNvSpPr/>
          <p:nvPr/>
        </p:nvSpPr>
        <p:spPr>
          <a:xfrm rot="16200000">
            <a:off x="315261" y="7933009"/>
            <a:ext cx="407034" cy="174625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34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SC-W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86" name="textbox 86"/>
          <p:cNvSpPr/>
          <p:nvPr/>
        </p:nvSpPr>
        <p:spPr>
          <a:xfrm rot="16200000">
            <a:off x="2662193" y="7926484"/>
            <a:ext cx="386079" cy="174625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34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5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SSC-A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88" name="path 88"/>
          <p:cNvSpPr/>
          <p:nvPr/>
        </p:nvSpPr>
        <p:spPr>
          <a:xfrm>
            <a:off x="787161" y="3380165"/>
            <a:ext cx="135349" cy="213709"/>
          </a:xfrm>
          <a:custGeom>
            <a:avLst/>
            <a:gdLst/>
            <a:ahLst/>
            <a:cxnLst/>
            <a:rect l="0" t="0" r="0" b="0"/>
            <a:pathLst>
              <a:path w="213" h="336">
                <a:moveTo>
                  <a:pt x="207" y="330"/>
                </a:moveTo>
                <a:lnTo>
                  <a:pt x="106" y="330"/>
                </a:lnTo>
                <a:moveTo>
                  <a:pt x="207" y="173"/>
                </a:moveTo>
                <a:lnTo>
                  <a:pt x="106" y="173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0" name="path 90"/>
          <p:cNvSpPr/>
          <p:nvPr/>
        </p:nvSpPr>
        <p:spPr>
          <a:xfrm>
            <a:off x="915387" y="787162"/>
            <a:ext cx="7123" cy="3120152"/>
          </a:xfrm>
          <a:custGeom>
            <a:avLst/>
            <a:gdLst/>
            <a:ahLst/>
            <a:cxnLst/>
            <a:rect l="0" t="0" r="0" b="0"/>
            <a:pathLst>
              <a:path w="11" h="4913">
                <a:moveTo>
                  <a:pt x="5" y="4908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2" name="rect 92"/>
          <p:cNvSpPr/>
          <p:nvPr/>
        </p:nvSpPr>
        <p:spPr>
          <a:xfrm>
            <a:off x="3381900" y="7613574"/>
            <a:ext cx="142473" cy="135349"/>
          </a:xfrm>
          <a:prstGeom prst="rect">
            <a:avLst/>
          </a:prstGeom>
          <a:solidFill>
            <a:srgbClr val="FFFFFF">
              <a:alpha val="49803"/>
            </a:srgbClr>
          </a:solidFill>
          <a:ln w="0" cap="flat">
            <a:noFill/>
            <a:prstDash val="solid"/>
            <a:miter lim="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4" name="rect 94"/>
          <p:cNvSpPr/>
          <p:nvPr/>
        </p:nvSpPr>
        <p:spPr>
          <a:xfrm>
            <a:off x="5716958" y="7534850"/>
            <a:ext cx="142472" cy="135349"/>
          </a:xfrm>
          <a:prstGeom prst="rect">
            <a:avLst/>
          </a:prstGeom>
          <a:solidFill>
            <a:srgbClr val="FFFFFF">
              <a:alpha val="49803"/>
            </a:srgbClr>
          </a:solidFill>
          <a:ln w="0" cap="flat">
            <a:noFill/>
            <a:prstDash val="solid"/>
            <a:miter lim="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6" name="rect 96"/>
          <p:cNvSpPr/>
          <p:nvPr/>
        </p:nvSpPr>
        <p:spPr>
          <a:xfrm>
            <a:off x="1098199" y="7602667"/>
            <a:ext cx="142472" cy="135349"/>
          </a:xfrm>
          <a:prstGeom prst="rect">
            <a:avLst/>
          </a:prstGeom>
          <a:solidFill>
            <a:srgbClr val="FFFFFF">
              <a:alpha val="49803"/>
            </a:srgbClr>
          </a:solidFill>
          <a:ln w="0" cap="flat">
            <a:noFill/>
            <a:prstDash val="solid"/>
            <a:miter lim="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8" name="textbox 98"/>
          <p:cNvSpPr/>
          <p:nvPr/>
        </p:nvSpPr>
        <p:spPr>
          <a:xfrm>
            <a:off x="5713715" y="7540575"/>
            <a:ext cx="161289" cy="144145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2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r" rtl="0" eaLnBrk="0">
              <a:lnSpc>
                <a:spcPct val="78000"/>
              </a:lnSpc>
            </a:pPr>
            <a:r>
              <a:rPr sz="1000" kern="0" spc="-9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</a:t>
            </a:r>
            <a:r>
              <a:rPr sz="1000" kern="0" spc="-5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3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100" name="textbox 100"/>
          <p:cNvSpPr/>
          <p:nvPr/>
        </p:nvSpPr>
        <p:spPr>
          <a:xfrm>
            <a:off x="1094927" y="7608361"/>
            <a:ext cx="161289" cy="14477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r" rtl="0" eaLnBrk="0">
              <a:lnSpc>
                <a:spcPct val="78000"/>
              </a:lnSpc>
            </a:pPr>
            <a:r>
              <a:rPr sz="1000" kern="0" spc="-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1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102" name="textbox 102"/>
          <p:cNvSpPr/>
          <p:nvPr/>
        </p:nvSpPr>
        <p:spPr>
          <a:xfrm>
            <a:off x="3378609" y="7619269"/>
            <a:ext cx="161289" cy="14477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r" rtl="0" eaLnBrk="0">
              <a:lnSpc>
                <a:spcPct val="78000"/>
              </a:lnSpc>
            </a:pPr>
            <a:r>
              <a:rPr sz="1000" kern="0" spc="-8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</a:t>
            </a: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104" name="path 104"/>
          <p:cNvSpPr/>
          <p:nvPr/>
        </p:nvSpPr>
        <p:spPr>
          <a:xfrm>
            <a:off x="758667" y="8608915"/>
            <a:ext cx="121101" cy="7123"/>
          </a:xfrm>
          <a:custGeom>
            <a:avLst/>
            <a:gdLst/>
            <a:ahLst/>
            <a:cxnLst/>
            <a:rect l="0" t="0" r="0" b="0"/>
            <a:pathLst>
              <a:path w="190" h="11"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06" name="path 106"/>
          <p:cNvSpPr/>
          <p:nvPr/>
        </p:nvSpPr>
        <p:spPr>
          <a:xfrm>
            <a:off x="815656" y="8559049"/>
            <a:ext cx="64112" cy="7123"/>
          </a:xfrm>
          <a:custGeom>
            <a:avLst/>
            <a:gdLst/>
            <a:ahLst/>
            <a:cxnLst/>
            <a:rect l="0" t="0" r="0" b="0"/>
            <a:pathLst>
              <a:path w="100" h="11">
                <a:moveTo>
                  <a:pt x="9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08" name="path 108"/>
          <p:cNvSpPr/>
          <p:nvPr/>
        </p:nvSpPr>
        <p:spPr>
          <a:xfrm>
            <a:off x="872645" y="7426391"/>
            <a:ext cx="7123" cy="1189647"/>
          </a:xfrm>
          <a:custGeom>
            <a:avLst/>
            <a:gdLst/>
            <a:ahLst/>
            <a:cxnLst/>
            <a:rect l="0" t="0" r="0" b="0"/>
            <a:pathLst>
              <a:path w="11" h="1873">
                <a:moveTo>
                  <a:pt x="5" y="1867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2"/>
          <p:cNvGrpSpPr/>
          <p:nvPr/>
        </p:nvGrpSpPr>
        <p:grpSpPr>
          <a:xfrm rot="21600000">
            <a:off x="787161" y="709514"/>
            <a:ext cx="3758357" cy="3326026"/>
            <a:chOff x="0" y="0"/>
            <a:chExt cx="3758357" cy="3326026"/>
          </a:xfrm>
        </p:grpSpPr>
        <p:grpSp>
          <p:nvGrpSpPr>
            <p:cNvPr id="4" name="group 4"/>
            <p:cNvGrpSpPr/>
            <p:nvPr/>
          </p:nvGrpSpPr>
          <p:grpSpPr>
            <a:xfrm rot="21600000">
              <a:off x="128225" y="832036"/>
              <a:ext cx="3630131" cy="2365764"/>
              <a:chOff x="0" y="0"/>
              <a:chExt cx="3630131" cy="2365764"/>
            </a:xfrm>
          </p:grpSpPr>
          <p:sp>
            <p:nvSpPr>
              <p:cNvPr id="3" name="path 2"/>
              <p:cNvSpPr/>
              <p:nvPr/>
            </p:nvSpPr>
            <p:spPr>
              <a:xfrm>
                <a:off x="9187" y="0"/>
                <a:ext cx="3620944" cy="2364228"/>
              </a:xfrm>
              <a:custGeom>
                <a:avLst/>
                <a:gdLst/>
                <a:ahLst/>
                <a:cxnLst/>
                <a:rect l="0" t="0" r="0" b="0"/>
                <a:pathLst>
                  <a:path w="5702" h="3723">
                    <a:moveTo>
                      <a:pt x="7" y="3715"/>
                    </a:moveTo>
                    <a:lnTo>
                      <a:pt x="35" y="3715"/>
                    </a:lnTo>
                    <a:lnTo>
                      <a:pt x="64" y="3715"/>
                    </a:lnTo>
                    <a:lnTo>
                      <a:pt x="92" y="3715"/>
                    </a:lnTo>
                    <a:lnTo>
                      <a:pt x="121" y="3715"/>
                    </a:lnTo>
                    <a:lnTo>
                      <a:pt x="149" y="3715"/>
                    </a:lnTo>
                    <a:lnTo>
                      <a:pt x="177" y="3715"/>
                    </a:lnTo>
                    <a:lnTo>
                      <a:pt x="206" y="3715"/>
                    </a:lnTo>
                    <a:lnTo>
                      <a:pt x="234" y="3715"/>
                    </a:lnTo>
                    <a:lnTo>
                      <a:pt x="263" y="3715"/>
                    </a:lnTo>
                    <a:lnTo>
                      <a:pt x="291" y="3715"/>
                    </a:lnTo>
                    <a:lnTo>
                      <a:pt x="320" y="3715"/>
                    </a:lnTo>
                    <a:lnTo>
                      <a:pt x="348" y="3715"/>
                    </a:lnTo>
                    <a:lnTo>
                      <a:pt x="376" y="3715"/>
                    </a:lnTo>
                    <a:lnTo>
                      <a:pt x="405" y="3715"/>
                    </a:lnTo>
                    <a:lnTo>
                      <a:pt x="433" y="3715"/>
                    </a:lnTo>
                    <a:lnTo>
                      <a:pt x="462" y="3715"/>
                    </a:lnTo>
                    <a:lnTo>
                      <a:pt x="490" y="3715"/>
                    </a:lnTo>
                    <a:lnTo>
                      <a:pt x="519" y="3715"/>
                    </a:lnTo>
                    <a:lnTo>
                      <a:pt x="547" y="3715"/>
                    </a:lnTo>
                    <a:lnTo>
                      <a:pt x="576" y="3715"/>
                    </a:lnTo>
                    <a:lnTo>
                      <a:pt x="604" y="3715"/>
                    </a:lnTo>
                    <a:lnTo>
                      <a:pt x="632" y="3715"/>
                    </a:lnTo>
                    <a:lnTo>
                      <a:pt x="661" y="3715"/>
                    </a:lnTo>
                    <a:lnTo>
                      <a:pt x="689" y="3715"/>
                    </a:lnTo>
                    <a:lnTo>
                      <a:pt x="718" y="3715"/>
                    </a:lnTo>
                    <a:lnTo>
                      <a:pt x="746" y="3715"/>
                    </a:lnTo>
                    <a:lnTo>
                      <a:pt x="775" y="3715"/>
                    </a:lnTo>
                    <a:lnTo>
                      <a:pt x="803" y="3715"/>
                    </a:lnTo>
                    <a:lnTo>
                      <a:pt x="832" y="3715"/>
                    </a:lnTo>
                    <a:lnTo>
                      <a:pt x="860" y="3715"/>
                    </a:lnTo>
                    <a:lnTo>
                      <a:pt x="888" y="3715"/>
                    </a:lnTo>
                    <a:lnTo>
                      <a:pt x="917" y="3715"/>
                    </a:lnTo>
                    <a:lnTo>
                      <a:pt x="945" y="3715"/>
                    </a:lnTo>
                    <a:lnTo>
                      <a:pt x="974" y="3715"/>
                    </a:lnTo>
                    <a:lnTo>
                      <a:pt x="1002" y="3715"/>
                    </a:lnTo>
                    <a:lnTo>
                      <a:pt x="1031" y="3715"/>
                    </a:lnTo>
                    <a:lnTo>
                      <a:pt x="1059" y="3715"/>
                    </a:lnTo>
                    <a:lnTo>
                      <a:pt x="1087" y="3715"/>
                    </a:lnTo>
                    <a:lnTo>
                      <a:pt x="1116" y="3715"/>
                    </a:lnTo>
                    <a:lnTo>
                      <a:pt x="1144" y="3715"/>
                    </a:lnTo>
                    <a:lnTo>
                      <a:pt x="1173" y="3715"/>
                    </a:lnTo>
                    <a:lnTo>
                      <a:pt x="1201" y="3714"/>
                    </a:lnTo>
                    <a:lnTo>
                      <a:pt x="1230" y="3715"/>
                    </a:lnTo>
                    <a:lnTo>
                      <a:pt x="1258" y="3712"/>
                    </a:lnTo>
                    <a:lnTo>
                      <a:pt x="1287" y="3714"/>
                    </a:lnTo>
                    <a:lnTo>
                      <a:pt x="1315" y="3715"/>
                    </a:lnTo>
                    <a:lnTo>
                      <a:pt x="1343" y="3711"/>
                    </a:lnTo>
                    <a:lnTo>
                      <a:pt x="1372" y="3713"/>
                    </a:lnTo>
                    <a:lnTo>
                      <a:pt x="1400" y="3715"/>
                    </a:lnTo>
                    <a:lnTo>
                      <a:pt x="1429" y="3713"/>
                    </a:lnTo>
                    <a:lnTo>
                      <a:pt x="1457" y="3713"/>
                    </a:lnTo>
                    <a:lnTo>
                      <a:pt x="1486" y="3712"/>
                    </a:lnTo>
                    <a:lnTo>
                      <a:pt x="1514" y="3713"/>
                    </a:lnTo>
                    <a:lnTo>
                      <a:pt x="1542" y="3713"/>
                    </a:lnTo>
                    <a:lnTo>
                      <a:pt x="1571" y="3712"/>
                    </a:lnTo>
                    <a:lnTo>
                      <a:pt x="1599" y="3712"/>
                    </a:lnTo>
                    <a:lnTo>
                      <a:pt x="1628" y="3708"/>
                    </a:lnTo>
                    <a:lnTo>
                      <a:pt x="1656" y="3711"/>
                    </a:lnTo>
                    <a:lnTo>
                      <a:pt x="1685" y="3701"/>
                    </a:lnTo>
                    <a:moveTo>
                      <a:pt x="1912" y="2955"/>
                    </a:moveTo>
                    <a:lnTo>
                      <a:pt x="1941" y="2681"/>
                    </a:lnTo>
                    <a:lnTo>
                      <a:pt x="1969" y="2184"/>
                    </a:lnTo>
                    <a:lnTo>
                      <a:pt x="1997" y="1785"/>
                    </a:lnTo>
                    <a:lnTo>
                      <a:pt x="2026" y="1009"/>
                    </a:lnTo>
                    <a:lnTo>
                      <a:pt x="2054" y="100"/>
                    </a:lnTo>
                    <a:moveTo>
                      <a:pt x="2140" y="7"/>
                    </a:moveTo>
                    <a:lnTo>
                      <a:pt x="2168" y="1324"/>
                    </a:lnTo>
                    <a:lnTo>
                      <a:pt x="2197" y="2557"/>
                    </a:lnTo>
                    <a:lnTo>
                      <a:pt x="2225" y="3220"/>
                    </a:lnTo>
                    <a:lnTo>
                      <a:pt x="2253" y="3510"/>
                    </a:lnTo>
                    <a:lnTo>
                      <a:pt x="2282" y="3607"/>
                    </a:lnTo>
                    <a:lnTo>
                      <a:pt x="2310" y="3663"/>
                    </a:lnTo>
                    <a:lnTo>
                      <a:pt x="2339" y="3676"/>
                    </a:lnTo>
                    <a:lnTo>
                      <a:pt x="2367" y="3672"/>
                    </a:lnTo>
                    <a:lnTo>
                      <a:pt x="2396" y="3685"/>
                    </a:lnTo>
                    <a:moveTo>
                      <a:pt x="2623" y="3700"/>
                    </a:moveTo>
                    <a:lnTo>
                      <a:pt x="2652" y="3707"/>
                    </a:lnTo>
                    <a:lnTo>
                      <a:pt x="2680" y="3709"/>
                    </a:lnTo>
                    <a:lnTo>
                      <a:pt x="2708" y="3699"/>
                    </a:lnTo>
                    <a:lnTo>
                      <a:pt x="2737" y="3709"/>
                    </a:lnTo>
                    <a:lnTo>
                      <a:pt x="2765" y="3703"/>
                    </a:lnTo>
                    <a:lnTo>
                      <a:pt x="2794" y="3708"/>
                    </a:lnTo>
                    <a:lnTo>
                      <a:pt x="2822" y="3705"/>
                    </a:lnTo>
                    <a:moveTo>
                      <a:pt x="2879" y="3695"/>
                    </a:moveTo>
                    <a:lnTo>
                      <a:pt x="2908" y="3711"/>
                    </a:lnTo>
                    <a:lnTo>
                      <a:pt x="2936" y="3711"/>
                    </a:lnTo>
                    <a:lnTo>
                      <a:pt x="2964" y="3708"/>
                    </a:lnTo>
                    <a:lnTo>
                      <a:pt x="2993" y="3709"/>
                    </a:lnTo>
                    <a:lnTo>
                      <a:pt x="3021" y="3706"/>
                    </a:lnTo>
                    <a:lnTo>
                      <a:pt x="3050" y="3705"/>
                    </a:lnTo>
                    <a:lnTo>
                      <a:pt x="3078" y="3712"/>
                    </a:lnTo>
                    <a:lnTo>
                      <a:pt x="3107" y="3701"/>
                    </a:lnTo>
                    <a:lnTo>
                      <a:pt x="3135" y="3710"/>
                    </a:lnTo>
                    <a:lnTo>
                      <a:pt x="3163" y="3707"/>
                    </a:lnTo>
                    <a:lnTo>
                      <a:pt x="3192" y="3707"/>
                    </a:lnTo>
                    <a:lnTo>
                      <a:pt x="3220" y="3700"/>
                    </a:lnTo>
                    <a:moveTo>
                      <a:pt x="3249" y="3703"/>
                    </a:moveTo>
                    <a:lnTo>
                      <a:pt x="3277" y="3710"/>
                    </a:lnTo>
                    <a:lnTo>
                      <a:pt x="3306" y="3705"/>
                    </a:lnTo>
                    <a:moveTo>
                      <a:pt x="3363" y="3705"/>
                    </a:moveTo>
                    <a:lnTo>
                      <a:pt x="3391" y="3710"/>
                    </a:lnTo>
                    <a:lnTo>
                      <a:pt x="3419" y="3706"/>
                    </a:lnTo>
                    <a:lnTo>
                      <a:pt x="3448" y="3711"/>
                    </a:lnTo>
                    <a:lnTo>
                      <a:pt x="3476" y="3707"/>
                    </a:lnTo>
                    <a:lnTo>
                      <a:pt x="3505" y="3709"/>
                    </a:lnTo>
                    <a:lnTo>
                      <a:pt x="3533" y="3705"/>
                    </a:lnTo>
                    <a:moveTo>
                      <a:pt x="3732" y="3686"/>
                    </a:moveTo>
                    <a:lnTo>
                      <a:pt x="3761" y="3688"/>
                    </a:lnTo>
                    <a:lnTo>
                      <a:pt x="3789" y="3691"/>
                    </a:lnTo>
                    <a:lnTo>
                      <a:pt x="3818" y="3677"/>
                    </a:lnTo>
                    <a:lnTo>
                      <a:pt x="3846" y="3681"/>
                    </a:lnTo>
                    <a:lnTo>
                      <a:pt x="3874" y="3665"/>
                    </a:lnTo>
                    <a:lnTo>
                      <a:pt x="3903" y="3669"/>
                    </a:lnTo>
                    <a:lnTo>
                      <a:pt x="3931" y="3677"/>
                    </a:lnTo>
                    <a:lnTo>
                      <a:pt x="3960" y="3643"/>
                    </a:lnTo>
                    <a:lnTo>
                      <a:pt x="3988" y="3636"/>
                    </a:lnTo>
                    <a:lnTo>
                      <a:pt x="4017" y="3635"/>
                    </a:lnTo>
                    <a:lnTo>
                      <a:pt x="4045" y="3605"/>
                    </a:lnTo>
                    <a:lnTo>
                      <a:pt x="4073" y="3624"/>
                    </a:lnTo>
                    <a:lnTo>
                      <a:pt x="4102" y="3633"/>
                    </a:lnTo>
                    <a:lnTo>
                      <a:pt x="4130" y="3593"/>
                    </a:lnTo>
                    <a:moveTo>
                      <a:pt x="4159" y="3598"/>
                    </a:moveTo>
                    <a:lnTo>
                      <a:pt x="4187" y="3621"/>
                    </a:lnTo>
                    <a:moveTo>
                      <a:pt x="4244" y="3640"/>
                    </a:moveTo>
                    <a:lnTo>
                      <a:pt x="4273" y="3650"/>
                    </a:lnTo>
                    <a:moveTo>
                      <a:pt x="4301" y="3664"/>
                    </a:moveTo>
                    <a:lnTo>
                      <a:pt x="4329" y="3684"/>
                    </a:lnTo>
                    <a:lnTo>
                      <a:pt x="4358" y="3694"/>
                    </a:lnTo>
                    <a:lnTo>
                      <a:pt x="4386" y="3690"/>
                    </a:lnTo>
                    <a:lnTo>
                      <a:pt x="4415" y="3705"/>
                    </a:lnTo>
                    <a:lnTo>
                      <a:pt x="4443" y="3708"/>
                    </a:lnTo>
                    <a:lnTo>
                      <a:pt x="4472" y="3709"/>
                    </a:lnTo>
                    <a:lnTo>
                      <a:pt x="4500" y="3707"/>
                    </a:lnTo>
                    <a:lnTo>
                      <a:pt x="4529" y="3713"/>
                    </a:lnTo>
                    <a:lnTo>
                      <a:pt x="4557" y="3711"/>
                    </a:lnTo>
                    <a:lnTo>
                      <a:pt x="4585" y="3714"/>
                    </a:lnTo>
                    <a:lnTo>
                      <a:pt x="4614" y="3714"/>
                    </a:lnTo>
                    <a:lnTo>
                      <a:pt x="4642" y="3713"/>
                    </a:lnTo>
                    <a:lnTo>
                      <a:pt x="4671" y="3711"/>
                    </a:lnTo>
                    <a:lnTo>
                      <a:pt x="4699" y="3715"/>
                    </a:lnTo>
                    <a:lnTo>
                      <a:pt x="4728" y="3714"/>
                    </a:lnTo>
                    <a:lnTo>
                      <a:pt x="4756" y="3714"/>
                    </a:lnTo>
                    <a:lnTo>
                      <a:pt x="4784" y="3714"/>
                    </a:lnTo>
                    <a:lnTo>
                      <a:pt x="4813" y="3715"/>
                    </a:lnTo>
                    <a:lnTo>
                      <a:pt x="4841" y="3713"/>
                    </a:lnTo>
                    <a:lnTo>
                      <a:pt x="4870" y="3713"/>
                    </a:lnTo>
                    <a:lnTo>
                      <a:pt x="4898" y="3714"/>
                    </a:lnTo>
                    <a:lnTo>
                      <a:pt x="4927" y="3715"/>
                    </a:lnTo>
                    <a:lnTo>
                      <a:pt x="4955" y="3715"/>
                    </a:lnTo>
                    <a:lnTo>
                      <a:pt x="4984" y="3713"/>
                    </a:lnTo>
                    <a:lnTo>
                      <a:pt x="5012" y="3715"/>
                    </a:lnTo>
                    <a:lnTo>
                      <a:pt x="5040" y="3714"/>
                    </a:lnTo>
                    <a:lnTo>
                      <a:pt x="5069" y="3715"/>
                    </a:lnTo>
                    <a:lnTo>
                      <a:pt x="5097" y="3715"/>
                    </a:lnTo>
                    <a:lnTo>
                      <a:pt x="5126" y="3714"/>
                    </a:lnTo>
                    <a:lnTo>
                      <a:pt x="5154" y="3715"/>
                    </a:lnTo>
                    <a:lnTo>
                      <a:pt x="5183" y="3715"/>
                    </a:lnTo>
                    <a:lnTo>
                      <a:pt x="5211" y="3715"/>
                    </a:lnTo>
                    <a:lnTo>
                      <a:pt x="5239" y="3715"/>
                    </a:lnTo>
                    <a:lnTo>
                      <a:pt x="5268" y="3714"/>
                    </a:lnTo>
                    <a:lnTo>
                      <a:pt x="5296" y="3715"/>
                    </a:lnTo>
                    <a:lnTo>
                      <a:pt x="5325" y="3715"/>
                    </a:lnTo>
                    <a:lnTo>
                      <a:pt x="5353" y="3715"/>
                    </a:lnTo>
                    <a:lnTo>
                      <a:pt x="5382" y="3715"/>
                    </a:lnTo>
                    <a:lnTo>
                      <a:pt x="5410" y="3715"/>
                    </a:lnTo>
                    <a:lnTo>
                      <a:pt x="5439" y="3715"/>
                    </a:lnTo>
                    <a:lnTo>
                      <a:pt x="5467" y="3715"/>
                    </a:lnTo>
                    <a:lnTo>
                      <a:pt x="5495" y="3715"/>
                    </a:lnTo>
                    <a:lnTo>
                      <a:pt x="5524" y="3715"/>
                    </a:lnTo>
                    <a:lnTo>
                      <a:pt x="5552" y="3715"/>
                    </a:lnTo>
                    <a:lnTo>
                      <a:pt x="5581" y="3715"/>
                    </a:lnTo>
                    <a:lnTo>
                      <a:pt x="5609" y="3715"/>
                    </a:lnTo>
                    <a:lnTo>
                      <a:pt x="5638" y="3715"/>
                    </a:lnTo>
                    <a:lnTo>
                      <a:pt x="5666" y="3715"/>
                    </a:lnTo>
                    <a:lnTo>
                      <a:pt x="5694" y="3715"/>
                    </a:lnTo>
                  </a:path>
                </a:pathLst>
              </a:custGeom>
              <a:noFill/>
              <a:ln w="9260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/>
              <a:lstStyle/>
              <a:p>
                <a:pPr algn="ctr"/>
                <a:endParaRPr lang="zh-CN" altLang="en-US"/>
              </a:p>
            </p:txBody>
          </p:sp>
          <p:sp>
            <p:nvSpPr>
              <p:cNvPr id="5" name="path 4"/>
              <p:cNvSpPr/>
              <p:nvPr/>
            </p:nvSpPr>
            <p:spPr>
              <a:xfrm>
                <a:off x="0" y="2358640"/>
                <a:ext cx="3625931" cy="7123"/>
              </a:xfrm>
              <a:custGeom>
                <a:avLst/>
                <a:gdLst/>
                <a:ahLst/>
                <a:cxnLst/>
                <a:rect l="0" t="0" r="0" b="0"/>
                <a:pathLst>
                  <a:path w="5710" h="11">
                    <a:moveTo>
                      <a:pt x="5" y="5"/>
                    </a:moveTo>
                    <a:lnTo>
                      <a:pt x="5704" y="5"/>
                    </a:lnTo>
                  </a:path>
                </a:pathLst>
              </a:custGeom>
              <a:noFill/>
              <a:ln w="7123" cap="sq">
                <a:solidFill>
                  <a:srgbClr val="000000"/>
                </a:solidFill>
                <a:prstDash val="solid"/>
                <a:bevel/>
              </a:ln>
            </p:spPr>
            <p:txBody>
              <a:bodyPr rtlCol="0"/>
              <a:lstStyle/>
              <a:p>
                <a:pPr algn="ctr"/>
                <a:endParaRPr lang="zh-CN" altLang="en-US"/>
              </a:p>
            </p:txBody>
          </p:sp>
        </p:grpSp>
        <p:pic>
          <p:nvPicPr>
            <p:cNvPr id="6" name="picture 6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 rot="21600000">
              <a:off x="142042" y="527625"/>
              <a:ext cx="3611684" cy="2664008"/>
            </a:xfrm>
            <a:prstGeom prst="rect">
              <a:avLst/>
            </a:prstGeom>
          </p:spPr>
        </p:pic>
        <p:pic>
          <p:nvPicPr>
            <p:cNvPr id="8" name="picture 8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21600000">
              <a:off x="1293151" y="2703862"/>
              <a:ext cx="2461005" cy="622163"/>
            </a:xfrm>
            <a:prstGeom prst="rect">
              <a:avLst/>
            </a:prstGeom>
          </p:spPr>
        </p:pic>
        <p:sp>
          <p:nvSpPr>
            <p:cNvPr id="10" name="path 10"/>
            <p:cNvSpPr/>
            <p:nvPr/>
          </p:nvSpPr>
          <p:spPr>
            <a:xfrm>
              <a:off x="128225" y="3190677"/>
              <a:ext cx="7123" cy="135349"/>
            </a:xfrm>
            <a:custGeom>
              <a:avLst/>
              <a:gdLst/>
              <a:ahLst/>
              <a:cxnLst/>
              <a:rect l="0" t="0" r="0" b="0"/>
              <a:pathLst>
                <a:path w="11" h="213">
                  <a:moveTo>
                    <a:pt x="5" y="5"/>
                  </a:moveTo>
                  <a:lnTo>
                    <a:pt x="5" y="207"/>
                  </a:lnTo>
                </a:path>
              </a:pathLst>
            </a:custGeom>
            <a:noFill/>
            <a:ln w="7123" cap="sq">
              <a:solidFill>
                <a:srgbClr val="000000"/>
              </a:solidFill>
              <a:prstDash val="solid"/>
              <a:bevel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  <p:sp>
          <p:nvSpPr>
            <p:cNvPr id="12" name="path 12"/>
            <p:cNvSpPr/>
            <p:nvPr/>
          </p:nvSpPr>
          <p:spPr>
            <a:xfrm>
              <a:off x="0" y="3190677"/>
              <a:ext cx="135349" cy="7123"/>
            </a:xfrm>
            <a:custGeom>
              <a:avLst/>
              <a:gdLst/>
              <a:ahLst/>
              <a:cxnLst/>
              <a:rect l="0" t="0" r="0" b="0"/>
              <a:pathLst>
                <a:path w="213" h="11">
                  <a:moveTo>
                    <a:pt x="207" y="5"/>
                  </a:moveTo>
                  <a:lnTo>
                    <a:pt x="5" y="5"/>
                  </a:lnTo>
                </a:path>
              </a:pathLst>
            </a:custGeom>
            <a:noFill/>
            <a:ln w="7123" cap="sq">
              <a:solidFill>
                <a:srgbClr val="000000"/>
              </a:solidFill>
              <a:prstDash val="solid"/>
              <a:bevel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  <p:sp>
          <p:nvSpPr>
            <p:cNvPr id="14" name="path 14"/>
            <p:cNvSpPr/>
            <p:nvPr/>
          </p:nvSpPr>
          <p:spPr>
            <a:xfrm>
              <a:off x="0" y="2499684"/>
              <a:ext cx="135349" cy="562767"/>
            </a:xfrm>
            <a:custGeom>
              <a:avLst/>
              <a:gdLst/>
              <a:ahLst/>
              <a:cxnLst/>
              <a:rect l="0" t="0" r="0" b="0"/>
              <a:pathLst>
                <a:path w="213" h="886">
                  <a:moveTo>
                    <a:pt x="207" y="880"/>
                  </a:moveTo>
                  <a:lnTo>
                    <a:pt x="106" y="880"/>
                  </a:lnTo>
                  <a:moveTo>
                    <a:pt x="207" y="656"/>
                  </a:moveTo>
                  <a:lnTo>
                    <a:pt x="106" y="656"/>
                  </a:lnTo>
                  <a:moveTo>
                    <a:pt x="207" y="443"/>
                  </a:moveTo>
                  <a:lnTo>
                    <a:pt x="106" y="443"/>
                  </a:lnTo>
                  <a:moveTo>
                    <a:pt x="207" y="218"/>
                  </a:moveTo>
                  <a:lnTo>
                    <a:pt x="106" y="218"/>
                  </a:lnTo>
                  <a:moveTo>
                    <a:pt x="207" y="5"/>
                  </a:moveTo>
                  <a:lnTo>
                    <a:pt x="5" y="5"/>
                  </a:lnTo>
                </a:path>
              </a:pathLst>
            </a:custGeom>
            <a:noFill/>
            <a:ln w="7123" cap="sq">
              <a:solidFill>
                <a:srgbClr val="000000"/>
              </a:solidFill>
              <a:prstDash val="solid"/>
              <a:bevel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  <p:sp>
          <p:nvSpPr>
            <p:cNvPr id="16" name="path 16"/>
            <p:cNvSpPr/>
            <p:nvPr/>
          </p:nvSpPr>
          <p:spPr>
            <a:xfrm>
              <a:off x="0" y="426705"/>
              <a:ext cx="135349" cy="555644"/>
            </a:xfrm>
            <a:custGeom>
              <a:avLst/>
              <a:gdLst/>
              <a:ahLst/>
              <a:cxnLst/>
              <a:rect l="0" t="0" r="0" b="0"/>
              <a:pathLst>
                <a:path w="213" h="875">
                  <a:moveTo>
                    <a:pt x="207" y="869"/>
                  </a:moveTo>
                  <a:lnTo>
                    <a:pt x="106" y="869"/>
                  </a:lnTo>
                  <a:moveTo>
                    <a:pt x="207" y="656"/>
                  </a:moveTo>
                  <a:lnTo>
                    <a:pt x="106" y="656"/>
                  </a:lnTo>
                  <a:moveTo>
                    <a:pt x="207" y="431"/>
                  </a:moveTo>
                  <a:lnTo>
                    <a:pt x="106" y="431"/>
                  </a:lnTo>
                  <a:moveTo>
                    <a:pt x="207" y="218"/>
                  </a:moveTo>
                  <a:lnTo>
                    <a:pt x="106" y="218"/>
                  </a:lnTo>
                  <a:moveTo>
                    <a:pt x="207" y="5"/>
                  </a:moveTo>
                  <a:lnTo>
                    <a:pt x="5" y="5"/>
                  </a:lnTo>
                </a:path>
              </a:pathLst>
            </a:custGeom>
            <a:noFill/>
            <a:ln w="7123" cap="sq">
              <a:solidFill>
                <a:srgbClr val="000000"/>
              </a:solidFill>
              <a:prstDash val="solid"/>
              <a:bevel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  <p:sp>
          <p:nvSpPr>
            <p:cNvPr id="18" name="path 18"/>
            <p:cNvSpPr/>
            <p:nvPr/>
          </p:nvSpPr>
          <p:spPr>
            <a:xfrm>
              <a:off x="0" y="1808691"/>
              <a:ext cx="135349" cy="555643"/>
            </a:xfrm>
            <a:custGeom>
              <a:avLst/>
              <a:gdLst/>
              <a:ahLst/>
              <a:cxnLst/>
              <a:rect l="0" t="0" r="0" b="0"/>
              <a:pathLst>
                <a:path w="213" h="875">
                  <a:moveTo>
                    <a:pt x="207" y="869"/>
                  </a:moveTo>
                  <a:lnTo>
                    <a:pt x="106" y="869"/>
                  </a:lnTo>
                  <a:moveTo>
                    <a:pt x="207" y="656"/>
                  </a:moveTo>
                  <a:lnTo>
                    <a:pt x="106" y="656"/>
                  </a:lnTo>
                  <a:moveTo>
                    <a:pt x="207" y="443"/>
                  </a:moveTo>
                  <a:lnTo>
                    <a:pt x="106" y="443"/>
                  </a:lnTo>
                  <a:moveTo>
                    <a:pt x="207" y="218"/>
                  </a:moveTo>
                  <a:lnTo>
                    <a:pt x="106" y="218"/>
                  </a:lnTo>
                  <a:moveTo>
                    <a:pt x="207" y="5"/>
                  </a:moveTo>
                  <a:lnTo>
                    <a:pt x="5" y="5"/>
                  </a:lnTo>
                </a:path>
              </a:pathLst>
            </a:custGeom>
            <a:noFill/>
            <a:ln w="7123" cap="sq">
              <a:solidFill>
                <a:srgbClr val="000000"/>
              </a:solidFill>
              <a:prstDash val="solid"/>
              <a:bevel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  <p:sp>
          <p:nvSpPr>
            <p:cNvPr id="20" name="path 20"/>
            <p:cNvSpPr/>
            <p:nvPr/>
          </p:nvSpPr>
          <p:spPr>
            <a:xfrm>
              <a:off x="0" y="1117699"/>
              <a:ext cx="135349" cy="555643"/>
            </a:xfrm>
            <a:custGeom>
              <a:avLst/>
              <a:gdLst/>
              <a:ahLst/>
              <a:cxnLst/>
              <a:rect l="0" t="0" r="0" b="0"/>
              <a:pathLst>
                <a:path w="213" h="875">
                  <a:moveTo>
                    <a:pt x="207" y="869"/>
                  </a:moveTo>
                  <a:lnTo>
                    <a:pt x="106" y="869"/>
                  </a:lnTo>
                  <a:moveTo>
                    <a:pt x="207" y="656"/>
                  </a:moveTo>
                  <a:lnTo>
                    <a:pt x="106" y="656"/>
                  </a:lnTo>
                  <a:moveTo>
                    <a:pt x="207" y="443"/>
                  </a:moveTo>
                  <a:lnTo>
                    <a:pt x="106" y="443"/>
                  </a:lnTo>
                  <a:moveTo>
                    <a:pt x="207" y="218"/>
                  </a:moveTo>
                  <a:lnTo>
                    <a:pt x="106" y="218"/>
                  </a:lnTo>
                  <a:moveTo>
                    <a:pt x="207" y="5"/>
                  </a:moveTo>
                  <a:lnTo>
                    <a:pt x="5" y="5"/>
                  </a:lnTo>
                </a:path>
              </a:pathLst>
            </a:custGeom>
            <a:noFill/>
            <a:ln w="7123" cap="sq">
              <a:solidFill>
                <a:srgbClr val="000000"/>
              </a:solidFill>
              <a:prstDash val="solid"/>
              <a:bevel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  <p:sp>
          <p:nvSpPr>
            <p:cNvPr id="22" name="path 22"/>
            <p:cNvSpPr/>
            <p:nvPr/>
          </p:nvSpPr>
          <p:spPr>
            <a:xfrm>
              <a:off x="64112" y="77647"/>
              <a:ext cx="71236" cy="3120152"/>
            </a:xfrm>
            <a:custGeom>
              <a:avLst/>
              <a:gdLst/>
              <a:ahLst/>
              <a:cxnLst/>
              <a:rect l="0" t="0" r="0" b="0"/>
              <a:pathLst>
                <a:path w="112" h="4913">
                  <a:moveTo>
                    <a:pt x="106" y="330"/>
                  </a:moveTo>
                  <a:lnTo>
                    <a:pt x="5" y="330"/>
                  </a:lnTo>
                  <a:moveTo>
                    <a:pt x="106" y="117"/>
                  </a:moveTo>
                  <a:lnTo>
                    <a:pt x="5" y="117"/>
                  </a:lnTo>
                  <a:moveTo>
                    <a:pt x="106" y="4908"/>
                  </a:moveTo>
                  <a:lnTo>
                    <a:pt x="106" y="5"/>
                  </a:lnTo>
                </a:path>
              </a:pathLst>
            </a:custGeom>
            <a:noFill/>
            <a:ln w="7123" cap="sq">
              <a:solidFill>
                <a:srgbClr val="000000"/>
              </a:solidFill>
              <a:prstDash val="solid"/>
              <a:bevel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  <p:sp>
          <p:nvSpPr>
            <p:cNvPr id="24" name="path 24"/>
            <p:cNvSpPr/>
            <p:nvPr/>
          </p:nvSpPr>
          <p:spPr>
            <a:xfrm>
              <a:off x="306316" y="3190677"/>
              <a:ext cx="733734" cy="135349"/>
            </a:xfrm>
            <a:custGeom>
              <a:avLst/>
              <a:gdLst/>
              <a:ahLst/>
              <a:cxnLst/>
              <a:rect l="0" t="0" r="0" b="0"/>
              <a:pathLst>
                <a:path w="1155" h="213">
                  <a:moveTo>
                    <a:pt x="5" y="5"/>
                  </a:moveTo>
                  <a:lnTo>
                    <a:pt x="5" y="106"/>
                  </a:lnTo>
                  <a:moveTo>
                    <a:pt x="297" y="5"/>
                  </a:moveTo>
                  <a:lnTo>
                    <a:pt x="297" y="106"/>
                  </a:lnTo>
                  <a:moveTo>
                    <a:pt x="577" y="5"/>
                  </a:moveTo>
                  <a:lnTo>
                    <a:pt x="577" y="106"/>
                  </a:lnTo>
                  <a:moveTo>
                    <a:pt x="869" y="5"/>
                  </a:moveTo>
                  <a:lnTo>
                    <a:pt x="869" y="106"/>
                  </a:lnTo>
                  <a:moveTo>
                    <a:pt x="1149" y="5"/>
                  </a:moveTo>
                  <a:lnTo>
                    <a:pt x="1149" y="207"/>
                  </a:lnTo>
                </a:path>
              </a:pathLst>
            </a:custGeom>
            <a:noFill/>
            <a:ln w="7123" cap="sq">
              <a:solidFill>
                <a:srgbClr val="000000"/>
              </a:solidFill>
              <a:prstDash val="solid"/>
              <a:bevel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  <p:sp>
          <p:nvSpPr>
            <p:cNvPr id="26" name="textbox 26"/>
            <p:cNvSpPr/>
            <p:nvPr/>
          </p:nvSpPr>
          <p:spPr>
            <a:xfrm>
              <a:off x="3018407" y="-12700"/>
              <a:ext cx="434975" cy="161289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algn="l" rtl="0" eaLnBrk="0">
                <a:lnSpc>
                  <a:spcPct val="83000"/>
                </a:lnSpc>
              </a:pPr>
              <a:endParaRPr sz="100" dirty="0">
                <a:latin typeface="Arial" panose="020B0604020202020204"/>
                <a:ea typeface="Arial" panose="020B0604020202020204"/>
                <a:cs typeface="Arial" panose="020B0604020202020204"/>
              </a:endParaRPr>
            </a:p>
            <a:p>
              <a:pPr marL="133350" algn="l" rtl="0" eaLnBrk="0">
                <a:lnSpc>
                  <a:spcPts val="1065"/>
                </a:lnSpc>
                <a:tabLst>
                  <a:tab pos="198120" algn="l"/>
                </a:tabLst>
              </a:pPr>
              <a:r>
                <a:rPr sz="800" kern="0" spc="0" dirty="0">
                  <a:solidFill>
                    <a:srgbClr val="0000FF">
                      <a:alpha val="100000"/>
                    </a:srgbClr>
                  </a:solidFill>
                  <a:latin typeface="Arial" panose="020B0604020202020204"/>
                  <a:ea typeface="Arial" panose="020B0604020202020204"/>
                  <a:cs typeface="Arial" panose="020B0604020202020204"/>
                </a:rPr>
                <a:t>	</a:t>
              </a:r>
              <a:r>
                <a:rPr sz="800" kern="0" spc="-40" dirty="0">
                  <a:solidFill>
                    <a:srgbClr val="0000FF">
                      <a:alpha val="100000"/>
                    </a:srgbClr>
                  </a:solidFill>
                  <a:latin typeface="Arial" panose="020B0604020202020204"/>
                  <a:ea typeface="Arial" panose="020B0604020202020204"/>
                  <a:cs typeface="Arial" panose="020B0604020202020204"/>
                </a:rPr>
                <a:t>Dip S</a:t>
              </a:r>
              <a:endParaRPr sz="800" dirty="0">
                <a:latin typeface="Arial" panose="020B0604020202020204"/>
                <a:ea typeface="Arial" panose="020B0604020202020204"/>
                <a:cs typeface="Arial" panose="020B0604020202020204"/>
              </a:endParaRPr>
            </a:p>
          </p:txBody>
        </p:sp>
        <p:pic>
          <p:nvPicPr>
            <p:cNvPr id="28" name="picture 28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 rot="21600000">
              <a:off x="3031107" y="9973"/>
              <a:ext cx="121101" cy="99731"/>
            </a:xfrm>
            <a:prstGeom prst="rect">
              <a:avLst/>
            </a:prstGeom>
          </p:spPr>
        </p:pic>
        <p:sp>
          <p:nvSpPr>
            <p:cNvPr id="30" name="path 30"/>
            <p:cNvSpPr/>
            <p:nvPr/>
          </p:nvSpPr>
          <p:spPr>
            <a:xfrm>
              <a:off x="1437618" y="243295"/>
              <a:ext cx="63436" cy="657359"/>
            </a:xfrm>
            <a:custGeom>
              <a:avLst/>
              <a:gdLst/>
              <a:ahLst/>
              <a:cxnLst/>
              <a:rect l="0" t="0" r="0" b="0"/>
              <a:pathLst>
                <a:path w="99" h="1035">
                  <a:moveTo>
                    <a:pt x="7" y="1027"/>
                  </a:moveTo>
                  <a:lnTo>
                    <a:pt x="35" y="86"/>
                  </a:lnTo>
                  <a:lnTo>
                    <a:pt x="64" y="7"/>
                  </a:lnTo>
                  <a:lnTo>
                    <a:pt x="92" y="934"/>
                  </a:lnTo>
                </a:path>
              </a:pathLst>
            </a:custGeom>
            <a:noFill/>
            <a:ln w="9260" cap="rnd">
              <a:solidFill>
                <a:srgbClr val="000000"/>
              </a:solidFill>
              <a:prstDash val="solid"/>
              <a:round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  <p:grpSp>
          <p:nvGrpSpPr>
            <p:cNvPr id="7" name="group 6"/>
            <p:cNvGrpSpPr/>
            <p:nvPr/>
          </p:nvGrpSpPr>
          <p:grpSpPr>
            <a:xfrm rot="21600000">
              <a:off x="1202859" y="3051723"/>
              <a:ext cx="99552" cy="210189"/>
              <a:chOff x="0" y="0"/>
              <a:chExt cx="99552" cy="210189"/>
            </a:xfrm>
          </p:grpSpPr>
          <p:sp>
            <p:nvSpPr>
              <p:cNvPr id="32" name="path 32"/>
              <p:cNvSpPr/>
              <p:nvPr/>
            </p:nvSpPr>
            <p:spPr>
              <a:xfrm>
                <a:off x="0" y="0"/>
                <a:ext cx="99552" cy="135568"/>
              </a:xfrm>
              <a:custGeom>
                <a:avLst/>
                <a:gdLst/>
                <a:ahLst/>
                <a:cxnLst/>
                <a:rect l="0" t="0" r="0" b="0"/>
                <a:pathLst>
                  <a:path w="156" h="213">
                    <a:moveTo>
                      <a:pt x="7" y="206"/>
                    </a:moveTo>
                    <a:lnTo>
                      <a:pt x="35" y="197"/>
                    </a:lnTo>
                    <a:lnTo>
                      <a:pt x="64" y="176"/>
                    </a:lnTo>
                    <a:lnTo>
                      <a:pt x="92" y="156"/>
                    </a:lnTo>
                    <a:lnTo>
                      <a:pt x="121" y="97"/>
                    </a:lnTo>
                    <a:lnTo>
                      <a:pt x="149" y="7"/>
                    </a:lnTo>
                  </a:path>
                </a:pathLst>
              </a:custGeom>
              <a:noFill/>
              <a:ln w="9260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/>
              <a:lstStyle/>
              <a:p>
                <a:pPr algn="ctr"/>
                <a:endParaRPr lang="zh-CN" altLang="en-US"/>
              </a:p>
            </p:txBody>
          </p:sp>
          <p:sp>
            <p:nvSpPr>
              <p:cNvPr id="34" name="path 34"/>
              <p:cNvSpPr/>
              <p:nvPr/>
            </p:nvSpPr>
            <p:spPr>
              <a:xfrm>
                <a:off x="8158" y="138953"/>
                <a:ext cx="7123" cy="71235"/>
              </a:xfrm>
              <a:custGeom>
                <a:avLst/>
                <a:gdLst/>
                <a:ahLst/>
                <a:cxnLst/>
                <a:rect l="0" t="0" r="0" b="0"/>
                <a:pathLst>
                  <a:path w="11" h="112">
                    <a:moveTo>
                      <a:pt x="5" y="5"/>
                    </a:moveTo>
                    <a:lnTo>
                      <a:pt x="5" y="106"/>
                    </a:lnTo>
                  </a:path>
                </a:pathLst>
              </a:custGeom>
              <a:noFill/>
              <a:ln w="7123" cap="sq">
                <a:solidFill>
                  <a:srgbClr val="000000"/>
                </a:solidFill>
                <a:prstDash val="solid"/>
                <a:bevel/>
              </a:ln>
            </p:spPr>
            <p:txBody>
              <a:bodyPr rtlCol="0"/>
              <a:lstStyle/>
              <a:p>
                <a:pPr algn="ctr"/>
                <a:endParaRPr lang="zh-CN" altLang="en-US"/>
              </a:p>
            </p:txBody>
          </p:sp>
        </p:grpSp>
      </p:grpSp>
      <p:sp>
        <p:nvSpPr>
          <p:cNvPr id="36" name="textbox 36"/>
          <p:cNvSpPr/>
          <p:nvPr/>
        </p:nvSpPr>
        <p:spPr>
          <a:xfrm>
            <a:off x="5148708" y="463314"/>
            <a:ext cx="2123439" cy="330962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8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ct val="10700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ile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nalyzed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: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240105</a:t>
            </a:r>
            <a:r>
              <a:rPr sz="900" u="sng" kern="0" spc="10" dirty="0">
                <a:solidFill>
                  <a:srgbClr val="0000FF">
                    <a:alpha val="100000"/>
                  </a:srgbClr>
                </a:solidFill>
                <a:uFill>
                  <a:solidFill>
                    <a:srgbClr val="000000"/>
                  </a:solidFill>
                </a:u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900" u="sng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</a:t>
            </a:r>
            <a:r>
              <a:rPr sz="900" u="sng" kern="0" spc="10" dirty="0">
                <a:solidFill>
                  <a:srgbClr val="0000FF">
                    <a:alpha val="100000"/>
                  </a:srgbClr>
                </a:solidFill>
                <a:uFill>
                  <a:solidFill>
                    <a:srgbClr val="000000"/>
                  </a:solidFill>
                </a:u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02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.fcs        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ate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nalyzed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:</a:t>
            </a:r>
            <a:r>
              <a:rPr sz="900" kern="0" spc="1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-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Jan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-2024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el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nn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n_DSD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ts val="1230"/>
              </a:lnSpc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nalysis type:</a:t>
            </a:r>
            <a:r>
              <a:rPr sz="1000" kern="0" spc="8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anual analy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sis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87000"/>
              </a:lnSpc>
              <a:spcBef>
                <a:spcPts val="75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uto</a:t>
            </a:r>
            <a:r>
              <a:rPr sz="10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Linearity:</a:t>
            </a:r>
            <a:r>
              <a:rPr sz="10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N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o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ts val="1270"/>
              </a:lnSpc>
              <a:spcBef>
                <a:spcPts val="945"/>
              </a:spcBef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loidy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e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:</a:t>
            </a:r>
            <a:r>
              <a:rPr sz="900" kern="0" spc="12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irst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cycle</a:t>
            </a:r>
            <a:r>
              <a:rPr sz="900" kern="0" spc="8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is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loid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ts val="1195"/>
              </a:lnSpc>
              <a:spcBef>
                <a:spcPts val="975"/>
              </a:spcBef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loid:</a:t>
            </a:r>
            <a:r>
              <a:rPr sz="900" kern="0" spc="1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.00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827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G1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92.97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t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72.87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827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G2:</a:t>
            </a:r>
            <a:r>
              <a:rPr sz="9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.51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t</a:t>
            </a:r>
            <a:r>
              <a:rPr sz="9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43.56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8270" algn="l" rtl="0" eaLnBrk="0">
              <a:lnSpc>
                <a:spcPts val="123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S:</a:t>
            </a:r>
            <a:r>
              <a:rPr sz="900" kern="0" spc="8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.52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r>
              <a:rPr sz="9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G2/G1:</a:t>
            </a:r>
            <a:r>
              <a:rPr sz="900" kern="0" spc="1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.97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6365" algn="l" rtl="0" eaLnBrk="0">
              <a:lnSpc>
                <a:spcPts val="1230"/>
              </a:lnSpc>
              <a:spcBef>
                <a:spcPts val="70"/>
              </a:spcBef>
            </a:pPr>
            <a:r>
              <a:rPr sz="1000" kern="0" spc="-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CV:</a:t>
            </a:r>
            <a:r>
              <a:rPr sz="1000" kern="0" spc="12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3.73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5240" algn="l" rtl="0" eaLnBrk="0">
              <a:lnSpc>
                <a:spcPts val="1195"/>
              </a:lnSpc>
              <a:spcBef>
                <a:spcPts val="760"/>
              </a:spcBef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Total S-Phase:</a:t>
            </a:r>
            <a:r>
              <a:rPr sz="900" kern="0" spc="8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.52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5240" algn="l" rtl="0" eaLnBrk="0">
              <a:lnSpc>
                <a:spcPts val="1195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Total B.A.D.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.00 %    no debris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no aggs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ct val="100000"/>
              </a:lnSpc>
              <a:spcBef>
                <a:spcPts val="970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ebris:</a:t>
            </a:r>
            <a:r>
              <a:rPr sz="10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3000"/>
              </a:lnSpc>
              <a:spcBef>
                <a:spcPts val="5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ggregates:</a:t>
            </a:r>
            <a:r>
              <a:rPr sz="10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eled event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s: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8402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3000"/>
              </a:lnSpc>
              <a:spcBef>
                <a:spcPts val="5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ll cycle events:</a:t>
            </a:r>
            <a:r>
              <a:rPr sz="10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8402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8415" algn="l" rtl="0" eaLnBrk="0">
              <a:lnSpc>
                <a:spcPts val="1225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Cycle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events</a:t>
            </a:r>
            <a:r>
              <a:rPr sz="9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er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channel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:</a:t>
            </a:r>
            <a:r>
              <a:rPr sz="9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396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ct val="92000"/>
              </a:lnSpc>
              <a:spcBef>
                <a:spcPts val="5"/>
              </a:spcBef>
            </a:pPr>
            <a:r>
              <a:rPr sz="900" kern="0" spc="-2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CS:</a:t>
            </a:r>
            <a:r>
              <a:rPr sz="900" kern="0" spc="18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2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.</a:t>
            </a:r>
            <a:r>
              <a:rPr sz="900" kern="0" spc="-1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2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99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pic>
        <p:nvPicPr>
          <p:cNvPr id="38" name="picture 3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21600000">
            <a:off x="872645" y="7436918"/>
            <a:ext cx="1239083" cy="1301232"/>
          </a:xfrm>
          <a:prstGeom prst="rect">
            <a:avLst/>
          </a:prstGeom>
        </p:spPr>
      </p:pic>
      <p:grpSp>
        <p:nvGrpSpPr>
          <p:cNvPr id="9" name="group 8"/>
          <p:cNvGrpSpPr/>
          <p:nvPr/>
        </p:nvGrpSpPr>
        <p:grpSpPr>
          <a:xfrm rot="21600000">
            <a:off x="758667" y="7426391"/>
            <a:ext cx="1353491" cy="1303625"/>
            <a:chOff x="0" y="0"/>
            <a:chExt cx="1353491" cy="1303625"/>
          </a:xfrm>
        </p:grpSpPr>
        <p:sp>
          <p:nvSpPr>
            <p:cNvPr id="40" name="path 40"/>
            <p:cNvSpPr/>
            <p:nvPr/>
          </p:nvSpPr>
          <p:spPr>
            <a:xfrm>
              <a:off x="0" y="0"/>
              <a:ext cx="1353491" cy="1303625"/>
            </a:xfrm>
            <a:custGeom>
              <a:avLst/>
              <a:gdLst/>
              <a:ahLst/>
              <a:cxnLst/>
              <a:rect l="0" t="0" r="0" b="0"/>
              <a:pathLst>
                <a:path w="2131" h="2052">
                  <a:moveTo>
                    <a:pt x="263" y="1867"/>
                  </a:moveTo>
                  <a:lnTo>
                    <a:pt x="263" y="1957"/>
                  </a:lnTo>
                  <a:moveTo>
                    <a:pt x="342" y="1867"/>
                  </a:moveTo>
                  <a:lnTo>
                    <a:pt x="342" y="1957"/>
                  </a:lnTo>
                  <a:moveTo>
                    <a:pt x="420" y="1867"/>
                  </a:moveTo>
                  <a:lnTo>
                    <a:pt x="420" y="1957"/>
                  </a:lnTo>
                  <a:moveTo>
                    <a:pt x="487" y="1867"/>
                  </a:moveTo>
                  <a:lnTo>
                    <a:pt x="487" y="2047"/>
                  </a:lnTo>
                  <a:moveTo>
                    <a:pt x="566" y="1867"/>
                  </a:moveTo>
                  <a:lnTo>
                    <a:pt x="566" y="1957"/>
                  </a:lnTo>
                  <a:moveTo>
                    <a:pt x="645" y="1867"/>
                  </a:moveTo>
                  <a:lnTo>
                    <a:pt x="645" y="1957"/>
                  </a:lnTo>
                  <a:moveTo>
                    <a:pt x="723" y="1867"/>
                  </a:moveTo>
                  <a:lnTo>
                    <a:pt x="723" y="1957"/>
                  </a:lnTo>
                  <a:moveTo>
                    <a:pt x="802" y="1867"/>
                  </a:moveTo>
                  <a:lnTo>
                    <a:pt x="802" y="2047"/>
                  </a:lnTo>
                  <a:moveTo>
                    <a:pt x="880" y="1867"/>
                  </a:moveTo>
                  <a:lnTo>
                    <a:pt x="880" y="1957"/>
                  </a:lnTo>
                  <a:moveTo>
                    <a:pt x="959" y="1867"/>
                  </a:moveTo>
                  <a:lnTo>
                    <a:pt x="959" y="1957"/>
                  </a:lnTo>
                  <a:moveTo>
                    <a:pt x="1037" y="1867"/>
                  </a:moveTo>
                  <a:lnTo>
                    <a:pt x="1037" y="1957"/>
                  </a:lnTo>
                  <a:moveTo>
                    <a:pt x="1105" y="1867"/>
                  </a:moveTo>
                  <a:lnTo>
                    <a:pt x="1105" y="2047"/>
                  </a:lnTo>
                  <a:moveTo>
                    <a:pt x="1183" y="1867"/>
                  </a:moveTo>
                  <a:lnTo>
                    <a:pt x="1183" y="1957"/>
                  </a:lnTo>
                  <a:moveTo>
                    <a:pt x="1262" y="1867"/>
                  </a:moveTo>
                  <a:lnTo>
                    <a:pt x="1262" y="1957"/>
                  </a:lnTo>
                  <a:moveTo>
                    <a:pt x="1340" y="1867"/>
                  </a:moveTo>
                  <a:lnTo>
                    <a:pt x="1340" y="1957"/>
                  </a:lnTo>
                  <a:moveTo>
                    <a:pt x="1419" y="1867"/>
                  </a:moveTo>
                  <a:lnTo>
                    <a:pt x="1419" y="2047"/>
                  </a:lnTo>
                  <a:moveTo>
                    <a:pt x="1497" y="1867"/>
                  </a:moveTo>
                  <a:lnTo>
                    <a:pt x="1497" y="1957"/>
                  </a:lnTo>
                  <a:moveTo>
                    <a:pt x="1576" y="1867"/>
                  </a:moveTo>
                  <a:lnTo>
                    <a:pt x="1576" y="1957"/>
                  </a:lnTo>
                  <a:moveTo>
                    <a:pt x="1643" y="1867"/>
                  </a:moveTo>
                  <a:lnTo>
                    <a:pt x="1643" y="1957"/>
                  </a:lnTo>
                  <a:moveTo>
                    <a:pt x="1722" y="1867"/>
                  </a:moveTo>
                  <a:lnTo>
                    <a:pt x="1722" y="2047"/>
                  </a:lnTo>
                  <a:moveTo>
                    <a:pt x="1800" y="1867"/>
                  </a:moveTo>
                  <a:lnTo>
                    <a:pt x="1800" y="1957"/>
                  </a:lnTo>
                  <a:moveTo>
                    <a:pt x="1879" y="1867"/>
                  </a:moveTo>
                  <a:lnTo>
                    <a:pt x="1879" y="1957"/>
                  </a:lnTo>
                  <a:moveTo>
                    <a:pt x="1957" y="1867"/>
                  </a:moveTo>
                  <a:lnTo>
                    <a:pt x="1957" y="1957"/>
                  </a:lnTo>
                  <a:moveTo>
                    <a:pt x="2036" y="1867"/>
                  </a:moveTo>
                  <a:lnTo>
                    <a:pt x="2036" y="2047"/>
                  </a:lnTo>
                  <a:moveTo>
                    <a:pt x="2114" y="1867"/>
                  </a:moveTo>
                  <a:lnTo>
                    <a:pt x="2114" y="1957"/>
                  </a:lnTo>
                  <a:moveTo>
                    <a:pt x="185" y="1867"/>
                  </a:moveTo>
                  <a:lnTo>
                    <a:pt x="2125" y="1867"/>
                  </a:lnTo>
                  <a:moveTo>
                    <a:pt x="185" y="1867"/>
                  </a:moveTo>
                  <a:lnTo>
                    <a:pt x="5" y="1867"/>
                  </a:lnTo>
                  <a:moveTo>
                    <a:pt x="185" y="1789"/>
                  </a:moveTo>
                  <a:lnTo>
                    <a:pt x="95" y="1789"/>
                  </a:lnTo>
                  <a:moveTo>
                    <a:pt x="185" y="1722"/>
                  </a:moveTo>
                  <a:lnTo>
                    <a:pt x="95" y="1722"/>
                  </a:lnTo>
                  <a:moveTo>
                    <a:pt x="185" y="1643"/>
                  </a:moveTo>
                  <a:lnTo>
                    <a:pt x="95" y="1643"/>
                  </a:lnTo>
                  <a:moveTo>
                    <a:pt x="185" y="1576"/>
                  </a:moveTo>
                  <a:lnTo>
                    <a:pt x="5" y="1576"/>
                  </a:lnTo>
                  <a:moveTo>
                    <a:pt x="185" y="1497"/>
                  </a:moveTo>
                  <a:lnTo>
                    <a:pt x="95" y="1497"/>
                  </a:lnTo>
                  <a:moveTo>
                    <a:pt x="185" y="1430"/>
                  </a:moveTo>
                  <a:lnTo>
                    <a:pt x="95" y="1430"/>
                  </a:lnTo>
                  <a:moveTo>
                    <a:pt x="185" y="1351"/>
                  </a:moveTo>
                  <a:lnTo>
                    <a:pt x="95" y="1351"/>
                  </a:lnTo>
                  <a:moveTo>
                    <a:pt x="185" y="1284"/>
                  </a:moveTo>
                  <a:lnTo>
                    <a:pt x="5" y="1284"/>
                  </a:lnTo>
                  <a:moveTo>
                    <a:pt x="185" y="1205"/>
                  </a:moveTo>
                  <a:lnTo>
                    <a:pt x="95" y="1205"/>
                  </a:lnTo>
                  <a:moveTo>
                    <a:pt x="185" y="1138"/>
                  </a:moveTo>
                  <a:lnTo>
                    <a:pt x="95" y="1138"/>
                  </a:lnTo>
                  <a:moveTo>
                    <a:pt x="185" y="1060"/>
                  </a:moveTo>
                  <a:lnTo>
                    <a:pt x="95" y="1060"/>
                  </a:lnTo>
                  <a:moveTo>
                    <a:pt x="185" y="992"/>
                  </a:moveTo>
                  <a:lnTo>
                    <a:pt x="5" y="992"/>
                  </a:lnTo>
                  <a:moveTo>
                    <a:pt x="185" y="914"/>
                  </a:moveTo>
                  <a:lnTo>
                    <a:pt x="95" y="914"/>
                  </a:lnTo>
                  <a:moveTo>
                    <a:pt x="185" y="846"/>
                  </a:moveTo>
                  <a:lnTo>
                    <a:pt x="95" y="846"/>
                  </a:lnTo>
                  <a:moveTo>
                    <a:pt x="185" y="768"/>
                  </a:moveTo>
                  <a:lnTo>
                    <a:pt x="95" y="768"/>
                  </a:lnTo>
                  <a:moveTo>
                    <a:pt x="185" y="689"/>
                  </a:moveTo>
                  <a:lnTo>
                    <a:pt x="5" y="689"/>
                  </a:lnTo>
                  <a:moveTo>
                    <a:pt x="185" y="622"/>
                  </a:moveTo>
                  <a:lnTo>
                    <a:pt x="95" y="622"/>
                  </a:lnTo>
                  <a:moveTo>
                    <a:pt x="185" y="544"/>
                  </a:moveTo>
                  <a:lnTo>
                    <a:pt x="95" y="544"/>
                  </a:lnTo>
                  <a:moveTo>
                    <a:pt x="185" y="476"/>
                  </a:moveTo>
                  <a:lnTo>
                    <a:pt x="95" y="476"/>
                  </a:lnTo>
                  <a:moveTo>
                    <a:pt x="185" y="398"/>
                  </a:moveTo>
                  <a:lnTo>
                    <a:pt x="5" y="398"/>
                  </a:lnTo>
                  <a:moveTo>
                    <a:pt x="185" y="330"/>
                  </a:moveTo>
                  <a:lnTo>
                    <a:pt x="95" y="330"/>
                  </a:lnTo>
                  <a:moveTo>
                    <a:pt x="185" y="252"/>
                  </a:moveTo>
                  <a:lnTo>
                    <a:pt x="95" y="252"/>
                  </a:lnTo>
                  <a:moveTo>
                    <a:pt x="185" y="185"/>
                  </a:moveTo>
                  <a:lnTo>
                    <a:pt x="95" y="185"/>
                  </a:lnTo>
                  <a:moveTo>
                    <a:pt x="185" y="106"/>
                  </a:moveTo>
                  <a:lnTo>
                    <a:pt x="5" y="106"/>
                  </a:lnTo>
                  <a:moveTo>
                    <a:pt x="185" y="39"/>
                  </a:moveTo>
                  <a:lnTo>
                    <a:pt x="95" y="39"/>
                  </a:lnTo>
                  <a:moveTo>
                    <a:pt x="185" y="1867"/>
                  </a:moveTo>
                  <a:lnTo>
                    <a:pt x="185" y="5"/>
                  </a:lnTo>
                </a:path>
              </a:pathLst>
            </a:custGeom>
            <a:noFill/>
            <a:ln w="7123" cap="sq">
              <a:solidFill>
                <a:srgbClr val="000000"/>
              </a:solidFill>
              <a:prstDash val="solid"/>
              <a:bevel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  <p:sp>
          <p:nvSpPr>
            <p:cNvPr id="42" name="path 42"/>
            <p:cNvSpPr/>
            <p:nvPr/>
          </p:nvSpPr>
          <p:spPr>
            <a:xfrm>
              <a:off x="251051" y="613225"/>
              <a:ext cx="852201" cy="394125"/>
            </a:xfrm>
            <a:custGeom>
              <a:avLst/>
              <a:gdLst/>
              <a:ahLst/>
              <a:cxnLst/>
              <a:rect l="0" t="0" r="0" b="0"/>
              <a:pathLst>
                <a:path w="1342" h="620">
                  <a:moveTo>
                    <a:pt x="563" y="16"/>
                  </a:moveTo>
                  <a:lnTo>
                    <a:pt x="633" y="16"/>
                  </a:lnTo>
                  <a:lnTo>
                    <a:pt x="717" y="16"/>
                  </a:lnTo>
                  <a:lnTo>
                    <a:pt x="774" y="18"/>
                  </a:lnTo>
                  <a:lnTo>
                    <a:pt x="831" y="21"/>
                  </a:lnTo>
                  <a:lnTo>
                    <a:pt x="889" y="29"/>
                  </a:lnTo>
                  <a:lnTo>
                    <a:pt x="946" y="38"/>
                  </a:lnTo>
                  <a:lnTo>
                    <a:pt x="1038" y="51"/>
                  </a:lnTo>
                  <a:lnTo>
                    <a:pt x="1131" y="68"/>
                  </a:lnTo>
                  <a:lnTo>
                    <a:pt x="1206" y="93"/>
                  </a:lnTo>
                  <a:lnTo>
                    <a:pt x="1276" y="132"/>
                  </a:lnTo>
                  <a:lnTo>
                    <a:pt x="1316" y="192"/>
                  </a:lnTo>
                  <a:lnTo>
                    <a:pt x="1325" y="261"/>
                  </a:lnTo>
                  <a:lnTo>
                    <a:pt x="1289" y="333"/>
                  </a:lnTo>
                  <a:lnTo>
                    <a:pt x="1232" y="381"/>
                  </a:lnTo>
                  <a:lnTo>
                    <a:pt x="1171" y="419"/>
                  </a:lnTo>
                  <a:lnTo>
                    <a:pt x="1109" y="453"/>
                  </a:lnTo>
                  <a:lnTo>
                    <a:pt x="1043" y="479"/>
                  </a:lnTo>
                  <a:lnTo>
                    <a:pt x="992" y="494"/>
                  </a:lnTo>
                  <a:lnTo>
                    <a:pt x="941" y="509"/>
                  </a:lnTo>
                  <a:lnTo>
                    <a:pt x="871" y="526"/>
                  </a:lnTo>
                  <a:lnTo>
                    <a:pt x="800" y="543"/>
                  </a:lnTo>
                  <a:lnTo>
                    <a:pt x="730" y="552"/>
                  </a:lnTo>
                  <a:lnTo>
                    <a:pt x="660" y="565"/>
                  </a:lnTo>
                  <a:lnTo>
                    <a:pt x="567" y="586"/>
                  </a:lnTo>
                  <a:lnTo>
                    <a:pt x="483" y="599"/>
                  </a:lnTo>
                  <a:lnTo>
                    <a:pt x="395" y="603"/>
                  </a:lnTo>
                  <a:lnTo>
                    <a:pt x="320" y="603"/>
                  </a:lnTo>
                  <a:lnTo>
                    <a:pt x="232" y="573"/>
                  </a:lnTo>
                  <a:lnTo>
                    <a:pt x="166" y="543"/>
                  </a:lnTo>
                  <a:lnTo>
                    <a:pt x="100" y="518"/>
                  </a:lnTo>
                  <a:lnTo>
                    <a:pt x="38" y="471"/>
                  </a:lnTo>
                  <a:lnTo>
                    <a:pt x="21" y="398"/>
                  </a:lnTo>
                  <a:lnTo>
                    <a:pt x="16" y="325"/>
                  </a:lnTo>
                  <a:lnTo>
                    <a:pt x="56" y="248"/>
                  </a:lnTo>
                  <a:lnTo>
                    <a:pt x="104" y="183"/>
                  </a:lnTo>
                  <a:lnTo>
                    <a:pt x="153" y="123"/>
                  </a:lnTo>
                  <a:lnTo>
                    <a:pt x="201" y="93"/>
                  </a:lnTo>
                  <a:lnTo>
                    <a:pt x="274" y="78"/>
                  </a:lnTo>
                  <a:lnTo>
                    <a:pt x="346" y="63"/>
                  </a:lnTo>
                  <a:lnTo>
                    <a:pt x="418" y="47"/>
                  </a:lnTo>
                  <a:lnTo>
                    <a:pt x="490" y="32"/>
                  </a:lnTo>
                  <a:lnTo>
                    <a:pt x="563" y="16"/>
                  </a:lnTo>
                </a:path>
              </a:pathLst>
            </a:custGeom>
            <a:noFill/>
            <a:ln w="21370" cap="sq">
              <a:solidFill>
                <a:srgbClr val="000000"/>
              </a:solidFill>
              <a:prstDash val="solid"/>
              <a:miter lim="1000000"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</p:grpSp>
      <p:pic>
        <p:nvPicPr>
          <p:cNvPr id="44" name="picture 4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21600000">
            <a:off x="5545751" y="7436918"/>
            <a:ext cx="1223862" cy="1301232"/>
          </a:xfrm>
          <a:prstGeom prst="rect">
            <a:avLst/>
          </a:prstGeom>
        </p:spPr>
      </p:pic>
      <p:grpSp>
        <p:nvGrpSpPr>
          <p:cNvPr id="11" name="group 10"/>
          <p:cNvGrpSpPr/>
          <p:nvPr/>
        </p:nvGrpSpPr>
        <p:grpSpPr>
          <a:xfrm rot="21600000">
            <a:off x="5431773" y="7426391"/>
            <a:ext cx="1353491" cy="1303625"/>
            <a:chOff x="0" y="0"/>
            <a:chExt cx="1353491" cy="1303625"/>
          </a:xfrm>
        </p:grpSpPr>
        <p:sp>
          <p:nvSpPr>
            <p:cNvPr id="46" name="path 46"/>
            <p:cNvSpPr/>
            <p:nvPr/>
          </p:nvSpPr>
          <p:spPr>
            <a:xfrm>
              <a:off x="0" y="0"/>
              <a:ext cx="1353491" cy="1303625"/>
            </a:xfrm>
            <a:custGeom>
              <a:avLst/>
              <a:gdLst/>
              <a:ahLst/>
              <a:cxnLst/>
              <a:rect l="0" t="0" r="0" b="0"/>
              <a:pathLst>
                <a:path w="2131" h="2052">
                  <a:moveTo>
                    <a:pt x="263" y="1867"/>
                  </a:moveTo>
                  <a:lnTo>
                    <a:pt x="263" y="1957"/>
                  </a:lnTo>
                  <a:moveTo>
                    <a:pt x="342" y="1867"/>
                  </a:moveTo>
                  <a:lnTo>
                    <a:pt x="342" y="1957"/>
                  </a:lnTo>
                  <a:moveTo>
                    <a:pt x="420" y="1867"/>
                  </a:moveTo>
                  <a:lnTo>
                    <a:pt x="420" y="1957"/>
                  </a:lnTo>
                  <a:moveTo>
                    <a:pt x="487" y="1867"/>
                  </a:moveTo>
                  <a:lnTo>
                    <a:pt x="487" y="2047"/>
                  </a:lnTo>
                  <a:moveTo>
                    <a:pt x="566" y="1867"/>
                  </a:moveTo>
                  <a:lnTo>
                    <a:pt x="566" y="1957"/>
                  </a:lnTo>
                  <a:moveTo>
                    <a:pt x="645" y="1867"/>
                  </a:moveTo>
                  <a:lnTo>
                    <a:pt x="645" y="1957"/>
                  </a:lnTo>
                  <a:moveTo>
                    <a:pt x="723" y="1867"/>
                  </a:moveTo>
                  <a:lnTo>
                    <a:pt x="723" y="1957"/>
                  </a:lnTo>
                  <a:moveTo>
                    <a:pt x="802" y="1867"/>
                  </a:moveTo>
                  <a:lnTo>
                    <a:pt x="802" y="2047"/>
                  </a:lnTo>
                  <a:moveTo>
                    <a:pt x="880" y="1867"/>
                  </a:moveTo>
                  <a:lnTo>
                    <a:pt x="880" y="1957"/>
                  </a:lnTo>
                  <a:moveTo>
                    <a:pt x="959" y="1867"/>
                  </a:moveTo>
                  <a:lnTo>
                    <a:pt x="959" y="1957"/>
                  </a:lnTo>
                  <a:moveTo>
                    <a:pt x="1037" y="1867"/>
                  </a:moveTo>
                  <a:lnTo>
                    <a:pt x="1037" y="1957"/>
                  </a:lnTo>
                  <a:moveTo>
                    <a:pt x="1105" y="1867"/>
                  </a:moveTo>
                  <a:lnTo>
                    <a:pt x="1105" y="2047"/>
                  </a:lnTo>
                  <a:moveTo>
                    <a:pt x="1183" y="1867"/>
                  </a:moveTo>
                  <a:lnTo>
                    <a:pt x="1183" y="1957"/>
                  </a:lnTo>
                  <a:moveTo>
                    <a:pt x="1262" y="1867"/>
                  </a:moveTo>
                  <a:lnTo>
                    <a:pt x="1262" y="1957"/>
                  </a:lnTo>
                  <a:moveTo>
                    <a:pt x="1340" y="1867"/>
                  </a:moveTo>
                  <a:lnTo>
                    <a:pt x="1340" y="1957"/>
                  </a:lnTo>
                  <a:moveTo>
                    <a:pt x="1419" y="1867"/>
                  </a:moveTo>
                  <a:lnTo>
                    <a:pt x="1419" y="2047"/>
                  </a:lnTo>
                  <a:moveTo>
                    <a:pt x="1497" y="1867"/>
                  </a:moveTo>
                  <a:lnTo>
                    <a:pt x="1497" y="1957"/>
                  </a:lnTo>
                  <a:moveTo>
                    <a:pt x="1576" y="1867"/>
                  </a:moveTo>
                  <a:lnTo>
                    <a:pt x="1576" y="1957"/>
                  </a:lnTo>
                  <a:moveTo>
                    <a:pt x="1643" y="1867"/>
                  </a:moveTo>
                  <a:lnTo>
                    <a:pt x="1643" y="1957"/>
                  </a:lnTo>
                  <a:moveTo>
                    <a:pt x="1722" y="1867"/>
                  </a:moveTo>
                  <a:lnTo>
                    <a:pt x="1722" y="2047"/>
                  </a:lnTo>
                  <a:moveTo>
                    <a:pt x="1800" y="1867"/>
                  </a:moveTo>
                  <a:lnTo>
                    <a:pt x="1800" y="1957"/>
                  </a:lnTo>
                  <a:moveTo>
                    <a:pt x="1879" y="1867"/>
                  </a:moveTo>
                  <a:lnTo>
                    <a:pt x="1879" y="1957"/>
                  </a:lnTo>
                  <a:moveTo>
                    <a:pt x="1957" y="1867"/>
                  </a:moveTo>
                  <a:lnTo>
                    <a:pt x="1957" y="1957"/>
                  </a:lnTo>
                  <a:moveTo>
                    <a:pt x="2036" y="1867"/>
                  </a:moveTo>
                  <a:lnTo>
                    <a:pt x="2036" y="2047"/>
                  </a:lnTo>
                  <a:moveTo>
                    <a:pt x="2114" y="1867"/>
                  </a:moveTo>
                  <a:lnTo>
                    <a:pt x="2114" y="1957"/>
                  </a:lnTo>
                  <a:moveTo>
                    <a:pt x="185" y="1867"/>
                  </a:moveTo>
                  <a:lnTo>
                    <a:pt x="2125" y="1867"/>
                  </a:lnTo>
                  <a:moveTo>
                    <a:pt x="185" y="1867"/>
                  </a:moveTo>
                  <a:lnTo>
                    <a:pt x="5" y="1867"/>
                  </a:lnTo>
                  <a:moveTo>
                    <a:pt x="185" y="1789"/>
                  </a:moveTo>
                  <a:lnTo>
                    <a:pt x="95" y="1789"/>
                  </a:lnTo>
                  <a:moveTo>
                    <a:pt x="185" y="1722"/>
                  </a:moveTo>
                  <a:lnTo>
                    <a:pt x="95" y="1722"/>
                  </a:lnTo>
                  <a:moveTo>
                    <a:pt x="185" y="1643"/>
                  </a:moveTo>
                  <a:lnTo>
                    <a:pt x="95" y="1643"/>
                  </a:lnTo>
                  <a:moveTo>
                    <a:pt x="185" y="1576"/>
                  </a:moveTo>
                  <a:lnTo>
                    <a:pt x="5" y="1576"/>
                  </a:lnTo>
                  <a:moveTo>
                    <a:pt x="185" y="1497"/>
                  </a:moveTo>
                  <a:lnTo>
                    <a:pt x="95" y="1497"/>
                  </a:lnTo>
                  <a:moveTo>
                    <a:pt x="185" y="1430"/>
                  </a:moveTo>
                  <a:lnTo>
                    <a:pt x="95" y="1430"/>
                  </a:lnTo>
                  <a:moveTo>
                    <a:pt x="185" y="1351"/>
                  </a:moveTo>
                  <a:lnTo>
                    <a:pt x="95" y="1351"/>
                  </a:lnTo>
                  <a:moveTo>
                    <a:pt x="185" y="1284"/>
                  </a:moveTo>
                  <a:lnTo>
                    <a:pt x="5" y="1284"/>
                  </a:lnTo>
                  <a:moveTo>
                    <a:pt x="185" y="1205"/>
                  </a:moveTo>
                  <a:lnTo>
                    <a:pt x="95" y="1205"/>
                  </a:lnTo>
                  <a:moveTo>
                    <a:pt x="185" y="1138"/>
                  </a:moveTo>
                  <a:lnTo>
                    <a:pt x="95" y="1138"/>
                  </a:lnTo>
                  <a:moveTo>
                    <a:pt x="185" y="1060"/>
                  </a:moveTo>
                  <a:lnTo>
                    <a:pt x="95" y="1060"/>
                  </a:lnTo>
                  <a:moveTo>
                    <a:pt x="185" y="992"/>
                  </a:moveTo>
                  <a:lnTo>
                    <a:pt x="5" y="992"/>
                  </a:lnTo>
                  <a:moveTo>
                    <a:pt x="185" y="914"/>
                  </a:moveTo>
                  <a:lnTo>
                    <a:pt x="95" y="914"/>
                  </a:lnTo>
                  <a:moveTo>
                    <a:pt x="185" y="846"/>
                  </a:moveTo>
                  <a:lnTo>
                    <a:pt x="95" y="846"/>
                  </a:lnTo>
                  <a:moveTo>
                    <a:pt x="185" y="768"/>
                  </a:moveTo>
                  <a:lnTo>
                    <a:pt x="95" y="768"/>
                  </a:lnTo>
                  <a:moveTo>
                    <a:pt x="185" y="689"/>
                  </a:moveTo>
                  <a:lnTo>
                    <a:pt x="5" y="689"/>
                  </a:lnTo>
                  <a:moveTo>
                    <a:pt x="185" y="622"/>
                  </a:moveTo>
                  <a:lnTo>
                    <a:pt x="95" y="622"/>
                  </a:lnTo>
                  <a:moveTo>
                    <a:pt x="185" y="544"/>
                  </a:moveTo>
                  <a:lnTo>
                    <a:pt x="95" y="544"/>
                  </a:lnTo>
                  <a:moveTo>
                    <a:pt x="185" y="476"/>
                  </a:moveTo>
                  <a:lnTo>
                    <a:pt x="95" y="476"/>
                  </a:lnTo>
                  <a:moveTo>
                    <a:pt x="185" y="398"/>
                  </a:moveTo>
                  <a:lnTo>
                    <a:pt x="5" y="398"/>
                  </a:lnTo>
                  <a:moveTo>
                    <a:pt x="185" y="330"/>
                  </a:moveTo>
                  <a:lnTo>
                    <a:pt x="95" y="330"/>
                  </a:lnTo>
                  <a:moveTo>
                    <a:pt x="185" y="252"/>
                  </a:moveTo>
                  <a:lnTo>
                    <a:pt x="95" y="252"/>
                  </a:lnTo>
                  <a:moveTo>
                    <a:pt x="185" y="185"/>
                  </a:moveTo>
                  <a:lnTo>
                    <a:pt x="95" y="185"/>
                  </a:lnTo>
                  <a:moveTo>
                    <a:pt x="185" y="106"/>
                  </a:moveTo>
                  <a:lnTo>
                    <a:pt x="5" y="106"/>
                  </a:lnTo>
                  <a:moveTo>
                    <a:pt x="185" y="39"/>
                  </a:moveTo>
                  <a:lnTo>
                    <a:pt x="95" y="39"/>
                  </a:lnTo>
                  <a:moveTo>
                    <a:pt x="185" y="1867"/>
                  </a:moveTo>
                  <a:lnTo>
                    <a:pt x="185" y="5"/>
                  </a:lnTo>
                </a:path>
              </a:pathLst>
            </a:custGeom>
            <a:noFill/>
            <a:ln w="7123" cap="sq">
              <a:solidFill>
                <a:srgbClr val="000000"/>
              </a:solidFill>
              <a:prstDash val="solid"/>
              <a:bevel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  <p:sp>
          <p:nvSpPr>
            <p:cNvPr id="48" name="path 48"/>
            <p:cNvSpPr/>
            <p:nvPr/>
          </p:nvSpPr>
          <p:spPr>
            <a:xfrm>
              <a:off x="298606" y="520717"/>
              <a:ext cx="745900" cy="636279"/>
            </a:xfrm>
            <a:custGeom>
              <a:avLst/>
              <a:gdLst/>
              <a:ahLst/>
              <a:cxnLst/>
              <a:rect l="0" t="0" r="0" b="0"/>
              <a:pathLst>
                <a:path w="1174" h="1002">
                  <a:moveTo>
                    <a:pt x="1007" y="51"/>
                  </a:moveTo>
                  <a:lnTo>
                    <a:pt x="1052" y="112"/>
                  </a:lnTo>
                  <a:lnTo>
                    <a:pt x="1093" y="182"/>
                  </a:lnTo>
                  <a:lnTo>
                    <a:pt x="1121" y="265"/>
                  </a:lnTo>
                  <a:lnTo>
                    <a:pt x="1139" y="339"/>
                  </a:lnTo>
                  <a:lnTo>
                    <a:pt x="1157" y="409"/>
                  </a:lnTo>
                  <a:lnTo>
                    <a:pt x="1157" y="448"/>
                  </a:lnTo>
                  <a:lnTo>
                    <a:pt x="1157" y="487"/>
                  </a:lnTo>
                  <a:lnTo>
                    <a:pt x="1144" y="570"/>
                  </a:lnTo>
                  <a:lnTo>
                    <a:pt x="1103" y="644"/>
                  </a:lnTo>
                  <a:lnTo>
                    <a:pt x="1048" y="723"/>
                  </a:lnTo>
                  <a:lnTo>
                    <a:pt x="979" y="788"/>
                  </a:lnTo>
                  <a:lnTo>
                    <a:pt x="915" y="836"/>
                  </a:lnTo>
                  <a:lnTo>
                    <a:pt x="842" y="880"/>
                  </a:lnTo>
                  <a:lnTo>
                    <a:pt x="779" y="915"/>
                  </a:lnTo>
                  <a:lnTo>
                    <a:pt x="692" y="941"/>
                  </a:lnTo>
                  <a:lnTo>
                    <a:pt x="605" y="963"/>
                  </a:lnTo>
                  <a:lnTo>
                    <a:pt x="518" y="980"/>
                  </a:lnTo>
                  <a:lnTo>
                    <a:pt x="436" y="985"/>
                  </a:lnTo>
                  <a:lnTo>
                    <a:pt x="359" y="985"/>
                  </a:lnTo>
                  <a:lnTo>
                    <a:pt x="286" y="972"/>
                  </a:lnTo>
                  <a:lnTo>
                    <a:pt x="208" y="954"/>
                  </a:lnTo>
                  <a:lnTo>
                    <a:pt x="130" y="915"/>
                  </a:lnTo>
                  <a:lnTo>
                    <a:pt x="80" y="858"/>
                  </a:lnTo>
                  <a:lnTo>
                    <a:pt x="44" y="788"/>
                  </a:lnTo>
                  <a:lnTo>
                    <a:pt x="21" y="714"/>
                  </a:lnTo>
                  <a:lnTo>
                    <a:pt x="16" y="636"/>
                  </a:lnTo>
                  <a:lnTo>
                    <a:pt x="16" y="596"/>
                  </a:lnTo>
                  <a:lnTo>
                    <a:pt x="16" y="557"/>
                  </a:lnTo>
                  <a:lnTo>
                    <a:pt x="53" y="496"/>
                  </a:lnTo>
                  <a:lnTo>
                    <a:pt x="98" y="422"/>
                  </a:lnTo>
                  <a:lnTo>
                    <a:pt x="158" y="352"/>
                  </a:lnTo>
                  <a:lnTo>
                    <a:pt x="222" y="291"/>
                  </a:lnTo>
                  <a:lnTo>
                    <a:pt x="272" y="239"/>
                  </a:lnTo>
                  <a:lnTo>
                    <a:pt x="336" y="186"/>
                  </a:lnTo>
                  <a:lnTo>
                    <a:pt x="404" y="138"/>
                  </a:lnTo>
                  <a:lnTo>
                    <a:pt x="477" y="90"/>
                  </a:lnTo>
                  <a:lnTo>
                    <a:pt x="541" y="56"/>
                  </a:lnTo>
                  <a:lnTo>
                    <a:pt x="614" y="29"/>
                  </a:lnTo>
                  <a:lnTo>
                    <a:pt x="687" y="16"/>
                  </a:lnTo>
                  <a:lnTo>
                    <a:pt x="701" y="16"/>
                  </a:lnTo>
                  <a:lnTo>
                    <a:pt x="777" y="25"/>
                  </a:lnTo>
                  <a:lnTo>
                    <a:pt x="854" y="34"/>
                  </a:lnTo>
                  <a:lnTo>
                    <a:pt x="930" y="42"/>
                  </a:lnTo>
                  <a:lnTo>
                    <a:pt x="1007" y="51"/>
                  </a:lnTo>
                </a:path>
              </a:pathLst>
            </a:custGeom>
            <a:noFill/>
            <a:ln w="21370" cap="sq">
              <a:solidFill>
                <a:srgbClr val="000000"/>
              </a:solidFill>
              <a:prstDash val="solid"/>
              <a:miter lim="1000000"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</p:grpSp>
      <p:pic>
        <p:nvPicPr>
          <p:cNvPr id="50" name="picture 5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rot="21600000">
            <a:off x="3209198" y="7436918"/>
            <a:ext cx="1225214" cy="1301232"/>
          </a:xfrm>
          <a:prstGeom prst="rect">
            <a:avLst/>
          </a:prstGeom>
        </p:spPr>
      </p:pic>
      <p:sp>
        <p:nvSpPr>
          <p:cNvPr id="52" name="textbox 52"/>
          <p:cNvSpPr/>
          <p:nvPr/>
        </p:nvSpPr>
        <p:spPr>
          <a:xfrm>
            <a:off x="882499" y="4078020"/>
            <a:ext cx="3767454" cy="31242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81000"/>
              </a:lnSpc>
            </a:pP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  </a:t>
            </a:r>
            <a:r>
              <a:rPr sz="9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5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50                       200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741170" algn="l" rtl="0" eaLnBrk="0">
              <a:lnSpc>
                <a:spcPts val="1270"/>
              </a:lnSpc>
              <a:spcBef>
                <a:spcPts val="115"/>
              </a:spcBef>
            </a:pPr>
            <a:r>
              <a:rPr sz="1000" kern="0" spc="-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I-A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54" name="path 54"/>
          <p:cNvSpPr/>
          <p:nvPr/>
        </p:nvSpPr>
        <p:spPr>
          <a:xfrm>
            <a:off x="3326689" y="7895413"/>
            <a:ext cx="821430" cy="701579"/>
          </a:xfrm>
          <a:custGeom>
            <a:avLst/>
            <a:gdLst/>
            <a:ahLst/>
            <a:cxnLst/>
            <a:rect l="0" t="0" r="0" b="0"/>
            <a:pathLst>
              <a:path w="1293" h="1104">
                <a:moveTo>
                  <a:pt x="1276" y="136"/>
                </a:moveTo>
                <a:lnTo>
                  <a:pt x="1276" y="205"/>
                </a:lnTo>
                <a:lnTo>
                  <a:pt x="1263" y="273"/>
                </a:lnTo>
                <a:lnTo>
                  <a:pt x="1248" y="325"/>
                </a:lnTo>
                <a:lnTo>
                  <a:pt x="1232" y="376"/>
                </a:lnTo>
                <a:lnTo>
                  <a:pt x="1210" y="426"/>
                </a:lnTo>
                <a:lnTo>
                  <a:pt x="1188" y="475"/>
                </a:lnTo>
                <a:lnTo>
                  <a:pt x="1144" y="560"/>
                </a:lnTo>
                <a:lnTo>
                  <a:pt x="1100" y="642"/>
                </a:lnTo>
                <a:lnTo>
                  <a:pt x="1052" y="710"/>
                </a:lnTo>
                <a:lnTo>
                  <a:pt x="994" y="775"/>
                </a:lnTo>
                <a:lnTo>
                  <a:pt x="928" y="835"/>
                </a:lnTo>
                <a:lnTo>
                  <a:pt x="862" y="886"/>
                </a:lnTo>
                <a:lnTo>
                  <a:pt x="796" y="929"/>
                </a:lnTo>
                <a:lnTo>
                  <a:pt x="730" y="959"/>
                </a:lnTo>
                <a:lnTo>
                  <a:pt x="646" y="993"/>
                </a:lnTo>
                <a:lnTo>
                  <a:pt x="558" y="1028"/>
                </a:lnTo>
                <a:lnTo>
                  <a:pt x="474" y="1053"/>
                </a:lnTo>
                <a:lnTo>
                  <a:pt x="391" y="1075"/>
                </a:lnTo>
                <a:lnTo>
                  <a:pt x="303" y="1088"/>
                </a:lnTo>
                <a:lnTo>
                  <a:pt x="232" y="1088"/>
                </a:lnTo>
                <a:lnTo>
                  <a:pt x="162" y="1088"/>
                </a:lnTo>
                <a:lnTo>
                  <a:pt x="96" y="1028"/>
                </a:lnTo>
                <a:lnTo>
                  <a:pt x="60" y="963"/>
                </a:lnTo>
                <a:lnTo>
                  <a:pt x="30" y="882"/>
                </a:lnTo>
                <a:lnTo>
                  <a:pt x="16" y="800"/>
                </a:lnTo>
                <a:lnTo>
                  <a:pt x="21" y="723"/>
                </a:lnTo>
                <a:lnTo>
                  <a:pt x="38" y="650"/>
                </a:lnTo>
                <a:lnTo>
                  <a:pt x="74" y="586"/>
                </a:lnTo>
                <a:lnTo>
                  <a:pt x="118" y="505"/>
                </a:lnTo>
                <a:lnTo>
                  <a:pt x="166" y="436"/>
                </a:lnTo>
                <a:lnTo>
                  <a:pt x="228" y="372"/>
                </a:lnTo>
                <a:lnTo>
                  <a:pt x="303" y="312"/>
                </a:lnTo>
                <a:lnTo>
                  <a:pt x="369" y="265"/>
                </a:lnTo>
                <a:lnTo>
                  <a:pt x="430" y="218"/>
                </a:lnTo>
                <a:lnTo>
                  <a:pt x="510" y="171"/>
                </a:lnTo>
                <a:lnTo>
                  <a:pt x="580" y="128"/>
                </a:lnTo>
                <a:lnTo>
                  <a:pt x="673" y="85"/>
                </a:lnTo>
                <a:lnTo>
                  <a:pt x="743" y="55"/>
                </a:lnTo>
                <a:lnTo>
                  <a:pt x="823" y="33"/>
                </a:lnTo>
                <a:lnTo>
                  <a:pt x="897" y="16"/>
                </a:lnTo>
                <a:lnTo>
                  <a:pt x="972" y="16"/>
                </a:lnTo>
                <a:lnTo>
                  <a:pt x="1047" y="21"/>
                </a:lnTo>
                <a:lnTo>
                  <a:pt x="1122" y="33"/>
                </a:lnTo>
                <a:lnTo>
                  <a:pt x="1175" y="42"/>
                </a:lnTo>
                <a:lnTo>
                  <a:pt x="1226" y="89"/>
                </a:lnTo>
                <a:lnTo>
                  <a:pt x="1276" y="136"/>
                </a:lnTo>
              </a:path>
            </a:pathLst>
          </a:custGeom>
          <a:noFill/>
          <a:ln w="21370" cap="sq">
            <a:solidFill>
              <a:srgbClr val="000000"/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56" name="textbox 56"/>
          <p:cNvSpPr/>
          <p:nvPr/>
        </p:nvSpPr>
        <p:spPr>
          <a:xfrm>
            <a:off x="5519459" y="8760429"/>
            <a:ext cx="1303019" cy="32639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6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537210" indent="-525145" algn="l" rtl="0" eaLnBrk="0">
              <a:lnSpc>
                <a:spcPct val="116000"/>
              </a:lnSpc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    2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60   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80</a:t>
            </a:r>
            <a:r>
              <a:rPr sz="700" kern="0" spc="10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  120  </a:t>
            </a:r>
            <a:r>
              <a:rPr sz="1000" kern="0" spc="-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I-A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58" name="textbox 58"/>
          <p:cNvSpPr/>
          <p:nvPr/>
        </p:nvSpPr>
        <p:spPr>
          <a:xfrm>
            <a:off x="846353" y="8760429"/>
            <a:ext cx="1303019" cy="28702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2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0000"/>
              </a:lnSpc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    2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60</a:t>
            </a:r>
            <a:r>
              <a:rPr sz="700" kern="0" spc="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   100  1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l" rtl="0" eaLnBrk="0">
              <a:lnSpc>
                <a:spcPct val="148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47371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SC-A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60" name="textbox 60"/>
          <p:cNvSpPr/>
          <p:nvPr/>
        </p:nvSpPr>
        <p:spPr>
          <a:xfrm>
            <a:off x="3182906" y="8760429"/>
            <a:ext cx="1303019" cy="28702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2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0000"/>
              </a:lnSpc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    2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60</a:t>
            </a:r>
            <a:r>
              <a:rPr sz="700" kern="0" spc="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   100  1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l" rtl="0" eaLnBrk="0">
              <a:lnSpc>
                <a:spcPct val="148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47371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SC-A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62" name="textbox 62"/>
          <p:cNvSpPr/>
          <p:nvPr/>
        </p:nvSpPr>
        <p:spPr>
          <a:xfrm rot="16200000">
            <a:off x="-777778" y="2388729"/>
            <a:ext cx="2940685" cy="16256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26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81000"/>
              </a:lnSpc>
              <a:spcBef>
                <a:spcPts val="0"/>
              </a:spcBef>
            </a:pPr>
            <a:r>
              <a:rPr sz="9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                 1000              2000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3000              4000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64" name="textbox 64"/>
          <p:cNvSpPr/>
          <p:nvPr/>
        </p:nvSpPr>
        <p:spPr>
          <a:xfrm>
            <a:off x="468099" y="9566299"/>
            <a:ext cx="949325" cy="16128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ts val="1065"/>
              </a:lnSpc>
            </a:pPr>
            <a:r>
              <a:rPr sz="800" kern="0" spc="-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Fit</a:t>
            </a:r>
            <a:r>
              <a:rPr sz="8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800" kern="0" spc="-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LTV4.1.</a:t>
            </a:r>
            <a:r>
              <a:rPr sz="8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7(Win)</a:t>
            </a:r>
            <a:endParaRPr sz="8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66" name="textbox 66"/>
          <p:cNvSpPr/>
          <p:nvPr/>
        </p:nvSpPr>
        <p:spPr>
          <a:xfrm>
            <a:off x="3805569" y="454610"/>
            <a:ext cx="495300" cy="28638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4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33350" algn="l" rtl="0" eaLnBrk="0">
              <a:lnSpc>
                <a:spcPct val="122000"/>
              </a:lnSpc>
              <a:tabLst>
                <a:tab pos="198120" algn="l"/>
              </a:tabLst>
            </a:pP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	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G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	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G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pic>
        <p:nvPicPr>
          <p:cNvPr id="68" name="picture 6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rot="21600000">
            <a:off x="3818269" y="598385"/>
            <a:ext cx="121101" cy="99731"/>
          </a:xfrm>
          <a:prstGeom prst="rect">
            <a:avLst/>
          </a:prstGeom>
        </p:spPr>
      </p:pic>
      <p:pic>
        <p:nvPicPr>
          <p:cNvPr id="70" name="picture 70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rot="21600000">
            <a:off x="3818269" y="477284"/>
            <a:ext cx="121101" cy="99730"/>
          </a:xfrm>
          <a:prstGeom prst="rect">
            <a:avLst/>
          </a:prstGeom>
        </p:spPr>
      </p:pic>
      <p:sp>
        <p:nvSpPr>
          <p:cNvPr id="72" name="textbox 72"/>
          <p:cNvSpPr/>
          <p:nvPr/>
        </p:nvSpPr>
        <p:spPr>
          <a:xfrm rot="16200000">
            <a:off x="2389390" y="7948715"/>
            <a:ext cx="1245869" cy="14160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07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0000"/>
              </a:lnSpc>
              <a:spcBef>
                <a:spcPts val="0"/>
              </a:spcBef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   40   6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</a:t>
            </a:r>
            <a:r>
              <a:rPr sz="700" kern="0" spc="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700" kern="0" spc="1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20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74" name="textbox 74"/>
          <p:cNvSpPr/>
          <p:nvPr/>
        </p:nvSpPr>
        <p:spPr>
          <a:xfrm rot="16200000">
            <a:off x="52837" y="7948715"/>
            <a:ext cx="1245869" cy="14160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07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0000"/>
              </a:lnSpc>
              <a:spcBef>
                <a:spcPts val="0"/>
              </a:spcBef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   40   6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</a:t>
            </a:r>
            <a:r>
              <a:rPr sz="700" kern="0" spc="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700" kern="0" spc="1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20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76" name="textbox 76"/>
          <p:cNvSpPr/>
          <p:nvPr/>
        </p:nvSpPr>
        <p:spPr>
          <a:xfrm rot="16200000">
            <a:off x="4725942" y="7948715"/>
            <a:ext cx="1245869" cy="14160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07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0000"/>
              </a:lnSpc>
              <a:spcBef>
                <a:spcPts val="0"/>
              </a:spcBef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   40   6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</a:t>
            </a:r>
            <a:r>
              <a:rPr sz="700" kern="0" spc="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700" kern="0" spc="1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20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78" name="path 78"/>
          <p:cNvSpPr/>
          <p:nvPr/>
        </p:nvSpPr>
        <p:spPr>
          <a:xfrm>
            <a:off x="4235002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80" name="path 80"/>
          <p:cNvSpPr/>
          <p:nvPr/>
        </p:nvSpPr>
        <p:spPr>
          <a:xfrm>
            <a:off x="4042664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51" y="5"/>
                </a:moveTo>
                <a:lnTo>
                  <a:pt x="151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82" name="path 82"/>
          <p:cNvSpPr/>
          <p:nvPr/>
        </p:nvSpPr>
        <p:spPr>
          <a:xfrm>
            <a:off x="3451402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84" name="path 84"/>
          <p:cNvSpPr/>
          <p:nvPr/>
        </p:nvSpPr>
        <p:spPr>
          <a:xfrm>
            <a:off x="3259063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86" name="path 86"/>
          <p:cNvSpPr/>
          <p:nvPr/>
        </p:nvSpPr>
        <p:spPr>
          <a:xfrm>
            <a:off x="3650863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88" name="path 88"/>
          <p:cNvSpPr/>
          <p:nvPr/>
        </p:nvSpPr>
        <p:spPr>
          <a:xfrm>
            <a:off x="3843202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0" name="path 90"/>
          <p:cNvSpPr/>
          <p:nvPr/>
        </p:nvSpPr>
        <p:spPr>
          <a:xfrm>
            <a:off x="3209198" y="8608915"/>
            <a:ext cx="1239512" cy="64112"/>
          </a:xfrm>
          <a:custGeom>
            <a:avLst/>
            <a:gdLst/>
            <a:ahLst/>
            <a:cxnLst/>
            <a:rect l="0" t="0" r="0" b="0"/>
            <a:pathLst>
              <a:path w="1951" h="100">
                <a:moveTo>
                  <a:pt x="1935" y="5"/>
                </a:moveTo>
                <a:lnTo>
                  <a:pt x="1935" y="95"/>
                </a:lnTo>
                <a:moveTo>
                  <a:pt x="5" y="5"/>
                </a:moveTo>
                <a:lnTo>
                  <a:pt x="1946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2" name="path 92"/>
          <p:cNvSpPr/>
          <p:nvPr/>
        </p:nvSpPr>
        <p:spPr>
          <a:xfrm>
            <a:off x="3095220" y="8423700"/>
            <a:ext cx="121101" cy="142472"/>
          </a:xfrm>
          <a:custGeom>
            <a:avLst/>
            <a:gdLst/>
            <a:ahLst/>
            <a:cxnLst/>
            <a:rect l="0" t="0" r="0" b="0"/>
            <a:pathLst>
              <a:path w="190" h="224">
                <a:moveTo>
                  <a:pt x="185" y="218"/>
                </a:moveTo>
                <a:lnTo>
                  <a:pt x="95" y="218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72"/>
                </a:moveTo>
                <a:lnTo>
                  <a:pt x="95" y="72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4" name="path 94"/>
          <p:cNvSpPr/>
          <p:nvPr/>
        </p:nvSpPr>
        <p:spPr>
          <a:xfrm>
            <a:off x="3095220" y="8608915"/>
            <a:ext cx="121101" cy="7123"/>
          </a:xfrm>
          <a:custGeom>
            <a:avLst/>
            <a:gdLst/>
            <a:ahLst/>
            <a:cxnLst/>
            <a:rect l="0" t="0" r="0" b="0"/>
            <a:pathLst>
              <a:path w="190" h="11"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6" name="path 96"/>
          <p:cNvSpPr/>
          <p:nvPr/>
        </p:nvSpPr>
        <p:spPr>
          <a:xfrm>
            <a:off x="3095220" y="7490504"/>
            <a:ext cx="121101" cy="149596"/>
          </a:xfrm>
          <a:custGeom>
            <a:avLst/>
            <a:gdLst/>
            <a:ahLst/>
            <a:cxnLst/>
            <a:rect l="0" t="0" r="0" b="0"/>
            <a:pathLst>
              <a:path w="190" h="235">
                <a:moveTo>
                  <a:pt x="185" y="229"/>
                </a:moveTo>
                <a:lnTo>
                  <a:pt x="95" y="229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84"/>
                </a:moveTo>
                <a:lnTo>
                  <a:pt x="95" y="84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8" name="path 98"/>
          <p:cNvSpPr/>
          <p:nvPr/>
        </p:nvSpPr>
        <p:spPr>
          <a:xfrm>
            <a:off x="3095220" y="8053271"/>
            <a:ext cx="121101" cy="142472"/>
          </a:xfrm>
          <a:custGeom>
            <a:avLst/>
            <a:gdLst/>
            <a:ahLst/>
            <a:cxnLst/>
            <a:rect l="0" t="0" r="0" b="0"/>
            <a:pathLst>
              <a:path w="190" h="224">
                <a:moveTo>
                  <a:pt x="185" y="218"/>
                </a:moveTo>
                <a:lnTo>
                  <a:pt x="95" y="218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72"/>
                </a:moveTo>
                <a:lnTo>
                  <a:pt x="95" y="72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00" name="path 100"/>
          <p:cNvSpPr/>
          <p:nvPr/>
        </p:nvSpPr>
        <p:spPr>
          <a:xfrm>
            <a:off x="3095220" y="8238486"/>
            <a:ext cx="121101" cy="142472"/>
          </a:xfrm>
          <a:custGeom>
            <a:avLst/>
            <a:gdLst/>
            <a:ahLst/>
            <a:cxnLst/>
            <a:rect l="0" t="0" r="0" b="0"/>
            <a:pathLst>
              <a:path w="190" h="224">
                <a:moveTo>
                  <a:pt x="185" y="218"/>
                </a:moveTo>
                <a:lnTo>
                  <a:pt x="95" y="218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72"/>
                </a:moveTo>
                <a:lnTo>
                  <a:pt x="95" y="72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02" name="path 102"/>
          <p:cNvSpPr/>
          <p:nvPr/>
        </p:nvSpPr>
        <p:spPr>
          <a:xfrm>
            <a:off x="3095220" y="7675719"/>
            <a:ext cx="121101" cy="149596"/>
          </a:xfrm>
          <a:custGeom>
            <a:avLst/>
            <a:gdLst/>
            <a:ahLst/>
            <a:cxnLst/>
            <a:rect l="0" t="0" r="0" b="0"/>
            <a:pathLst>
              <a:path w="190" h="235">
                <a:moveTo>
                  <a:pt x="185" y="229"/>
                </a:moveTo>
                <a:lnTo>
                  <a:pt x="95" y="229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84"/>
                </a:moveTo>
                <a:lnTo>
                  <a:pt x="95" y="84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04" name="path 104"/>
          <p:cNvSpPr/>
          <p:nvPr/>
        </p:nvSpPr>
        <p:spPr>
          <a:xfrm>
            <a:off x="3095220" y="7860933"/>
            <a:ext cx="121101" cy="149596"/>
          </a:xfrm>
          <a:custGeom>
            <a:avLst/>
            <a:gdLst/>
            <a:ahLst/>
            <a:cxnLst/>
            <a:rect l="0" t="0" r="0" b="0"/>
            <a:pathLst>
              <a:path w="190" h="235">
                <a:moveTo>
                  <a:pt x="185" y="229"/>
                </a:moveTo>
                <a:lnTo>
                  <a:pt x="95" y="229"/>
                </a:lnTo>
                <a:moveTo>
                  <a:pt x="185" y="162"/>
                </a:moveTo>
                <a:lnTo>
                  <a:pt x="95" y="162"/>
                </a:lnTo>
                <a:moveTo>
                  <a:pt x="185" y="84"/>
                </a:moveTo>
                <a:lnTo>
                  <a:pt x="95" y="84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06" name="path 106"/>
          <p:cNvSpPr/>
          <p:nvPr/>
        </p:nvSpPr>
        <p:spPr>
          <a:xfrm>
            <a:off x="3152209" y="7426391"/>
            <a:ext cx="64112" cy="1189647"/>
          </a:xfrm>
          <a:custGeom>
            <a:avLst/>
            <a:gdLst/>
            <a:ahLst/>
            <a:cxnLst/>
            <a:rect l="0" t="0" r="0" b="0"/>
            <a:pathLst>
              <a:path w="100" h="1873">
                <a:moveTo>
                  <a:pt x="95" y="39"/>
                </a:moveTo>
                <a:lnTo>
                  <a:pt x="5" y="39"/>
                </a:lnTo>
                <a:moveTo>
                  <a:pt x="95" y="1867"/>
                </a:moveTo>
                <a:lnTo>
                  <a:pt x="9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08" name="textbox 108"/>
          <p:cNvSpPr/>
          <p:nvPr/>
        </p:nvSpPr>
        <p:spPr>
          <a:xfrm rot="16200000">
            <a:off x="310755" y="2249794"/>
            <a:ext cx="421640" cy="18668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ts val="1270"/>
              </a:lnSpc>
            </a:pPr>
            <a:r>
              <a:rPr sz="900" kern="0" spc="-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Number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110" name="textbox 110"/>
          <p:cNvSpPr/>
          <p:nvPr/>
        </p:nvSpPr>
        <p:spPr>
          <a:xfrm rot="16200000">
            <a:off x="5064821" y="7915550"/>
            <a:ext cx="259715" cy="18668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ts val="1270"/>
              </a:lnSpc>
            </a:pP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</a:t>
            </a:r>
            <a:r>
              <a:rPr sz="900" kern="0" spc="-1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I-H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112" name="textbox 112"/>
          <p:cNvSpPr/>
          <p:nvPr/>
        </p:nvSpPr>
        <p:spPr>
          <a:xfrm rot="16200000">
            <a:off x="315261" y="7933009"/>
            <a:ext cx="407034" cy="174625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34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SC-W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114" name="textbox 114"/>
          <p:cNvSpPr/>
          <p:nvPr/>
        </p:nvSpPr>
        <p:spPr>
          <a:xfrm rot="16200000">
            <a:off x="2662193" y="7926484"/>
            <a:ext cx="386079" cy="174625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34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5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SSC-A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116" name="rect 116"/>
          <p:cNvSpPr/>
          <p:nvPr/>
        </p:nvSpPr>
        <p:spPr>
          <a:xfrm>
            <a:off x="3382804" y="7534850"/>
            <a:ext cx="142472" cy="135349"/>
          </a:xfrm>
          <a:prstGeom prst="rect">
            <a:avLst/>
          </a:prstGeom>
          <a:solidFill>
            <a:srgbClr val="FFFFFF">
              <a:alpha val="49803"/>
            </a:srgbClr>
          </a:solidFill>
          <a:ln w="0" cap="flat">
            <a:noFill/>
            <a:prstDash val="solid"/>
            <a:miter lim="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18" name="rect 118"/>
          <p:cNvSpPr/>
          <p:nvPr/>
        </p:nvSpPr>
        <p:spPr>
          <a:xfrm>
            <a:off x="1050796" y="7538984"/>
            <a:ext cx="142472" cy="135349"/>
          </a:xfrm>
          <a:prstGeom prst="rect">
            <a:avLst/>
          </a:prstGeom>
          <a:solidFill>
            <a:srgbClr val="FFFFFF">
              <a:alpha val="49803"/>
            </a:srgbClr>
          </a:solidFill>
          <a:ln w="0" cap="flat">
            <a:noFill/>
            <a:prstDash val="solid"/>
            <a:miter lim="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20" name="rect 120"/>
          <p:cNvSpPr/>
          <p:nvPr/>
        </p:nvSpPr>
        <p:spPr>
          <a:xfrm>
            <a:off x="5716958" y="7534850"/>
            <a:ext cx="142472" cy="135349"/>
          </a:xfrm>
          <a:prstGeom prst="rect">
            <a:avLst/>
          </a:prstGeom>
          <a:solidFill>
            <a:srgbClr val="FFFFFF">
              <a:alpha val="49803"/>
            </a:srgbClr>
          </a:solidFill>
          <a:ln w="0" cap="flat">
            <a:noFill/>
            <a:prstDash val="solid"/>
            <a:miter lim="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22" name="textbox 122"/>
          <p:cNvSpPr/>
          <p:nvPr/>
        </p:nvSpPr>
        <p:spPr>
          <a:xfrm>
            <a:off x="5713715" y="7540575"/>
            <a:ext cx="161289" cy="144145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2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r" rtl="0" eaLnBrk="0">
              <a:lnSpc>
                <a:spcPct val="78000"/>
              </a:lnSpc>
            </a:pPr>
            <a:r>
              <a:rPr sz="1000" kern="0" spc="-9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</a:t>
            </a:r>
            <a:r>
              <a:rPr sz="1000" kern="0" spc="-5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3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124" name="textbox 124"/>
          <p:cNvSpPr/>
          <p:nvPr/>
        </p:nvSpPr>
        <p:spPr>
          <a:xfrm>
            <a:off x="3379499" y="7540575"/>
            <a:ext cx="161289" cy="14477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r" rtl="0" eaLnBrk="0">
              <a:lnSpc>
                <a:spcPct val="78000"/>
              </a:lnSpc>
            </a:pPr>
            <a:r>
              <a:rPr sz="1000" kern="0" spc="-8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</a:t>
            </a: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126" name="textbox 126"/>
          <p:cNvSpPr/>
          <p:nvPr/>
        </p:nvSpPr>
        <p:spPr>
          <a:xfrm>
            <a:off x="1047510" y="7544693"/>
            <a:ext cx="161289" cy="14477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r" rtl="0" eaLnBrk="0">
              <a:lnSpc>
                <a:spcPct val="78000"/>
              </a:lnSpc>
            </a:pPr>
            <a:r>
              <a:rPr sz="1000" kern="0" spc="-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1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NjQ5NjlkZjQ4NmY2YmRlZWY0ZDc5MDc2N2QzMGZhMDQifQ=="/>
</p:tagLst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"/>
        <a:ea typeface=""/>
        <a:cs typeface=""/>
      </a:majorFont>
      <a:minorFont>
        <a:latin typeface="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satMod val="110000"/>
                <a:lum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satMod val="105000"/>
                <a:lum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shade val="94000"/>
              </a:schemeClr>
            </a:gs>
            <a:gs pos="50000">
              <a:schemeClr val="phClr">
                <a:lumMod val="110000"/>
                <a:satMod val="100000"/>
                <a:tint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65</Words>
  <Application>WPS 演示</Application>
  <PresentationFormat/>
  <Paragraphs>180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1" baseType="lpstr">
      <vt:lpstr>Arial</vt:lpstr>
      <vt:lpstr>宋体</vt:lpstr>
      <vt:lpstr>Wingdings</vt:lpstr>
      <vt:lpstr>Arial</vt:lpstr>
      <vt:lpstr>微软雅黑</vt:lpstr>
      <vt:lpstr>Arial Unicode MS</vt:lpstr>
      <vt:lpstr>Calibri</vt:lpstr>
      <vt:lpstr>Office theme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格林</cp:lastModifiedBy>
  <cp:revision>2</cp:revision>
  <dcterms:created xsi:type="dcterms:W3CDTF">2024-09-07T16:17:00Z</dcterms:created>
  <dcterms:modified xsi:type="dcterms:W3CDTF">2024-09-07T16:26:2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O">
    <vt:lpwstr>wqlLaW5nc29mdCBQREYgdG8gV1BTIDkw</vt:lpwstr>
  </property>
  <property fmtid="{D5CDD505-2E9C-101B-9397-08002B2CF9AE}" pid="3" name="Created">
    <vt:filetime>2024-03-06T06:35:57Z</vt:filetime>
  </property>
  <property fmtid="{D5CDD505-2E9C-101B-9397-08002B2CF9AE}" pid="4" name="ICV">
    <vt:lpwstr>281BBCE07CEB49DAB82C6DF6C739A17A_12</vt:lpwstr>
  </property>
  <property fmtid="{D5CDD505-2E9C-101B-9397-08002B2CF9AE}" pid="5" name="KSOProductBuildVer">
    <vt:lpwstr>2052-12.1.0.16910</vt:lpwstr>
  </property>
</Properties>
</file>